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1" r:id="rId4"/>
    <p:sldId id="262" r:id="rId5"/>
    <p:sldId id="263" r:id="rId6"/>
    <p:sldId id="318" r:id="rId7"/>
    <p:sldId id="321" r:id="rId8"/>
    <p:sldId id="322" r:id="rId9"/>
    <p:sldId id="323" r:id="rId10"/>
    <p:sldId id="324" r:id="rId11"/>
    <p:sldId id="290" r:id="rId12"/>
    <p:sldId id="293" r:id="rId13"/>
    <p:sldId id="294" r:id="rId14"/>
    <p:sldId id="295" r:id="rId15"/>
    <p:sldId id="296" r:id="rId16"/>
    <p:sldId id="311" r:id="rId17"/>
    <p:sldId id="314" r:id="rId18"/>
    <p:sldId id="315" r:id="rId19"/>
    <p:sldId id="316" r:id="rId20"/>
    <p:sldId id="317" r:id="rId2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2" id="{CAC82B0E-0747-4B62-AA71-6F411BDD1A67}">
          <p14:sldIdLst>
            <p14:sldId id="257"/>
            <p14:sldId id="260"/>
            <p14:sldId id="261"/>
            <p14:sldId id="262"/>
            <p14:sldId id="263"/>
          </p14:sldIdLst>
        </p14:section>
        <p14:section name="S4" id="{F5A3420E-5AB3-43AF-BEF5-F0784391EA4E}">
          <p14:sldIdLst>
            <p14:sldId id="318"/>
            <p14:sldId id="321"/>
            <p14:sldId id="322"/>
            <p14:sldId id="323"/>
            <p14:sldId id="324"/>
          </p14:sldIdLst>
        </p14:section>
        <p14:section name="S6" id="{B365B7AD-E57C-4D23-8595-811D1C7404DA}">
          <p14:sldIdLst>
            <p14:sldId id="290"/>
            <p14:sldId id="293"/>
            <p14:sldId id="294"/>
            <p14:sldId id="295"/>
            <p14:sldId id="296"/>
          </p14:sldIdLst>
        </p14:section>
        <p14:section name="S8" id="{1F04E5E8-E80A-455E-9B90-801E1DA91C70}">
          <p14:sldIdLst>
            <p14:sldId id="311"/>
            <p14:sldId id="314"/>
            <p14:sldId id="315"/>
            <p14:sldId id="316"/>
            <p14:sldId id="317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3337E6F-9E70-4B65-B42F-8091C9D37240}" v="122" dt="2023-10-23T01:47:00.4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30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7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6/11/relationships/changesInfo" Target="changesInfos/changesInfo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lipe Freitas" userId="754b0854625114a1" providerId="LiveId" clId="{D3337E6F-9E70-4B65-B42F-8091C9D37240}"/>
    <pc:docChg chg="undo redo custSel addSld delSld modSld modMainMaster addSection delSection modSection">
      <pc:chgData name="Felipe Freitas" userId="754b0854625114a1" providerId="LiveId" clId="{D3337E6F-9E70-4B65-B42F-8091C9D37240}" dt="2023-10-23T01:49:24.595" v="631" actId="1076"/>
      <pc:docMkLst>
        <pc:docMk/>
      </pc:docMkLst>
      <pc:sldChg chg="new del">
        <pc:chgData name="Felipe Freitas" userId="754b0854625114a1" providerId="LiveId" clId="{D3337E6F-9E70-4B65-B42F-8091C9D37240}" dt="2023-10-23T00:54:50.672" v="42" actId="47"/>
        <pc:sldMkLst>
          <pc:docMk/>
          <pc:sldMk cId="460939101" sldId="256"/>
        </pc:sldMkLst>
      </pc:sldChg>
      <pc:sldChg chg="addSp delSp modSp new mod setBg modClrScheme delDesignElem chgLayout">
        <pc:chgData name="Felipe Freitas" userId="754b0854625114a1" providerId="LiveId" clId="{D3337E6F-9E70-4B65-B42F-8091C9D37240}" dt="2023-10-23T01:46:27.692" v="580" actId="1076"/>
        <pc:sldMkLst>
          <pc:docMk/>
          <pc:sldMk cId="3266425601" sldId="257"/>
        </pc:sldMkLst>
        <pc:spChg chg="mod ord">
          <ac:chgData name="Felipe Freitas" userId="754b0854625114a1" providerId="LiveId" clId="{D3337E6F-9E70-4B65-B42F-8091C9D37240}" dt="2023-10-23T01:44:23.326" v="543" actId="700"/>
          <ac:spMkLst>
            <pc:docMk/>
            <pc:sldMk cId="3266425601" sldId="257"/>
            <ac:spMk id="2" creationId="{65C11385-BCBC-4B11-63AB-7393A2B5B858}"/>
          </ac:spMkLst>
        </pc:spChg>
        <pc:spChg chg="del">
          <ac:chgData name="Felipe Freitas" userId="754b0854625114a1" providerId="LiveId" clId="{D3337E6F-9E70-4B65-B42F-8091C9D37240}" dt="2023-10-23T00:55:04.888" v="43"/>
          <ac:spMkLst>
            <pc:docMk/>
            <pc:sldMk cId="3266425601" sldId="257"/>
            <ac:spMk id="3" creationId="{02166195-BDF8-497E-B56E-B124857C83CD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266425601" sldId="257"/>
            <ac:spMk id="8" creationId="{B8A162AD-B214-C903-8E90-226B0946DECB}"/>
          </ac:spMkLst>
        </pc:spChg>
        <pc:spChg chg="add del mod">
          <ac:chgData name="Felipe Freitas" userId="754b0854625114a1" providerId="LiveId" clId="{D3337E6F-9E70-4B65-B42F-8091C9D37240}" dt="2023-10-23T01:43:58.408" v="539" actId="767"/>
          <ac:spMkLst>
            <pc:docMk/>
            <pc:sldMk cId="3266425601" sldId="257"/>
            <ac:spMk id="9" creationId="{CFEC4C1B-14F2-D1AB-712B-DB09E3671592}"/>
          </ac:spMkLst>
        </pc:spChg>
        <pc:spChg chg="add mod">
          <ac:chgData name="Felipe Freitas" userId="754b0854625114a1" providerId="LiveId" clId="{D3337E6F-9E70-4B65-B42F-8091C9D37240}" dt="2023-10-23T01:46:27.692" v="580" actId="1076"/>
          <ac:spMkLst>
            <pc:docMk/>
            <pc:sldMk cId="3266425601" sldId="257"/>
            <ac:spMk id="10" creationId="{25B71B73-BBF3-137E-9EB6-2A786B44DB66}"/>
          </ac:spMkLst>
        </pc:spChg>
        <pc:spChg chg="add mod">
          <ac:chgData name="Felipe Freitas" userId="754b0854625114a1" providerId="LiveId" clId="{D3337E6F-9E70-4B65-B42F-8091C9D37240}" dt="2023-10-23T01:46:23.156" v="579" actId="1076"/>
          <ac:spMkLst>
            <pc:docMk/>
            <pc:sldMk cId="3266425601" sldId="257"/>
            <ac:spMk id="11" creationId="{624324FC-3452-0A4D-5770-73A56725084D}"/>
          </ac:spMkLst>
        </pc:spChg>
        <pc:spChg chg="add del">
          <ac:chgData name="Felipe Freitas" userId="754b0854625114a1" providerId="LiveId" clId="{D3337E6F-9E70-4B65-B42F-8091C9D37240}" dt="2023-10-23T01:44:23.326" v="543" actId="700"/>
          <ac:spMkLst>
            <pc:docMk/>
            <pc:sldMk cId="3266425601" sldId="257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44:23.326" v="543" actId="700"/>
          <ac:picMkLst>
            <pc:docMk/>
            <pc:sldMk cId="3266425601" sldId="257"/>
            <ac:picMk id="5" creationId="{3B0B0CDA-D7A6-DDE1-702D-8BADCA33FD40}"/>
          </ac:picMkLst>
        </pc:picChg>
        <pc:picChg chg="add mod">
          <ac:chgData name="Felipe Freitas" userId="754b0854625114a1" providerId="LiveId" clId="{D3337E6F-9E70-4B65-B42F-8091C9D37240}" dt="2023-10-23T01:45:58.924" v="569" actId="1076"/>
          <ac:picMkLst>
            <pc:docMk/>
            <pc:sldMk cId="3266425601" sldId="257"/>
            <ac:picMk id="7" creationId="{958CC049-441E-17B5-59CB-BD8F00EE2EE9}"/>
          </ac:picMkLst>
        </pc:picChg>
      </pc:sldChg>
      <pc:sldChg chg="addSp delSp modSp new add del mod setBg modClrScheme delDesignElem chgLayout">
        <pc:chgData name="Felipe Freitas" userId="754b0854625114a1" providerId="LiveId" clId="{D3337E6F-9E70-4B65-B42F-8091C9D37240}" dt="2023-10-23T01:32:26.193" v="398" actId="47"/>
        <pc:sldMkLst>
          <pc:docMk/>
          <pc:sldMk cId="691614670" sldId="258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691614670" sldId="258"/>
            <ac:spMk id="2" creationId="{25507AD8-5769-1871-C2E3-8F2F5709A2E1}"/>
          </ac:spMkLst>
        </pc:spChg>
        <pc:spChg chg="del">
          <ac:chgData name="Felipe Freitas" userId="754b0854625114a1" providerId="LiveId" clId="{D3337E6F-9E70-4B65-B42F-8091C9D37240}" dt="2023-10-23T00:55:16.899" v="45"/>
          <ac:spMkLst>
            <pc:docMk/>
            <pc:sldMk cId="691614670" sldId="258"/>
            <ac:spMk id="3" creationId="{2AF1289C-2CDF-9B8D-4C4C-CF9E5B3CB62A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691614670" sldId="258"/>
            <ac:spMk id="8" creationId="{D9D26072-B827-BD1E-4D71-442F7272639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691614670" sldId="258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691614670" sldId="258"/>
            <ac:picMk id="5" creationId="{EE6E3DCB-8FF8-CD3B-DBB4-D36AA5B5EF67}"/>
          </ac:picMkLst>
        </pc:picChg>
        <pc:picChg chg="add mod">
          <ac:chgData name="Felipe Freitas" userId="754b0854625114a1" providerId="LiveId" clId="{D3337E6F-9E70-4B65-B42F-8091C9D37240}" dt="2023-10-23T00:55:21.867" v="46" actId="26606"/>
          <ac:picMkLst>
            <pc:docMk/>
            <pc:sldMk cId="691614670" sldId="258"/>
            <ac:picMk id="7" creationId="{350F8969-680E-4005-8EE8-2200C7E0F523}"/>
          </ac:picMkLst>
        </pc:picChg>
      </pc:sldChg>
      <pc:sldChg chg="addSp delSp modSp new add del mod setBg modClrScheme delDesignElem chgLayout">
        <pc:chgData name="Felipe Freitas" userId="754b0854625114a1" providerId="LiveId" clId="{D3337E6F-9E70-4B65-B42F-8091C9D37240}" dt="2023-10-23T01:32:29.558" v="399" actId="47"/>
        <pc:sldMkLst>
          <pc:docMk/>
          <pc:sldMk cId="4123411070" sldId="259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4123411070" sldId="259"/>
            <ac:spMk id="2" creationId="{AB174FCF-100E-A371-E790-152B385F4A03}"/>
          </ac:spMkLst>
        </pc:spChg>
        <pc:spChg chg="del">
          <ac:chgData name="Felipe Freitas" userId="754b0854625114a1" providerId="LiveId" clId="{D3337E6F-9E70-4B65-B42F-8091C9D37240}" dt="2023-10-23T00:55:36.044" v="47"/>
          <ac:spMkLst>
            <pc:docMk/>
            <pc:sldMk cId="4123411070" sldId="259"/>
            <ac:spMk id="3" creationId="{342C765B-1242-0A51-72FD-CF803F7A6266}"/>
          </ac:spMkLst>
        </pc:spChg>
        <pc:spChg chg="add del">
          <ac:chgData name="Felipe Freitas" userId="754b0854625114a1" providerId="LiveId" clId="{D3337E6F-9E70-4B65-B42F-8091C9D37240}" dt="2023-10-23T01:24:49.032" v="330" actId="22"/>
          <ac:spMkLst>
            <pc:docMk/>
            <pc:sldMk cId="4123411070" sldId="259"/>
            <ac:spMk id="9" creationId="{2A11B244-5EF0-58E1-5DBF-3898DC9AF030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123411070" sldId="259"/>
            <ac:spMk id="10" creationId="{1A5BF6FD-6011-F193-3F98-F6A4CB2EA56C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123411070" sldId="259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123411070" sldId="259"/>
            <ac:picMk id="5" creationId="{D1F8C030-5ABE-B0D3-6232-41E97BB9018B}"/>
          </ac:picMkLst>
        </pc:picChg>
        <pc:picChg chg="add mod">
          <ac:chgData name="Felipe Freitas" userId="754b0854625114a1" providerId="LiveId" clId="{D3337E6F-9E70-4B65-B42F-8091C9D37240}" dt="2023-10-23T00:55:38.034" v="48" actId="26606"/>
          <ac:picMkLst>
            <pc:docMk/>
            <pc:sldMk cId="4123411070" sldId="259"/>
            <ac:picMk id="7" creationId="{D7FFA4B5-A4CE-F744-D924-4E21C8CDDCB8}"/>
          </ac:picMkLst>
        </pc:picChg>
      </pc:sldChg>
      <pc:sldChg chg="addSp delSp modSp new add del mod setBg modClrScheme delDesignElem chgLayout">
        <pc:chgData name="Felipe Freitas" userId="754b0854625114a1" providerId="LiveId" clId="{D3337E6F-9E70-4B65-B42F-8091C9D37240}" dt="2023-10-23T01:46:32.979" v="581"/>
        <pc:sldMkLst>
          <pc:docMk/>
          <pc:sldMk cId="1682473932" sldId="260"/>
        </pc:sldMkLst>
        <pc:spChg chg="mod ord">
          <ac:chgData name="Felipe Freitas" userId="754b0854625114a1" providerId="LiveId" clId="{D3337E6F-9E70-4B65-B42F-8091C9D37240}" dt="2023-10-23T01:43:33.917" v="531" actId="20577"/>
          <ac:spMkLst>
            <pc:docMk/>
            <pc:sldMk cId="1682473932" sldId="260"/>
            <ac:spMk id="2" creationId="{EACB5293-0FDD-271A-3B75-C1B547BCB875}"/>
          </ac:spMkLst>
        </pc:spChg>
        <pc:spChg chg="del">
          <ac:chgData name="Felipe Freitas" userId="754b0854625114a1" providerId="LiveId" clId="{D3337E6F-9E70-4B65-B42F-8091C9D37240}" dt="2023-10-23T00:55:46.587" v="49"/>
          <ac:spMkLst>
            <pc:docMk/>
            <pc:sldMk cId="1682473932" sldId="260"/>
            <ac:spMk id="3" creationId="{81D2A702-B5E6-85DB-A863-CFE4F62AF96F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682473932" sldId="260"/>
            <ac:spMk id="8" creationId="{1A18C4D5-5061-C4DE-28A8-D544AC64367D}"/>
          </ac:spMkLst>
        </pc:spChg>
        <pc:spChg chg="add mod">
          <ac:chgData name="Felipe Freitas" userId="754b0854625114a1" providerId="LiveId" clId="{D3337E6F-9E70-4B65-B42F-8091C9D37240}" dt="2023-10-23T01:46:32.979" v="581"/>
          <ac:spMkLst>
            <pc:docMk/>
            <pc:sldMk cId="1682473932" sldId="260"/>
            <ac:spMk id="9" creationId="{1099B8F9-CD77-36C6-8DB0-756FDAB307AA}"/>
          </ac:spMkLst>
        </pc:spChg>
        <pc:spChg chg="add mod">
          <ac:chgData name="Felipe Freitas" userId="754b0854625114a1" providerId="LiveId" clId="{D3337E6F-9E70-4B65-B42F-8091C9D37240}" dt="2023-10-23T01:46:32.979" v="581"/>
          <ac:spMkLst>
            <pc:docMk/>
            <pc:sldMk cId="1682473932" sldId="260"/>
            <ac:spMk id="10" creationId="{DCED5301-E72F-F8E8-4211-D2F7805E98A0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682473932" sldId="260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1682473932" sldId="260"/>
            <ac:picMk id="5" creationId="{A1BC0CCA-0635-DBDB-251D-8540FC9D60AF}"/>
          </ac:picMkLst>
        </pc:picChg>
        <pc:picChg chg="add mod">
          <ac:chgData name="Felipe Freitas" userId="754b0854625114a1" providerId="LiveId" clId="{D3337E6F-9E70-4B65-B42F-8091C9D37240}" dt="2023-10-23T00:55:48.147" v="50" actId="26606"/>
          <ac:picMkLst>
            <pc:docMk/>
            <pc:sldMk cId="1682473932" sldId="260"/>
            <ac:picMk id="7" creationId="{083F5890-FD73-204C-3619-02585B64DD7E}"/>
          </ac:picMkLst>
        </pc:picChg>
      </pc:sldChg>
      <pc:sldChg chg="addSp delSp modSp new mod setBg modClrScheme delDesignElem chgLayout">
        <pc:chgData name="Felipe Freitas" userId="754b0854625114a1" providerId="LiveId" clId="{D3337E6F-9E70-4B65-B42F-8091C9D37240}" dt="2023-10-23T01:46:34.240" v="582"/>
        <pc:sldMkLst>
          <pc:docMk/>
          <pc:sldMk cId="4142780168" sldId="261"/>
        </pc:sldMkLst>
        <pc:spChg chg="mod ord">
          <ac:chgData name="Felipe Freitas" userId="754b0854625114a1" providerId="LiveId" clId="{D3337E6F-9E70-4B65-B42F-8091C9D37240}" dt="2023-10-23T01:43:28.835" v="530" actId="20577"/>
          <ac:spMkLst>
            <pc:docMk/>
            <pc:sldMk cId="4142780168" sldId="261"/>
            <ac:spMk id="2" creationId="{DFE2B4DC-A5C0-C8D3-C66E-836E85A60E93}"/>
          </ac:spMkLst>
        </pc:spChg>
        <pc:spChg chg="del">
          <ac:chgData name="Felipe Freitas" userId="754b0854625114a1" providerId="LiveId" clId="{D3337E6F-9E70-4B65-B42F-8091C9D37240}" dt="2023-10-23T00:55:55.642" v="51"/>
          <ac:spMkLst>
            <pc:docMk/>
            <pc:sldMk cId="4142780168" sldId="261"/>
            <ac:spMk id="3" creationId="{5B3A49AC-92C3-82A4-34F3-FF7D30875965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142780168" sldId="261"/>
            <ac:spMk id="8" creationId="{D9E3B49F-66FD-007F-DD65-AE2BC52E623B}"/>
          </ac:spMkLst>
        </pc:spChg>
        <pc:spChg chg="add mod">
          <ac:chgData name="Felipe Freitas" userId="754b0854625114a1" providerId="LiveId" clId="{D3337E6F-9E70-4B65-B42F-8091C9D37240}" dt="2023-10-23T01:46:34.240" v="582"/>
          <ac:spMkLst>
            <pc:docMk/>
            <pc:sldMk cId="4142780168" sldId="261"/>
            <ac:spMk id="9" creationId="{28F6AAD9-72C7-7E5B-40FE-FDC52BCACC93}"/>
          </ac:spMkLst>
        </pc:spChg>
        <pc:spChg chg="add mod">
          <ac:chgData name="Felipe Freitas" userId="754b0854625114a1" providerId="LiveId" clId="{D3337E6F-9E70-4B65-B42F-8091C9D37240}" dt="2023-10-23T01:46:34.240" v="582"/>
          <ac:spMkLst>
            <pc:docMk/>
            <pc:sldMk cId="4142780168" sldId="261"/>
            <ac:spMk id="10" creationId="{AD2B5B7A-9D27-BA07-EF7E-80E37FCE973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142780168" sldId="261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142780168" sldId="261"/>
            <ac:picMk id="5" creationId="{CD9FE44F-9C59-6B57-C56D-114565BF816F}"/>
          </ac:picMkLst>
        </pc:picChg>
        <pc:picChg chg="add mod">
          <ac:chgData name="Felipe Freitas" userId="754b0854625114a1" providerId="LiveId" clId="{D3337E6F-9E70-4B65-B42F-8091C9D37240}" dt="2023-10-23T00:55:57.188" v="52" actId="26606"/>
          <ac:picMkLst>
            <pc:docMk/>
            <pc:sldMk cId="4142780168" sldId="261"/>
            <ac:picMk id="7" creationId="{B04DA4EE-B158-DA3F-76ED-BDB05D1BECE1}"/>
          </ac:picMkLst>
        </pc:picChg>
      </pc:sldChg>
      <pc:sldChg chg="addSp delSp modSp new mod setBg modClrScheme delDesignElem chgLayout">
        <pc:chgData name="Felipe Freitas" userId="754b0854625114a1" providerId="LiveId" clId="{D3337E6F-9E70-4B65-B42F-8091C9D37240}" dt="2023-10-23T01:46:35.975" v="583"/>
        <pc:sldMkLst>
          <pc:docMk/>
          <pc:sldMk cId="3982615876" sldId="262"/>
        </pc:sldMkLst>
        <pc:spChg chg="mod ord">
          <ac:chgData name="Felipe Freitas" userId="754b0854625114a1" providerId="LiveId" clId="{D3337E6F-9E70-4B65-B42F-8091C9D37240}" dt="2023-10-23T01:43:25.861" v="529" actId="20577"/>
          <ac:spMkLst>
            <pc:docMk/>
            <pc:sldMk cId="3982615876" sldId="262"/>
            <ac:spMk id="2" creationId="{787BD46A-090E-645E-A58E-942DE8293721}"/>
          </ac:spMkLst>
        </pc:spChg>
        <pc:spChg chg="del">
          <ac:chgData name="Felipe Freitas" userId="754b0854625114a1" providerId="LiveId" clId="{D3337E6F-9E70-4B65-B42F-8091C9D37240}" dt="2023-10-23T00:56:03.419" v="53"/>
          <ac:spMkLst>
            <pc:docMk/>
            <pc:sldMk cId="3982615876" sldId="262"/>
            <ac:spMk id="3" creationId="{D906328A-0CD5-E674-9409-4A3C0D8E1D80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982615876" sldId="262"/>
            <ac:spMk id="10" creationId="{17E9C3A7-7127-A7FE-5F46-8E375BDB6544}"/>
          </ac:spMkLst>
        </pc:spChg>
        <pc:spChg chg="add mod">
          <ac:chgData name="Felipe Freitas" userId="754b0854625114a1" providerId="LiveId" clId="{D3337E6F-9E70-4B65-B42F-8091C9D37240}" dt="2023-10-23T01:46:35.975" v="583"/>
          <ac:spMkLst>
            <pc:docMk/>
            <pc:sldMk cId="3982615876" sldId="262"/>
            <ac:spMk id="11" creationId="{05A2B262-09A1-1FBD-4934-DBEB11D49B25}"/>
          </ac:spMkLst>
        </pc:spChg>
        <pc:spChg chg="add del">
          <ac:chgData name="Felipe Freitas" userId="754b0854625114a1" providerId="LiveId" clId="{D3337E6F-9E70-4B65-B42F-8091C9D37240}" dt="2023-10-23T01:23:13.833" v="297" actId="26606"/>
          <ac:spMkLst>
            <pc:docMk/>
            <pc:sldMk cId="3982615876" sldId="262"/>
            <ac:spMk id="12" creationId="{3B47FC9C-2ED3-4100-A4EF-E8CDFEE106C9}"/>
          </ac:spMkLst>
        </pc:spChg>
        <pc:spChg chg="add mod">
          <ac:chgData name="Felipe Freitas" userId="754b0854625114a1" providerId="LiveId" clId="{D3337E6F-9E70-4B65-B42F-8091C9D37240}" dt="2023-10-23T01:46:35.975" v="583"/>
          <ac:spMkLst>
            <pc:docMk/>
            <pc:sldMk cId="3982615876" sldId="262"/>
            <ac:spMk id="13" creationId="{670D0C7A-A6B0-234B-DEC0-95D7F9E58221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3982615876" sldId="262"/>
            <ac:spMk id="17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3982615876" sldId="262"/>
            <ac:picMk id="5" creationId="{5E217D7C-BADA-C449-B2C1-D46B1B21BF6F}"/>
          </ac:picMkLst>
        </pc:picChg>
        <pc:picChg chg="add del mod">
          <ac:chgData name="Felipe Freitas" userId="754b0854625114a1" providerId="LiveId" clId="{D3337E6F-9E70-4B65-B42F-8091C9D37240}" dt="2023-10-23T01:23:08.095" v="295" actId="478"/>
          <ac:picMkLst>
            <pc:docMk/>
            <pc:sldMk cId="3982615876" sldId="262"/>
            <ac:picMk id="7" creationId="{B1285D3E-EBD9-F39C-5C60-BC7D3D3935D3}"/>
          </ac:picMkLst>
        </pc:picChg>
        <pc:picChg chg="add mod ord">
          <ac:chgData name="Felipe Freitas" userId="754b0854625114a1" providerId="LiveId" clId="{D3337E6F-9E70-4B65-B42F-8091C9D37240}" dt="2023-10-23T01:23:13.833" v="297" actId="26606"/>
          <ac:picMkLst>
            <pc:docMk/>
            <pc:sldMk cId="3982615876" sldId="262"/>
            <ac:picMk id="9" creationId="{DBB31EE8-246D-632B-5C13-F9711EA90D7A}"/>
          </ac:picMkLst>
        </pc:picChg>
      </pc:sldChg>
      <pc:sldChg chg="addSp delSp modSp new mod setBg modClrScheme delDesignElem chgLayout">
        <pc:chgData name="Felipe Freitas" userId="754b0854625114a1" providerId="LiveId" clId="{D3337E6F-9E70-4B65-B42F-8091C9D37240}" dt="2023-10-23T01:46:37.034" v="584"/>
        <pc:sldMkLst>
          <pc:docMk/>
          <pc:sldMk cId="1319312491" sldId="263"/>
        </pc:sldMkLst>
        <pc:spChg chg="mod ord">
          <ac:chgData name="Felipe Freitas" userId="754b0854625114a1" providerId="LiveId" clId="{D3337E6F-9E70-4B65-B42F-8091C9D37240}" dt="2023-10-23T01:43:19.237" v="525" actId="20577"/>
          <ac:spMkLst>
            <pc:docMk/>
            <pc:sldMk cId="1319312491" sldId="263"/>
            <ac:spMk id="2" creationId="{935EEDD6-8504-65CF-EEF6-E2DF9027F368}"/>
          </ac:spMkLst>
        </pc:spChg>
        <pc:spChg chg="del">
          <ac:chgData name="Felipe Freitas" userId="754b0854625114a1" providerId="LiveId" clId="{D3337E6F-9E70-4B65-B42F-8091C9D37240}" dt="2023-10-23T00:56:18.234" v="55"/>
          <ac:spMkLst>
            <pc:docMk/>
            <pc:sldMk cId="1319312491" sldId="263"/>
            <ac:spMk id="3" creationId="{55EC522B-67DB-8395-5A16-A0CBF79C04DB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319312491" sldId="263"/>
            <ac:spMk id="8" creationId="{F31CA28D-BEB2-5C22-F839-B60AC7C6A153}"/>
          </ac:spMkLst>
        </pc:spChg>
        <pc:spChg chg="add mod">
          <ac:chgData name="Felipe Freitas" userId="754b0854625114a1" providerId="LiveId" clId="{D3337E6F-9E70-4B65-B42F-8091C9D37240}" dt="2023-10-23T01:46:37.034" v="584"/>
          <ac:spMkLst>
            <pc:docMk/>
            <pc:sldMk cId="1319312491" sldId="263"/>
            <ac:spMk id="9" creationId="{727A6BAB-F389-168A-1C35-2CA5543D2858}"/>
          </ac:spMkLst>
        </pc:spChg>
        <pc:spChg chg="add mod">
          <ac:chgData name="Felipe Freitas" userId="754b0854625114a1" providerId="LiveId" clId="{D3337E6F-9E70-4B65-B42F-8091C9D37240}" dt="2023-10-23T01:46:37.034" v="584"/>
          <ac:spMkLst>
            <pc:docMk/>
            <pc:sldMk cId="1319312491" sldId="263"/>
            <ac:spMk id="10" creationId="{457D7B69-2F42-DAC1-B3A2-F6B0074AA796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319312491" sldId="263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1319312491" sldId="263"/>
            <ac:picMk id="5" creationId="{0F7AE48C-A006-FE6D-53E5-4C45710BEBFD}"/>
          </ac:picMkLst>
        </pc:picChg>
        <pc:picChg chg="add mod">
          <ac:chgData name="Felipe Freitas" userId="754b0854625114a1" providerId="LiveId" clId="{D3337E6F-9E70-4B65-B42F-8091C9D37240}" dt="2023-10-23T00:56:19.602" v="56" actId="26606"/>
          <ac:picMkLst>
            <pc:docMk/>
            <pc:sldMk cId="1319312491" sldId="263"/>
            <ac:picMk id="7" creationId="{FDDABF21-13D4-C94D-16C1-ED85486A94F4}"/>
          </ac:picMkLst>
        </pc:picChg>
      </pc:sldChg>
      <pc:sldChg chg="new del">
        <pc:chgData name="Felipe Freitas" userId="754b0854625114a1" providerId="LiveId" clId="{D3337E6F-9E70-4B65-B42F-8091C9D37240}" dt="2023-10-23T00:59:43.226" v="162" actId="47"/>
        <pc:sldMkLst>
          <pc:docMk/>
          <pc:sldMk cId="2359328987" sldId="264"/>
        </pc:sldMkLst>
      </pc:sldChg>
      <pc:sldChg chg="new del">
        <pc:chgData name="Felipe Freitas" userId="754b0854625114a1" providerId="LiveId" clId="{D3337E6F-9E70-4B65-B42F-8091C9D37240}" dt="2023-10-23T00:58:51.777" v="139" actId="47"/>
        <pc:sldMkLst>
          <pc:docMk/>
          <pc:sldMk cId="2218010346" sldId="265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3097519777" sldId="266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420284956" sldId="267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969151270" sldId="268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3738935522" sldId="269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3293563281" sldId="270"/>
        </pc:sldMkLst>
      </pc:sldChg>
      <pc:sldChg chg="new add del">
        <pc:chgData name="Felipe Freitas" userId="754b0854625114a1" providerId="LiveId" clId="{D3337E6F-9E70-4B65-B42F-8091C9D37240}" dt="2023-10-23T00:59:19.270" v="156" actId="47"/>
        <pc:sldMkLst>
          <pc:docMk/>
          <pc:sldMk cId="1299234544" sldId="271"/>
        </pc:sldMkLst>
      </pc:sldChg>
      <pc:sldChg chg="new del">
        <pc:chgData name="Felipe Freitas" userId="754b0854625114a1" providerId="LiveId" clId="{D3337E6F-9E70-4B65-B42F-8091C9D37240}" dt="2023-10-23T01:00:03.981" v="165" actId="47"/>
        <pc:sldMkLst>
          <pc:docMk/>
          <pc:sldMk cId="3838942565" sldId="272"/>
        </pc:sldMkLst>
      </pc:sldChg>
      <pc:sldChg chg="new del">
        <pc:chgData name="Felipe Freitas" userId="754b0854625114a1" providerId="LiveId" clId="{D3337E6F-9E70-4B65-B42F-8091C9D37240}" dt="2023-10-23T01:00:08.055" v="166" actId="47"/>
        <pc:sldMkLst>
          <pc:docMk/>
          <pc:sldMk cId="3432660945" sldId="273"/>
        </pc:sldMkLst>
      </pc:sldChg>
      <pc:sldChg chg="new add del">
        <pc:chgData name="Felipe Freitas" userId="754b0854625114a1" providerId="LiveId" clId="{D3337E6F-9E70-4B65-B42F-8091C9D37240}" dt="2023-10-23T01:00:18.668" v="167" actId="47"/>
        <pc:sldMkLst>
          <pc:docMk/>
          <pc:sldMk cId="3046982835" sldId="274"/>
        </pc:sldMkLst>
      </pc:sldChg>
      <pc:sldChg chg="addSp delSp modSp new del">
        <pc:chgData name="Felipe Freitas" userId="754b0854625114a1" providerId="LiveId" clId="{D3337E6F-9E70-4B65-B42F-8091C9D37240}" dt="2023-10-23T01:06:43.382" v="233" actId="47"/>
        <pc:sldMkLst>
          <pc:docMk/>
          <pc:sldMk cId="535143367" sldId="275"/>
        </pc:sldMkLst>
        <pc:spChg chg="add del">
          <ac:chgData name="Felipe Freitas" userId="754b0854625114a1" providerId="LiveId" clId="{D3337E6F-9E70-4B65-B42F-8091C9D37240}" dt="2023-10-23T01:06:41.398" v="232"/>
          <ac:spMkLst>
            <pc:docMk/>
            <pc:sldMk cId="535143367" sldId="275"/>
            <ac:spMk id="3" creationId="{CC395205-540B-ADF3-824B-2ED6FB4C8CF5}"/>
          </ac:spMkLst>
        </pc:spChg>
        <pc:picChg chg="add del mod">
          <ac:chgData name="Felipe Freitas" userId="754b0854625114a1" providerId="LiveId" clId="{D3337E6F-9E70-4B65-B42F-8091C9D37240}" dt="2023-10-23T01:06:41.398" v="232"/>
          <ac:picMkLst>
            <pc:docMk/>
            <pc:sldMk cId="535143367" sldId="275"/>
            <ac:picMk id="5" creationId="{EBD0C67E-C6F3-2014-A820-ED579397BB40}"/>
          </ac:picMkLst>
        </pc:picChg>
        <pc:picChg chg="add del mod">
          <ac:chgData name="Felipe Freitas" userId="754b0854625114a1" providerId="LiveId" clId="{D3337E6F-9E70-4B65-B42F-8091C9D37240}" dt="2023-10-23T01:06:41.398" v="232"/>
          <ac:picMkLst>
            <pc:docMk/>
            <pc:sldMk cId="535143367" sldId="275"/>
            <ac:picMk id="7" creationId="{F3FAB1E8-6B99-16B5-7DB1-E0AD6AA3C96A}"/>
          </ac:picMkLst>
        </pc:pic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859487942" sldId="276"/>
        </pc:sldMkLst>
        <pc:spChg chg="mod ord">
          <ac:chgData name="Felipe Freitas" userId="754b0854625114a1" providerId="LiveId" clId="{D3337E6F-9E70-4B65-B42F-8091C9D37240}" dt="2023-10-23T01:00:55.533" v="169" actId="26606"/>
          <ac:spMkLst>
            <pc:docMk/>
            <pc:sldMk cId="859487942" sldId="276"/>
            <ac:spMk id="2" creationId="{65C11385-BCBC-4B11-63AB-7393A2B5B858}"/>
          </ac:spMkLst>
        </pc:spChg>
        <pc:spChg chg="add del mod">
          <ac:chgData name="Felipe Freitas" userId="754b0854625114a1" providerId="LiveId" clId="{D3337E6F-9E70-4B65-B42F-8091C9D37240}" dt="2023-10-23T01:00:53.312" v="168"/>
          <ac:spMkLst>
            <pc:docMk/>
            <pc:sldMk cId="859487942" sldId="276"/>
            <ac:spMk id="4" creationId="{D1D06267-0291-9C84-2411-B92CFCEA23E1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859487942" sldId="276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0:55.533" v="169" actId="26606"/>
          <ac:spMkLst>
            <pc:docMk/>
            <pc:sldMk cId="859487942" sldId="276"/>
            <ac:spMk id="15" creationId="{3B47FC9C-2ED3-4100-A4EF-E8CDFEE106C9}"/>
          </ac:spMkLst>
        </pc:spChg>
        <pc:picChg chg="del">
          <ac:chgData name="Felipe Freitas" userId="754b0854625114a1" providerId="LiveId" clId="{D3337E6F-9E70-4B65-B42F-8091C9D37240}" dt="2023-10-23T00:58:55.762" v="141" actId="478"/>
          <ac:picMkLst>
            <pc:docMk/>
            <pc:sldMk cId="859487942" sldId="276"/>
            <ac:picMk id="5" creationId="{3B0B0CDA-D7A6-DDE1-702D-8BADCA33FD40}"/>
          </ac:picMkLst>
        </pc:picChg>
        <pc:picChg chg="del">
          <ac:chgData name="Felipe Freitas" userId="754b0854625114a1" providerId="LiveId" clId="{D3337E6F-9E70-4B65-B42F-8091C9D37240}" dt="2023-10-23T00:58:54.990" v="140" actId="478"/>
          <ac:picMkLst>
            <pc:docMk/>
            <pc:sldMk cId="859487942" sldId="276"/>
            <ac:picMk id="7" creationId="{958CC049-441E-17B5-59CB-BD8F00EE2EE9}"/>
          </ac:picMkLst>
        </pc:picChg>
        <pc:picChg chg="add mod ord">
          <ac:chgData name="Felipe Freitas" userId="754b0854625114a1" providerId="LiveId" clId="{D3337E6F-9E70-4B65-B42F-8091C9D37240}" dt="2023-10-23T01:00:55.533" v="169" actId="26606"/>
          <ac:picMkLst>
            <pc:docMk/>
            <pc:sldMk cId="859487942" sldId="276"/>
            <ac:picMk id="8" creationId="{1EE861D5-779B-6246-95AB-22B916A5AFB1}"/>
          </ac:picMkLst>
        </pc:picChg>
        <pc:picChg chg="add mod">
          <ac:chgData name="Felipe Freitas" userId="754b0854625114a1" providerId="LiveId" clId="{D3337E6F-9E70-4B65-B42F-8091C9D37240}" dt="2023-10-23T01:00:55.533" v="169" actId="26606"/>
          <ac:picMkLst>
            <pc:docMk/>
            <pc:sldMk cId="859487942" sldId="276"/>
            <ac:picMk id="10" creationId="{54E016B9-487E-DB1A-BB8D-A6701B45A254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3691948525" sldId="276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3691948525" sldId="276"/>
            <ac:spMk id="12" creationId="{3B47FC9C-2ED3-4100-A4EF-E8CDFEE106C9}"/>
          </ac:spMkLst>
        </pc:sp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458232085" sldId="277"/>
        </pc:sldMkLst>
        <pc:spChg chg="ord">
          <ac:chgData name="Felipe Freitas" userId="754b0854625114a1" providerId="LiveId" clId="{D3337E6F-9E70-4B65-B42F-8091C9D37240}" dt="2023-10-23T01:01:02.370" v="171" actId="26606"/>
          <ac:spMkLst>
            <pc:docMk/>
            <pc:sldMk cId="458232085" sldId="277"/>
            <ac:spMk id="2" creationId="{25507AD8-5769-1871-C2E3-8F2F5709A2E1}"/>
          </ac:spMkLst>
        </pc:spChg>
        <pc:spChg chg="add del mod">
          <ac:chgData name="Felipe Freitas" userId="754b0854625114a1" providerId="LiveId" clId="{D3337E6F-9E70-4B65-B42F-8091C9D37240}" dt="2023-10-23T01:01:01.124" v="170"/>
          <ac:spMkLst>
            <pc:docMk/>
            <pc:sldMk cId="458232085" sldId="277"/>
            <ac:spMk id="4" creationId="{F2FFCBE5-0B62-38E2-DDD8-427558A77C0F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458232085" sldId="277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02.370" v="171" actId="26606"/>
          <ac:spMkLst>
            <pc:docMk/>
            <pc:sldMk cId="458232085" sldId="277"/>
            <ac:spMk id="15" creationId="{3B47FC9C-2ED3-4100-A4EF-E8CDFEE106C9}"/>
          </ac:spMkLst>
        </pc:spChg>
        <pc:picChg chg="del">
          <ac:chgData name="Felipe Freitas" userId="754b0854625114a1" providerId="LiveId" clId="{D3337E6F-9E70-4B65-B42F-8091C9D37240}" dt="2023-10-23T00:58:57.668" v="143" actId="478"/>
          <ac:picMkLst>
            <pc:docMk/>
            <pc:sldMk cId="458232085" sldId="277"/>
            <ac:picMk id="5" creationId="{EE6E3DCB-8FF8-CD3B-DBB4-D36AA5B5EF67}"/>
          </ac:picMkLst>
        </pc:picChg>
        <pc:picChg chg="del">
          <ac:chgData name="Felipe Freitas" userId="754b0854625114a1" providerId="LiveId" clId="{D3337E6F-9E70-4B65-B42F-8091C9D37240}" dt="2023-10-23T00:58:57.117" v="142" actId="478"/>
          <ac:picMkLst>
            <pc:docMk/>
            <pc:sldMk cId="458232085" sldId="277"/>
            <ac:picMk id="7" creationId="{350F8969-680E-4005-8EE8-2200C7E0F523}"/>
          </ac:picMkLst>
        </pc:picChg>
        <pc:picChg chg="add mod">
          <ac:chgData name="Felipe Freitas" userId="754b0854625114a1" providerId="LiveId" clId="{D3337E6F-9E70-4B65-B42F-8091C9D37240}" dt="2023-10-23T01:01:02.370" v="171" actId="26606"/>
          <ac:picMkLst>
            <pc:docMk/>
            <pc:sldMk cId="458232085" sldId="277"/>
            <ac:picMk id="8" creationId="{211A19FB-B91F-DDBF-B13E-B89A74831E41}"/>
          </ac:picMkLst>
        </pc:picChg>
        <pc:picChg chg="add mod">
          <ac:chgData name="Felipe Freitas" userId="754b0854625114a1" providerId="LiveId" clId="{D3337E6F-9E70-4B65-B42F-8091C9D37240}" dt="2023-10-23T01:01:02.370" v="171" actId="26606"/>
          <ac:picMkLst>
            <pc:docMk/>
            <pc:sldMk cId="458232085" sldId="277"/>
            <ac:picMk id="10" creationId="{D67C578C-74DD-3A90-7865-14611E341CC6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920306451" sldId="277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920306451" sldId="277"/>
            <ac:spMk id="12" creationId="{3B47FC9C-2ED3-4100-A4EF-E8CDFEE106C9}"/>
          </ac:spMkLst>
        </pc:sp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3378544526" sldId="278"/>
        </pc:sldMkLst>
        <pc:spChg chg="ord">
          <ac:chgData name="Felipe Freitas" userId="754b0854625114a1" providerId="LiveId" clId="{D3337E6F-9E70-4B65-B42F-8091C9D37240}" dt="2023-10-23T01:01:09.666" v="173" actId="26606"/>
          <ac:spMkLst>
            <pc:docMk/>
            <pc:sldMk cId="3378544526" sldId="278"/>
            <ac:spMk id="2" creationId="{AB174FCF-100E-A371-E790-152B385F4A03}"/>
          </ac:spMkLst>
        </pc:spChg>
        <pc:spChg chg="add del mod">
          <ac:chgData name="Felipe Freitas" userId="754b0854625114a1" providerId="LiveId" clId="{D3337E6F-9E70-4B65-B42F-8091C9D37240}" dt="2023-10-23T01:01:08.277" v="172"/>
          <ac:spMkLst>
            <pc:docMk/>
            <pc:sldMk cId="3378544526" sldId="278"/>
            <ac:spMk id="4" creationId="{E9BC88A5-DB02-0E71-74CC-952FDBCF96CE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3378544526" sldId="278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09.666" v="173" actId="26606"/>
          <ac:spMkLst>
            <pc:docMk/>
            <pc:sldMk cId="3378544526" sldId="278"/>
            <ac:spMk id="15" creationId="{3B47FC9C-2ED3-4100-A4EF-E8CDFEE106C9}"/>
          </ac:spMkLst>
        </pc:spChg>
        <pc:picChg chg="del mod">
          <ac:chgData name="Felipe Freitas" userId="754b0854625114a1" providerId="LiveId" clId="{D3337E6F-9E70-4B65-B42F-8091C9D37240}" dt="2023-10-23T00:59:00.425" v="146" actId="478"/>
          <ac:picMkLst>
            <pc:docMk/>
            <pc:sldMk cId="3378544526" sldId="278"/>
            <ac:picMk id="5" creationId="{D1F8C030-5ABE-B0D3-6232-41E97BB9018B}"/>
          </ac:picMkLst>
        </pc:picChg>
        <pc:picChg chg="del">
          <ac:chgData name="Felipe Freitas" userId="754b0854625114a1" providerId="LiveId" clId="{D3337E6F-9E70-4B65-B42F-8091C9D37240}" dt="2023-10-23T00:58:59.778" v="144" actId="478"/>
          <ac:picMkLst>
            <pc:docMk/>
            <pc:sldMk cId="3378544526" sldId="278"/>
            <ac:picMk id="7" creationId="{D7FFA4B5-A4CE-F744-D924-4E21C8CDDCB8}"/>
          </ac:picMkLst>
        </pc:picChg>
        <pc:picChg chg="add mod ord">
          <ac:chgData name="Felipe Freitas" userId="754b0854625114a1" providerId="LiveId" clId="{D3337E6F-9E70-4B65-B42F-8091C9D37240}" dt="2023-10-23T01:01:09.666" v="173" actId="26606"/>
          <ac:picMkLst>
            <pc:docMk/>
            <pc:sldMk cId="3378544526" sldId="278"/>
            <ac:picMk id="8" creationId="{C18BEBD5-3A90-7BB7-2FCB-21728EC4FBD9}"/>
          </ac:picMkLst>
        </pc:picChg>
        <pc:picChg chg="add mod">
          <ac:chgData name="Felipe Freitas" userId="754b0854625114a1" providerId="LiveId" clId="{D3337E6F-9E70-4B65-B42F-8091C9D37240}" dt="2023-10-23T01:01:09.666" v="173" actId="26606"/>
          <ac:picMkLst>
            <pc:docMk/>
            <pc:sldMk cId="3378544526" sldId="278"/>
            <ac:picMk id="10" creationId="{4ECDE492-CC88-DF0A-F02D-9EA6A33B0C7C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3774795181" sldId="278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3774795181" sldId="278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2888123219" sldId="279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2888123219" sldId="279"/>
            <ac:spMk id="12" creationId="{3B47FC9C-2ED3-4100-A4EF-E8CDFEE106C9}"/>
          </ac:spMkLst>
        </pc:sp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4219491016" sldId="279"/>
        </pc:sldMkLst>
        <pc:spChg chg="ord">
          <ac:chgData name="Felipe Freitas" userId="754b0854625114a1" providerId="LiveId" clId="{D3337E6F-9E70-4B65-B42F-8091C9D37240}" dt="2023-10-23T01:01:16.844" v="175" actId="26606"/>
          <ac:spMkLst>
            <pc:docMk/>
            <pc:sldMk cId="4219491016" sldId="279"/>
            <ac:spMk id="2" creationId="{EACB5293-0FDD-271A-3B75-C1B547BCB875}"/>
          </ac:spMkLst>
        </pc:spChg>
        <pc:spChg chg="add del mod">
          <ac:chgData name="Felipe Freitas" userId="754b0854625114a1" providerId="LiveId" clId="{D3337E6F-9E70-4B65-B42F-8091C9D37240}" dt="2023-10-23T01:01:14.924" v="174"/>
          <ac:spMkLst>
            <pc:docMk/>
            <pc:sldMk cId="4219491016" sldId="279"/>
            <ac:spMk id="4" creationId="{B110AADB-E0CF-EB3B-08E2-B1463C75B2B0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4219491016" sldId="279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16.844" v="175" actId="26606"/>
          <ac:spMkLst>
            <pc:docMk/>
            <pc:sldMk cId="4219491016" sldId="279"/>
            <ac:spMk id="15" creationId="{3B47FC9C-2ED3-4100-A4EF-E8CDFEE106C9}"/>
          </ac:spMkLst>
        </pc:spChg>
        <pc:picChg chg="del">
          <ac:chgData name="Felipe Freitas" userId="754b0854625114a1" providerId="LiveId" clId="{D3337E6F-9E70-4B65-B42F-8091C9D37240}" dt="2023-10-23T00:59:03.175" v="148" actId="478"/>
          <ac:picMkLst>
            <pc:docMk/>
            <pc:sldMk cId="4219491016" sldId="279"/>
            <ac:picMk id="5" creationId="{A1BC0CCA-0635-DBDB-251D-8540FC9D60AF}"/>
          </ac:picMkLst>
        </pc:picChg>
        <pc:picChg chg="del">
          <ac:chgData name="Felipe Freitas" userId="754b0854625114a1" providerId="LiveId" clId="{D3337E6F-9E70-4B65-B42F-8091C9D37240}" dt="2023-10-23T00:59:02.433" v="147" actId="478"/>
          <ac:picMkLst>
            <pc:docMk/>
            <pc:sldMk cId="4219491016" sldId="279"/>
            <ac:picMk id="7" creationId="{083F5890-FD73-204C-3619-02585B64DD7E}"/>
          </ac:picMkLst>
        </pc:picChg>
        <pc:picChg chg="add mod">
          <ac:chgData name="Felipe Freitas" userId="754b0854625114a1" providerId="LiveId" clId="{D3337E6F-9E70-4B65-B42F-8091C9D37240}" dt="2023-10-23T01:01:16.844" v="175" actId="26606"/>
          <ac:picMkLst>
            <pc:docMk/>
            <pc:sldMk cId="4219491016" sldId="279"/>
            <ac:picMk id="8" creationId="{9140CA37-4779-CCF4-5D30-220436D775DD}"/>
          </ac:picMkLst>
        </pc:picChg>
        <pc:picChg chg="add mod">
          <ac:chgData name="Felipe Freitas" userId="754b0854625114a1" providerId="LiveId" clId="{D3337E6F-9E70-4B65-B42F-8091C9D37240}" dt="2023-10-23T01:01:16.844" v="175" actId="26606"/>
          <ac:picMkLst>
            <pc:docMk/>
            <pc:sldMk cId="4219491016" sldId="279"/>
            <ac:picMk id="10" creationId="{190FBC1B-B659-4E24-F48F-50C12FEC0EE1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330845970" sldId="280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330845970" sldId="280"/>
            <ac:spMk id="12" creationId="{3B47FC9C-2ED3-4100-A4EF-E8CDFEE106C9}"/>
          </ac:spMkLst>
        </pc:sp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1750981674" sldId="280"/>
        </pc:sldMkLst>
        <pc:spChg chg="ord">
          <ac:chgData name="Felipe Freitas" userId="754b0854625114a1" providerId="LiveId" clId="{D3337E6F-9E70-4B65-B42F-8091C9D37240}" dt="2023-10-23T01:01:24.343" v="177" actId="26606"/>
          <ac:spMkLst>
            <pc:docMk/>
            <pc:sldMk cId="1750981674" sldId="280"/>
            <ac:spMk id="2" creationId="{DFE2B4DC-A5C0-C8D3-C66E-836E85A60E93}"/>
          </ac:spMkLst>
        </pc:spChg>
        <pc:spChg chg="add del mod">
          <ac:chgData name="Felipe Freitas" userId="754b0854625114a1" providerId="LiveId" clId="{D3337E6F-9E70-4B65-B42F-8091C9D37240}" dt="2023-10-23T01:01:22.888" v="176"/>
          <ac:spMkLst>
            <pc:docMk/>
            <pc:sldMk cId="1750981674" sldId="280"/>
            <ac:spMk id="4" creationId="{61792894-74E5-8B06-486D-08EA82925D0F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1750981674" sldId="280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24.343" v="177" actId="26606"/>
          <ac:spMkLst>
            <pc:docMk/>
            <pc:sldMk cId="1750981674" sldId="280"/>
            <ac:spMk id="15" creationId="{3B47FC9C-2ED3-4100-A4EF-E8CDFEE106C9}"/>
          </ac:spMkLst>
        </pc:spChg>
        <pc:picChg chg="del mod">
          <ac:chgData name="Felipe Freitas" userId="754b0854625114a1" providerId="LiveId" clId="{D3337E6F-9E70-4B65-B42F-8091C9D37240}" dt="2023-10-23T00:59:05.149" v="151" actId="478"/>
          <ac:picMkLst>
            <pc:docMk/>
            <pc:sldMk cId="1750981674" sldId="280"/>
            <ac:picMk id="5" creationId="{CD9FE44F-9C59-6B57-C56D-114565BF816F}"/>
          </ac:picMkLst>
        </pc:picChg>
        <pc:picChg chg="del">
          <ac:chgData name="Felipe Freitas" userId="754b0854625114a1" providerId="LiveId" clId="{D3337E6F-9E70-4B65-B42F-8091C9D37240}" dt="2023-10-23T00:59:04.552" v="149" actId="478"/>
          <ac:picMkLst>
            <pc:docMk/>
            <pc:sldMk cId="1750981674" sldId="280"/>
            <ac:picMk id="7" creationId="{B04DA4EE-B158-DA3F-76ED-BDB05D1BECE1}"/>
          </ac:picMkLst>
        </pc:picChg>
        <pc:picChg chg="add mod ord">
          <ac:chgData name="Felipe Freitas" userId="754b0854625114a1" providerId="LiveId" clId="{D3337E6F-9E70-4B65-B42F-8091C9D37240}" dt="2023-10-23T01:01:24.343" v="177" actId="26606"/>
          <ac:picMkLst>
            <pc:docMk/>
            <pc:sldMk cId="1750981674" sldId="280"/>
            <ac:picMk id="8" creationId="{475FBC2B-F6A7-0355-CAE0-F319787F21A3}"/>
          </ac:picMkLst>
        </pc:picChg>
        <pc:picChg chg="add mod">
          <ac:chgData name="Felipe Freitas" userId="754b0854625114a1" providerId="LiveId" clId="{D3337E6F-9E70-4B65-B42F-8091C9D37240}" dt="2023-10-23T01:01:24.343" v="177" actId="26606"/>
          <ac:picMkLst>
            <pc:docMk/>
            <pc:sldMk cId="1750981674" sldId="280"/>
            <ac:picMk id="10" creationId="{51B81E3D-96EA-75EF-AB80-60596D7CEF2A}"/>
          </ac:picMkLst>
        </pc:pic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1790108997" sldId="281"/>
        </pc:sldMkLst>
        <pc:spChg chg="ord">
          <ac:chgData name="Felipe Freitas" userId="754b0854625114a1" providerId="LiveId" clId="{D3337E6F-9E70-4B65-B42F-8091C9D37240}" dt="2023-10-23T01:01:30.755" v="179" actId="26606"/>
          <ac:spMkLst>
            <pc:docMk/>
            <pc:sldMk cId="1790108997" sldId="281"/>
            <ac:spMk id="2" creationId="{787BD46A-090E-645E-A58E-942DE8293721}"/>
          </ac:spMkLst>
        </pc:spChg>
        <pc:spChg chg="add del mod">
          <ac:chgData name="Felipe Freitas" userId="754b0854625114a1" providerId="LiveId" clId="{D3337E6F-9E70-4B65-B42F-8091C9D37240}" dt="2023-10-23T01:01:29.146" v="178"/>
          <ac:spMkLst>
            <pc:docMk/>
            <pc:sldMk cId="1790108997" sldId="281"/>
            <ac:spMk id="4" creationId="{F75418F6-FEE1-6E31-5B4D-D6DEF3CBDAB3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1790108997" sldId="281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30.755" v="179" actId="26606"/>
          <ac:spMkLst>
            <pc:docMk/>
            <pc:sldMk cId="1790108997" sldId="281"/>
            <ac:spMk id="15" creationId="{3B47FC9C-2ED3-4100-A4EF-E8CDFEE106C9}"/>
          </ac:spMkLst>
        </pc:spChg>
        <pc:picChg chg="del">
          <ac:chgData name="Felipe Freitas" userId="754b0854625114a1" providerId="LiveId" clId="{D3337E6F-9E70-4B65-B42F-8091C9D37240}" dt="2023-10-23T00:59:07.293" v="153" actId="478"/>
          <ac:picMkLst>
            <pc:docMk/>
            <pc:sldMk cId="1790108997" sldId="281"/>
            <ac:picMk id="5" creationId="{5E217D7C-BADA-C449-B2C1-D46B1B21BF6F}"/>
          </ac:picMkLst>
        </pc:picChg>
        <pc:picChg chg="del">
          <ac:chgData name="Felipe Freitas" userId="754b0854625114a1" providerId="LiveId" clId="{D3337E6F-9E70-4B65-B42F-8091C9D37240}" dt="2023-10-23T00:59:06.804" v="152" actId="478"/>
          <ac:picMkLst>
            <pc:docMk/>
            <pc:sldMk cId="1790108997" sldId="281"/>
            <ac:picMk id="7" creationId="{B1285D3E-EBD9-F39C-5C60-BC7D3D3935D3}"/>
          </ac:picMkLst>
        </pc:picChg>
        <pc:picChg chg="add mod ord">
          <ac:chgData name="Felipe Freitas" userId="754b0854625114a1" providerId="LiveId" clId="{D3337E6F-9E70-4B65-B42F-8091C9D37240}" dt="2023-10-23T01:01:30.755" v="179" actId="26606"/>
          <ac:picMkLst>
            <pc:docMk/>
            <pc:sldMk cId="1790108997" sldId="281"/>
            <ac:picMk id="8" creationId="{E66E444D-1D6D-4DA0-82CE-F7CF126110E0}"/>
          </ac:picMkLst>
        </pc:picChg>
        <pc:picChg chg="add mod">
          <ac:chgData name="Felipe Freitas" userId="754b0854625114a1" providerId="LiveId" clId="{D3337E6F-9E70-4B65-B42F-8091C9D37240}" dt="2023-10-23T01:01:30.755" v="179" actId="26606"/>
          <ac:picMkLst>
            <pc:docMk/>
            <pc:sldMk cId="1790108997" sldId="281"/>
            <ac:picMk id="10" creationId="{29B1AC6C-AE19-FFBC-B97A-4FBCE834EF9A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3809202299" sldId="281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3809202299" sldId="281"/>
            <ac:spMk id="12" creationId="{3B47FC9C-2ED3-4100-A4EF-E8CDFEE106C9}"/>
          </ac:spMkLst>
        </pc:spChg>
      </pc:sldChg>
      <pc:sldChg chg="addSp delSp modSp add del mod setBg delDesignElem">
        <pc:chgData name="Felipe Freitas" userId="754b0854625114a1" providerId="LiveId" clId="{D3337E6F-9E70-4B65-B42F-8091C9D37240}" dt="2023-10-23T01:14:45.695" v="293" actId="47"/>
        <pc:sldMkLst>
          <pc:docMk/>
          <pc:sldMk cId="3453412885" sldId="282"/>
        </pc:sldMkLst>
        <pc:spChg chg="mod ord">
          <ac:chgData name="Felipe Freitas" userId="754b0854625114a1" providerId="LiveId" clId="{D3337E6F-9E70-4B65-B42F-8091C9D37240}" dt="2023-10-23T01:01:38.863" v="181" actId="26606"/>
          <ac:spMkLst>
            <pc:docMk/>
            <pc:sldMk cId="3453412885" sldId="282"/>
            <ac:spMk id="2" creationId="{935EEDD6-8504-65CF-EEF6-E2DF9027F368}"/>
          </ac:spMkLst>
        </pc:spChg>
        <pc:spChg chg="add del mod">
          <ac:chgData name="Felipe Freitas" userId="754b0854625114a1" providerId="LiveId" clId="{D3337E6F-9E70-4B65-B42F-8091C9D37240}" dt="2023-10-23T01:01:37.372" v="180"/>
          <ac:spMkLst>
            <pc:docMk/>
            <pc:sldMk cId="3453412885" sldId="282"/>
            <ac:spMk id="4" creationId="{4795549C-DDD1-82C6-26F6-FA4A78D21CB3}"/>
          </ac:spMkLst>
        </pc:spChg>
        <pc:spChg chg="del">
          <ac:chgData name="Felipe Freitas" userId="754b0854625114a1" providerId="LiveId" clId="{D3337E6F-9E70-4B65-B42F-8091C9D37240}" dt="2023-10-23T00:58:44.770" v="138"/>
          <ac:spMkLst>
            <pc:docMk/>
            <pc:sldMk cId="3453412885" sldId="282"/>
            <ac:spMk id="12" creationId="{3B47FC9C-2ED3-4100-A4EF-E8CDFEE106C9}"/>
          </ac:spMkLst>
        </pc:spChg>
        <pc:spChg chg="add">
          <ac:chgData name="Felipe Freitas" userId="754b0854625114a1" providerId="LiveId" clId="{D3337E6F-9E70-4B65-B42F-8091C9D37240}" dt="2023-10-23T01:01:38.863" v="181" actId="26606"/>
          <ac:spMkLst>
            <pc:docMk/>
            <pc:sldMk cId="3453412885" sldId="282"/>
            <ac:spMk id="15" creationId="{3B47FC9C-2ED3-4100-A4EF-E8CDFEE106C9}"/>
          </ac:spMkLst>
        </pc:spChg>
        <pc:picChg chg="del">
          <ac:chgData name="Felipe Freitas" userId="754b0854625114a1" providerId="LiveId" clId="{D3337E6F-9E70-4B65-B42F-8091C9D37240}" dt="2023-10-23T00:59:10.253" v="155" actId="478"/>
          <ac:picMkLst>
            <pc:docMk/>
            <pc:sldMk cId="3453412885" sldId="282"/>
            <ac:picMk id="5" creationId="{0F7AE48C-A006-FE6D-53E5-4C45710BEBFD}"/>
          </ac:picMkLst>
        </pc:picChg>
        <pc:picChg chg="del">
          <ac:chgData name="Felipe Freitas" userId="754b0854625114a1" providerId="LiveId" clId="{D3337E6F-9E70-4B65-B42F-8091C9D37240}" dt="2023-10-23T00:59:09.685" v="154" actId="478"/>
          <ac:picMkLst>
            <pc:docMk/>
            <pc:sldMk cId="3453412885" sldId="282"/>
            <ac:picMk id="7" creationId="{FDDABF21-13D4-C94D-16C1-ED85486A94F4}"/>
          </ac:picMkLst>
        </pc:picChg>
        <pc:picChg chg="add mod ord">
          <ac:chgData name="Felipe Freitas" userId="754b0854625114a1" providerId="LiveId" clId="{D3337E6F-9E70-4B65-B42F-8091C9D37240}" dt="2023-10-23T01:01:38.863" v="181" actId="26606"/>
          <ac:picMkLst>
            <pc:docMk/>
            <pc:sldMk cId="3453412885" sldId="282"/>
            <ac:picMk id="8" creationId="{1D3D196A-47E5-DB66-2299-C7BE33A1926E}"/>
          </ac:picMkLst>
        </pc:picChg>
        <pc:picChg chg="add mod">
          <ac:chgData name="Felipe Freitas" userId="754b0854625114a1" providerId="LiveId" clId="{D3337E6F-9E70-4B65-B42F-8091C9D37240}" dt="2023-10-23T01:01:38.863" v="181" actId="26606"/>
          <ac:picMkLst>
            <pc:docMk/>
            <pc:sldMk cId="3453412885" sldId="282"/>
            <ac:picMk id="10" creationId="{8F2F2197-E550-0AD0-17FF-9DC5B5D702A2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40.227" v="130"/>
        <pc:sldMkLst>
          <pc:docMk/>
          <pc:sldMk cId="4243902453" sldId="282"/>
        </pc:sldMkLst>
        <pc:spChg chg="add del">
          <ac:chgData name="Felipe Freitas" userId="754b0854625114a1" providerId="LiveId" clId="{D3337E6F-9E70-4B65-B42F-8091C9D37240}" dt="2023-10-23T00:58:40.227" v="130"/>
          <ac:spMkLst>
            <pc:docMk/>
            <pc:sldMk cId="4243902453" sldId="282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1325644926" sldId="283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1325644926" sldId="283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3105381492" sldId="283"/>
        </pc:sldMkLst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1352770795" sldId="284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1352770795" sldId="284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1584113307" sldId="284"/>
        </pc:sldMkLst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664591346" sldId="285"/>
        </pc:sldMkLst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877966165" sldId="285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877966165" sldId="285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2242753408" sldId="286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2242753408" sldId="286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3402130419" sldId="286"/>
        </pc:sldMkLst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2956804397" sldId="287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2956804397" sldId="287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4126504686" sldId="287"/>
        </pc:sldMkLst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474270337" sldId="288"/>
        </pc:sldMkLst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3350184287" sldId="288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3350184287" sldId="288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5.868" v="128"/>
        <pc:sldMkLst>
          <pc:docMk/>
          <pc:sldMk cId="894489473" sldId="289"/>
        </pc:sldMkLst>
        <pc:spChg chg="add del">
          <ac:chgData name="Felipe Freitas" userId="754b0854625114a1" providerId="LiveId" clId="{D3337E6F-9E70-4B65-B42F-8091C9D37240}" dt="2023-10-23T00:58:35.868" v="128"/>
          <ac:spMkLst>
            <pc:docMk/>
            <pc:sldMk cId="894489473" sldId="289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0:59:57.164" v="163" actId="47"/>
        <pc:sldMkLst>
          <pc:docMk/>
          <pc:sldMk cId="2237705816" sldId="289"/>
        </pc:sldMkLst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1754535657" sldId="290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1754535657" sldId="290"/>
            <ac:spMk id="12" creationId="{3B47FC9C-2ED3-4100-A4EF-E8CDFEE106C9}"/>
          </ac:spMkLst>
        </pc:spChg>
      </pc:sldChg>
      <pc:sldChg chg="addSp delSp modSp add mod setBg modClrScheme delDesignElem chgLayout">
        <pc:chgData name="Felipe Freitas" userId="754b0854625114a1" providerId="LiveId" clId="{D3337E6F-9E70-4B65-B42F-8091C9D37240}" dt="2023-10-23T01:49:13.332" v="628" actId="1076"/>
        <pc:sldMkLst>
          <pc:docMk/>
          <pc:sldMk cId="1842128799" sldId="290"/>
        </pc:sldMkLst>
        <pc:spChg chg="mod ord">
          <ac:chgData name="Felipe Freitas" userId="754b0854625114a1" providerId="LiveId" clId="{D3337E6F-9E70-4B65-B42F-8091C9D37240}" dt="2023-10-23T01:42:56.124" v="520" actId="20577"/>
          <ac:spMkLst>
            <pc:docMk/>
            <pc:sldMk cId="1842128799" sldId="290"/>
            <ac:spMk id="2" creationId="{65C11385-BCBC-4B11-63AB-7393A2B5B858}"/>
          </ac:spMkLst>
        </pc:spChg>
        <pc:spChg chg="del">
          <ac:chgData name="Felipe Freitas" userId="754b0854625114a1" providerId="LiveId" clId="{D3337E6F-9E70-4B65-B42F-8091C9D37240}" dt="2023-10-23T01:03:02.089" v="196"/>
          <ac:spMkLst>
            <pc:docMk/>
            <pc:sldMk cId="1842128799" sldId="290"/>
            <ac:spMk id="4" creationId="{D1D06267-0291-9C84-2411-B92CFCEA23E1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842128799" sldId="290"/>
            <ac:spMk id="8" creationId="{9A344B2C-6376-6439-F06B-C1147A9F70FD}"/>
          </ac:spMkLst>
        </pc:spChg>
        <pc:spChg chg="add mod">
          <ac:chgData name="Felipe Freitas" userId="754b0854625114a1" providerId="LiveId" clId="{D3337E6F-9E70-4B65-B42F-8091C9D37240}" dt="2023-10-23T01:46:44.534" v="590"/>
          <ac:spMkLst>
            <pc:docMk/>
            <pc:sldMk cId="1842128799" sldId="290"/>
            <ac:spMk id="9" creationId="{EFCC19AC-B27D-66E0-2E26-AABC6C9806AA}"/>
          </ac:spMkLst>
        </pc:spChg>
        <pc:spChg chg="add mod">
          <ac:chgData name="Felipe Freitas" userId="754b0854625114a1" providerId="LiveId" clId="{D3337E6F-9E70-4B65-B42F-8091C9D37240}" dt="2023-10-23T01:46:44.534" v="590"/>
          <ac:spMkLst>
            <pc:docMk/>
            <pc:sldMk cId="1842128799" sldId="290"/>
            <ac:spMk id="10" creationId="{1AA285B3-6525-7B22-FF0D-95668284E513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842128799" sldId="290"/>
            <ac:spMk id="12" creationId="{3B47FC9C-2ED3-4100-A4EF-E8CDFEE106C9}"/>
          </ac:spMkLst>
        </pc:spChg>
        <pc:spChg chg="add del">
          <ac:chgData name="Felipe Freitas" userId="754b0854625114a1" providerId="LiveId" clId="{D3337E6F-9E70-4B65-B42F-8091C9D37240}" dt="2023-10-23T01:25:46.889" v="346" actId="26606"/>
          <ac:spMkLst>
            <pc:docMk/>
            <pc:sldMk cId="1842128799" sldId="290"/>
            <ac:spMk id="17" creationId="{E0311CE5-3D05-493E-B9D2-CF549DF73DC5}"/>
          </ac:spMkLst>
        </pc:spChg>
        <pc:picChg chg="add mod ord modCrop">
          <ac:chgData name="Felipe Freitas" userId="754b0854625114a1" providerId="LiveId" clId="{D3337E6F-9E70-4B65-B42F-8091C9D37240}" dt="2023-10-23T01:49:13.332" v="628" actId="1076"/>
          <ac:picMkLst>
            <pc:docMk/>
            <pc:sldMk cId="1842128799" sldId="290"/>
            <ac:picMk id="5" creationId="{985C261A-0AB1-73DC-48FF-62EA50CC6A33}"/>
          </ac:picMkLst>
        </pc:picChg>
        <pc:picChg chg="add mod">
          <ac:chgData name="Felipe Freitas" userId="754b0854625114a1" providerId="LiveId" clId="{D3337E6F-9E70-4B65-B42F-8091C9D37240}" dt="2023-10-23T01:49:10.751" v="627" actId="14100"/>
          <ac:picMkLst>
            <pc:docMk/>
            <pc:sldMk cId="1842128799" sldId="290"/>
            <ac:picMk id="7" creationId="{9CA50217-D92B-6726-1952-9C0E00A2DEDA}"/>
          </ac:picMkLst>
        </pc:picChg>
      </pc:sldChg>
      <pc:sldChg chg="addSp delSp modSp add del mod setBg modClrScheme delDesignElem chgLayout">
        <pc:chgData name="Felipe Freitas" userId="754b0854625114a1" providerId="LiveId" clId="{D3337E6F-9E70-4B65-B42F-8091C9D37240}" dt="2023-10-23T01:32:39.637" v="402" actId="47"/>
        <pc:sldMkLst>
          <pc:docMk/>
          <pc:sldMk cId="930870485" sldId="291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930870485" sldId="291"/>
            <ac:spMk id="2" creationId="{25507AD8-5769-1871-C2E3-8F2F5709A2E1}"/>
          </ac:spMkLst>
        </pc:spChg>
        <pc:spChg chg="add del">
          <ac:chgData name="Felipe Freitas" userId="754b0854625114a1" providerId="LiveId" clId="{D3337E6F-9E70-4B65-B42F-8091C9D37240}" dt="2023-10-23T01:03:32.032" v="206"/>
          <ac:spMkLst>
            <pc:docMk/>
            <pc:sldMk cId="930870485" sldId="291"/>
            <ac:spMk id="4" creationId="{F2FFCBE5-0B62-38E2-DDD8-427558A77C0F}"/>
          </ac:spMkLst>
        </pc:spChg>
        <pc:spChg chg="add del">
          <ac:chgData name="Felipe Freitas" userId="754b0854625114a1" providerId="LiveId" clId="{D3337E6F-9E70-4B65-B42F-8091C9D37240}" dt="2023-10-23T01:03:18.761" v="200" actId="26606"/>
          <ac:spMkLst>
            <pc:docMk/>
            <pc:sldMk cId="930870485" sldId="291"/>
            <ac:spMk id="12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930870485" sldId="291"/>
            <ac:spMk id="13" creationId="{15D00A15-2D11-8AFF-3720-5A79F8048BAD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930870485" sldId="291"/>
            <ac:spMk id="16" creationId="{3B47FC9C-2ED3-4100-A4EF-E8CDFEE106C9}"/>
          </ac:spMkLst>
        </pc:spChg>
        <pc:spChg chg="add del">
          <ac:chgData name="Felipe Freitas" userId="754b0854625114a1" providerId="LiveId" clId="{D3337E6F-9E70-4B65-B42F-8091C9D37240}" dt="2023-10-23T01:03:27.055" v="204" actId="26606"/>
          <ac:spMkLst>
            <pc:docMk/>
            <pc:sldMk cId="930870485" sldId="291"/>
            <ac:spMk id="17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03:27.464" v="205"/>
          <ac:picMkLst>
            <pc:docMk/>
            <pc:sldMk cId="930870485" sldId="291"/>
            <ac:picMk id="5" creationId="{785917E0-185F-9091-6E29-CE597884C6A0}"/>
          </ac:picMkLst>
        </pc:picChg>
        <pc:picChg chg="add del mod">
          <ac:chgData name="Felipe Freitas" userId="754b0854625114a1" providerId="LiveId" clId="{D3337E6F-9E70-4B65-B42F-8091C9D37240}" dt="2023-10-23T01:03:27.464" v="205"/>
          <ac:picMkLst>
            <pc:docMk/>
            <pc:sldMk cId="930870485" sldId="291"/>
            <ac:picMk id="7" creationId="{A57EE771-1C4A-BFC3-9933-01EFF0E52BC7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930870485" sldId="291"/>
            <ac:picMk id="9" creationId="{96CEDB70-B2F4-FC5E-8C27-FD368C01CB7C}"/>
          </ac:picMkLst>
        </pc:picChg>
        <pc:picChg chg="add mod">
          <ac:chgData name="Felipe Freitas" userId="754b0854625114a1" providerId="LiveId" clId="{D3337E6F-9E70-4B65-B42F-8091C9D37240}" dt="2023-10-23T01:03:35.156" v="207" actId="26606"/>
          <ac:picMkLst>
            <pc:docMk/>
            <pc:sldMk cId="930870485" sldId="291"/>
            <ac:picMk id="11" creationId="{21D5F305-97A3-B983-67DD-8286A1A4DA8C}"/>
          </ac:picMkLst>
        </pc:picChg>
        <pc:cxnChg chg="add del">
          <ac:chgData name="Felipe Freitas" userId="754b0854625114a1" providerId="LiveId" clId="{D3337E6F-9E70-4B65-B42F-8091C9D37240}" dt="2023-10-23T01:03:20.037" v="202" actId="26606"/>
          <ac:cxnSpMkLst>
            <pc:docMk/>
            <pc:sldMk cId="930870485" sldId="291"/>
            <ac:cxnSpMk id="14" creationId="{AF9469B9-6468-5B6A-E832-8D4590388432}"/>
          </ac:cxnSpMkLst>
        </pc:cxnChg>
        <pc:cxnChg chg="add del">
          <ac:chgData name="Felipe Freitas" userId="754b0854625114a1" providerId="LiveId" clId="{D3337E6F-9E70-4B65-B42F-8091C9D37240}" dt="2023-10-23T01:03:20.037" v="202" actId="26606"/>
          <ac:cxnSpMkLst>
            <pc:docMk/>
            <pc:sldMk cId="930870485" sldId="291"/>
            <ac:cxnSpMk id="15" creationId="{192712F8-36FA-35DF-0CE8-4098D93322A3}"/>
          </ac:cxnSpMkLst>
        </pc:cxn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2289589653" sldId="291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2289589653" sldId="291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2087478390" sldId="292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2087478390" sldId="292"/>
            <ac:spMk id="12" creationId="{3B47FC9C-2ED3-4100-A4EF-E8CDFEE106C9}"/>
          </ac:spMkLst>
        </pc:spChg>
      </pc:sldChg>
      <pc:sldChg chg="addSp delSp modSp add del mod setBg modClrScheme delDesignElem chgLayout">
        <pc:chgData name="Felipe Freitas" userId="754b0854625114a1" providerId="LiveId" clId="{D3337E6F-9E70-4B65-B42F-8091C9D37240}" dt="2023-10-23T01:32:41.501" v="403" actId="47"/>
        <pc:sldMkLst>
          <pc:docMk/>
          <pc:sldMk cId="2191798547" sldId="292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2191798547" sldId="292"/>
            <ac:spMk id="2" creationId="{AB174FCF-100E-A371-E790-152B385F4A03}"/>
          </ac:spMkLst>
        </pc:spChg>
        <pc:spChg chg="del">
          <ac:chgData name="Felipe Freitas" userId="754b0854625114a1" providerId="LiveId" clId="{D3337E6F-9E70-4B65-B42F-8091C9D37240}" dt="2023-10-23T01:03:40.153" v="208"/>
          <ac:spMkLst>
            <pc:docMk/>
            <pc:sldMk cId="2191798547" sldId="292"/>
            <ac:spMk id="4" creationId="{E9BC88A5-DB02-0E71-74CC-952FDBCF96CE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2191798547" sldId="292"/>
            <ac:spMk id="8" creationId="{D6BA8A32-F833-4E76-A7EB-27327FAFED5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2191798547" sldId="292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2191798547" sldId="292"/>
            <ac:picMk id="5" creationId="{C421E868-79A8-113E-77E5-FBDB34F86FEF}"/>
          </ac:picMkLst>
        </pc:picChg>
        <pc:picChg chg="add mod">
          <ac:chgData name="Felipe Freitas" userId="754b0854625114a1" providerId="LiveId" clId="{D3337E6F-9E70-4B65-B42F-8091C9D37240}" dt="2023-10-23T01:03:41.368" v="209" actId="26606"/>
          <ac:picMkLst>
            <pc:docMk/>
            <pc:sldMk cId="2191798547" sldId="292"/>
            <ac:picMk id="7" creationId="{0087F55D-707C-BAAE-D7D6-F7D9D3F0D1B8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9:05.333" v="626" actId="1076"/>
        <pc:sldMkLst>
          <pc:docMk/>
          <pc:sldMk cId="1623943572" sldId="293"/>
        </pc:sldMkLst>
        <pc:spChg chg="mod ord">
          <ac:chgData name="Felipe Freitas" userId="754b0854625114a1" providerId="LiveId" clId="{D3337E6F-9E70-4B65-B42F-8091C9D37240}" dt="2023-10-23T01:42:49.950" v="519" actId="20577"/>
          <ac:spMkLst>
            <pc:docMk/>
            <pc:sldMk cId="1623943572" sldId="293"/>
            <ac:spMk id="2" creationId="{EACB5293-0FDD-271A-3B75-C1B547BCB875}"/>
          </ac:spMkLst>
        </pc:spChg>
        <pc:spChg chg="del">
          <ac:chgData name="Felipe Freitas" userId="754b0854625114a1" providerId="LiveId" clId="{D3337E6F-9E70-4B65-B42F-8091C9D37240}" dt="2023-10-23T01:03:48.989" v="210"/>
          <ac:spMkLst>
            <pc:docMk/>
            <pc:sldMk cId="1623943572" sldId="293"/>
            <ac:spMk id="4" creationId="{B110AADB-E0CF-EB3B-08E2-B1463C75B2B0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623943572" sldId="293"/>
            <ac:spMk id="8" creationId="{C18CC939-902C-DBA1-D5BF-6FB283D71537}"/>
          </ac:spMkLst>
        </pc:spChg>
        <pc:spChg chg="add mod">
          <ac:chgData name="Felipe Freitas" userId="754b0854625114a1" providerId="LiveId" clId="{D3337E6F-9E70-4B65-B42F-8091C9D37240}" dt="2023-10-23T01:46:45.926" v="591"/>
          <ac:spMkLst>
            <pc:docMk/>
            <pc:sldMk cId="1623943572" sldId="293"/>
            <ac:spMk id="9" creationId="{A5218E40-E50B-4856-1D43-132283D50569}"/>
          </ac:spMkLst>
        </pc:spChg>
        <pc:spChg chg="add mod">
          <ac:chgData name="Felipe Freitas" userId="754b0854625114a1" providerId="LiveId" clId="{D3337E6F-9E70-4B65-B42F-8091C9D37240}" dt="2023-10-23T01:46:45.926" v="591"/>
          <ac:spMkLst>
            <pc:docMk/>
            <pc:sldMk cId="1623943572" sldId="293"/>
            <ac:spMk id="10" creationId="{5DF19936-01B1-44A6-EA53-CD6B6B7D614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623943572" sldId="293"/>
            <ac:spMk id="12" creationId="{3B47FC9C-2ED3-4100-A4EF-E8CDFEE106C9}"/>
          </ac:spMkLst>
        </pc:spChg>
        <pc:picChg chg="add mod ord modCrop">
          <ac:chgData name="Felipe Freitas" userId="754b0854625114a1" providerId="LiveId" clId="{D3337E6F-9E70-4B65-B42F-8091C9D37240}" dt="2023-10-23T01:49:05.333" v="626" actId="1076"/>
          <ac:picMkLst>
            <pc:docMk/>
            <pc:sldMk cId="1623943572" sldId="293"/>
            <ac:picMk id="5" creationId="{5275395B-7D5A-B9C4-508C-BCF8C4610E11}"/>
          </ac:picMkLst>
        </pc:picChg>
        <pc:picChg chg="add mod">
          <ac:chgData name="Felipe Freitas" userId="754b0854625114a1" providerId="LiveId" clId="{D3337E6F-9E70-4B65-B42F-8091C9D37240}" dt="2023-10-23T01:49:03.596" v="625" actId="14100"/>
          <ac:picMkLst>
            <pc:docMk/>
            <pc:sldMk cId="1623943572" sldId="293"/>
            <ac:picMk id="7" creationId="{8C480A2B-FE97-988F-0706-C9DBB4E558F0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2992918898" sldId="293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2992918898" sldId="293"/>
            <ac:spMk id="12" creationId="{3B47FC9C-2ED3-4100-A4EF-E8CDFEE106C9}"/>
          </ac:spMkLst>
        </pc:spChg>
      </pc:sldChg>
      <pc:sldChg chg="addSp delSp modSp add mod setBg modClrScheme delDesignElem chgLayout">
        <pc:chgData name="Felipe Freitas" userId="754b0854625114a1" providerId="LiveId" clId="{D3337E6F-9E70-4B65-B42F-8091C9D37240}" dt="2023-10-23T01:48:20.194" v="620" actId="14100"/>
        <pc:sldMkLst>
          <pc:docMk/>
          <pc:sldMk cId="1527703325" sldId="294"/>
        </pc:sldMkLst>
        <pc:spChg chg="mod ord">
          <ac:chgData name="Felipe Freitas" userId="754b0854625114a1" providerId="LiveId" clId="{D3337E6F-9E70-4B65-B42F-8091C9D37240}" dt="2023-10-23T01:41:09.629" v="496" actId="255"/>
          <ac:spMkLst>
            <pc:docMk/>
            <pc:sldMk cId="1527703325" sldId="294"/>
            <ac:spMk id="2" creationId="{DFE2B4DC-A5C0-C8D3-C66E-836E85A60E93}"/>
          </ac:spMkLst>
        </pc:spChg>
        <pc:spChg chg="del">
          <ac:chgData name="Felipe Freitas" userId="754b0854625114a1" providerId="LiveId" clId="{D3337E6F-9E70-4B65-B42F-8091C9D37240}" dt="2023-10-23T01:04:00.422" v="212"/>
          <ac:spMkLst>
            <pc:docMk/>
            <pc:sldMk cId="1527703325" sldId="294"/>
            <ac:spMk id="4" creationId="{61792894-74E5-8B06-486D-08EA82925D0F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527703325" sldId="294"/>
            <ac:spMk id="8" creationId="{9B157DD4-21B5-185B-FF56-98B42FEB43CE}"/>
          </ac:spMkLst>
        </pc:spChg>
        <pc:spChg chg="add mod">
          <ac:chgData name="Felipe Freitas" userId="754b0854625114a1" providerId="LiveId" clId="{D3337E6F-9E70-4B65-B42F-8091C9D37240}" dt="2023-10-23T01:46:46.814" v="592"/>
          <ac:spMkLst>
            <pc:docMk/>
            <pc:sldMk cId="1527703325" sldId="294"/>
            <ac:spMk id="9" creationId="{B843246A-CB66-3A43-14D8-FF74E902F99C}"/>
          </ac:spMkLst>
        </pc:spChg>
        <pc:spChg chg="add mod">
          <ac:chgData name="Felipe Freitas" userId="754b0854625114a1" providerId="LiveId" clId="{D3337E6F-9E70-4B65-B42F-8091C9D37240}" dt="2023-10-23T01:46:46.814" v="592"/>
          <ac:spMkLst>
            <pc:docMk/>
            <pc:sldMk cId="1527703325" sldId="294"/>
            <ac:spMk id="10" creationId="{8E068424-97F5-7762-3A18-7CE9CE5FEBD9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527703325" sldId="294"/>
            <ac:spMk id="12" creationId="{3B47FC9C-2ED3-4100-A4EF-E8CDFEE106C9}"/>
          </ac:spMkLst>
        </pc:spChg>
        <pc:picChg chg="add mod ord modCrop">
          <ac:chgData name="Felipe Freitas" userId="754b0854625114a1" providerId="LiveId" clId="{D3337E6F-9E70-4B65-B42F-8091C9D37240}" dt="2023-10-23T01:48:17.188" v="619" actId="14100"/>
          <ac:picMkLst>
            <pc:docMk/>
            <pc:sldMk cId="1527703325" sldId="294"/>
            <ac:picMk id="5" creationId="{9E8861E2-C280-0E98-AF20-B923DBB882B3}"/>
          </ac:picMkLst>
        </pc:picChg>
        <pc:picChg chg="add mod">
          <ac:chgData name="Felipe Freitas" userId="754b0854625114a1" providerId="LiveId" clId="{D3337E6F-9E70-4B65-B42F-8091C9D37240}" dt="2023-10-23T01:48:20.194" v="620" actId="14100"/>
          <ac:picMkLst>
            <pc:docMk/>
            <pc:sldMk cId="1527703325" sldId="294"/>
            <ac:picMk id="7" creationId="{CEDD1250-F632-FC16-109A-0A3D619B15A5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1773924294" sldId="294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1773924294" sldId="294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436228077" sldId="295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436228077" sldId="295"/>
            <ac:spMk id="12" creationId="{3B47FC9C-2ED3-4100-A4EF-E8CDFEE106C9}"/>
          </ac:spMkLst>
        </pc:spChg>
      </pc:sldChg>
      <pc:sldChg chg="addSp delSp modSp add mod setBg modClrScheme delDesignElem chgLayout">
        <pc:chgData name="Felipe Freitas" userId="754b0854625114a1" providerId="LiveId" clId="{D3337E6F-9E70-4B65-B42F-8091C9D37240}" dt="2023-10-23T01:47:51.254" v="615" actId="14100"/>
        <pc:sldMkLst>
          <pc:docMk/>
          <pc:sldMk cId="3560760328" sldId="295"/>
        </pc:sldMkLst>
        <pc:spChg chg="mod ord">
          <ac:chgData name="Felipe Freitas" userId="754b0854625114a1" providerId="LiveId" clId="{D3337E6F-9E70-4B65-B42F-8091C9D37240}" dt="2023-10-23T01:42:39.503" v="518" actId="20577"/>
          <ac:spMkLst>
            <pc:docMk/>
            <pc:sldMk cId="3560760328" sldId="295"/>
            <ac:spMk id="2" creationId="{787BD46A-090E-645E-A58E-942DE8293721}"/>
          </ac:spMkLst>
        </pc:spChg>
        <pc:spChg chg="del">
          <ac:chgData name="Felipe Freitas" userId="754b0854625114a1" providerId="LiveId" clId="{D3337E6F-9E70-4B65-B42F-8091C9D37240}" dt="2023-10-23T01:04:08.373" v="214"/>
          <ac:spMkLst>
            <pc:docMk/>
            <pc:sldMk cId="3560760328" sldId="295"/>
            <ac:spMk id="4" creationId="{F75418F6-FEE1-6E31-5B4D-D6DEF3CBDAB3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560760328" sldId="295"/>
            <ac:spMk id="8" creationId="{87FA016E-266B-BAB9-FC53-24D633AF07F1}"/>
          </ac:spMkLst>
        </pc:spChg>
        <pc:spChg chg="add mod">
          <ac:chgData name="Felipe Freitas" userId="754b0854625114a1" providerId="LiveId" clId="{D3337E6F-9E70-4B65-B42F-8091C9D37240}" dt="2023-10-23T01:46:48.110" v="593"/>
          <ac:spMkLst>
            <pc:docMk/>
            <pc:sldMk cId="3560760328" sldId="295"/>
            <ac:spMk id="9" creationId="{6C2E8255-01E2-5ABB-31DF-1EBA322F3BD9}"/>
          </ac:spMkLst>
        </pc:spChg>
        <pc:spChg chg="add mod">
          <ac:chgData name="Felipe Freitas" userId="754b0854625114a1" providerId="LiveId" clId="{D3337E6F-9E70-4B65-B42F-8091C9D37240}" dt="2023-10-23T01:46:48.110" v="593"/>
          <ac:spMkLst>
            <pc:docMk/>
            <pc:sldMk cId="3560760328" sldId="295"/>
            <ac:spMk id="10" creationId="{17AF3D13-9CA3-6786-D7B7-449973527099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3560760328" sldId="295"/>
            <ac:spMk id="12" creationId="{3B47FC9C-2ED3-4100-A4EF-E8CDFEE106C9}"/>
          </ac:spMkLst>
        </pc:spChg>
        <pc:picChg chg="add mod ord modCrop">
          <ac:chgData name="Felipe Freitas" userId="754b0854625114a1" providerId="LiveId" clId="{D3337E6F-9E70-4B65-B42F-8091C9D37240}" dt="2023-10-23T01:47:51.254" v="615" actId="14100"/>
          <ac:picMkLst>
            <pc:docMk/>
            <pc:sldMk cId="3560760328" sldId="295"/>
            <ac:picMk id="5" creationId="{8F3583DB-2E6C-E074-813D-365273411E02}"/>
          </ac:picMkLst>
        </pc:picChg>
        <pc:picChg chg="add mod">
          <ac:chgData name="Felipe Freitas" userId="754b0854625114a1" providerId="LiveId" clId="{D3337E6F-9E70-4B65-B42F-8091C9D37240}" dt="2023-10-23T01:47:46.838" v="614" actId="14100"/>
          <ac:picMkLst>
            <pc:docMk/>
            <pc:sldMk cId="3560760328" sldId="295"/>
            <ac:picMk id="7" creationId="{0AD93B8D-C414-35B9-12CD-D3429B35E465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9:24.595" v="631" actId="1076"/>
        <pc:sldMkLst>
          <pc:docMk/>
          <pc:sldMk cId="619211182" sldId="296"/>
        </pc:sldMkLst>
        <pc:spChg chg="mod ord">
          <ac:chgData name="Felipe Freitas" userId="754b0854625114a1" providerId="LiveId" clId="{D3337E6F-9E70-4B65-B42F-8091C9D37240}" dt="2023-10-23T01:41:28.665" v="501" actId="27636"/>
          <ac:spMkLst>
            <pc:docMk/>
            <pc:sldMk cId="619211182" sldId="296"/>
            <ac:spMk id="2" creationId="{935EEDD6-8504-65CF-EEF6-E2DF9027F368}"/>
          </ac:spMkLst>
        </pc:spChg>
        <pc:spChg chg="del">
          <ac:chgData name="Felipe Freitas" userId="754b0854625114a1" providerId="LiveId" clId="{D3337E6F-9E70-4B65-B42F-8091C9D37240}" dt="2023-10-23T01:04:14.951" v="216"/>
          <ac:spMkLst>
            <pc:docMk/>
            <pc:sldMk cId="619211182" sldId="296"/>
            <ac:spMk id="4" creationId="{4795549C-DDD1-82C6-26F6-FA4A78D21CB3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619211182" sldId="296"/>
            <ac:spMk id="8" creationId="{13D127AC-317E-76CB-FB41-919275DD8433}"/>
          </ac:spMkLst>
        </pc:spChg>
        <pc:spChg chg="add mod">
          <ac:chgData name="Felipe Freitas" userId="754b0854625114a1" providerId="LiveId" clId="{D3337E6F-9E70-4B65-B42F-8091C9D37240}" dt="2023-10-23T01:46:48.963" v="594"/>
          <ac:spMkLst>
            <pc:docMk/>
            <pc:sldMk cId="619211182" sldId="296"/>
            <ac:spMk id="9" creationId="{62437F47-B92B-3811-7623-BD820ADA4868}"/>
          </ac:spMkLst>
        </pc:spChg>
        <pc:spChg chg="add mod">
          <ac:chgData name="Felipe Freitas" userId="754b0854625114a1" providerId="LiveId" clId="{D3337E6F-9E70-4B65-B42F-8091C9D37240}" dt="2023-10-23T01:46:48.963" v="594"/>
          <ac:spMkLst>
            <pc:docMk/>
            <pc:sldMk cId="619211182" sldId="296"/>
            <ac:spMk id="10" creationId="{DB800954-2AEF-3286-71FA-352DFA2439C0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619211182" sldId="296"/>
            <ac:spMk id="12" creationId="{3B47FC9C-2ED3-4100-A4EF-E8CDFEE106C9}"/>
          </ac:spMkLst>
        </pc:spChg>
        <pc:picChg chg="add mod ord modCrop">
          <ac:chgData name="Felipe Freitas" userId="754b0854625114a1" providerId="LiveId" clId="{D3337E6F-9E70-4B65-B42F-8091C9D37240}" dt="2023-10-23T01:49:24.595" v="631" actId="1076"/>
          <ac:picMkLst>
            <pc:docMk/>
            <pc:sldMk cId="619211182" sldId="296"/>
            <ac:picMk id="5" creationId="{B4DC64A7-E641-82EE-7C46-28044DBD4E7B}"/>
          </ac:picMkLst>
        </pc:picChg>
        <pc:picChg chg="add mod">
          <ac:chgData name="Felipe Freitas" userId="754b0854625114a1" providerId="LiveId" clId="{D3337E6F-9E70-4B65-B42F-8091C9D37240}" dt="2023-10-23T01:49:21.989" v="630" actId="14100"/>
          <ac:picMkLst>
            <pc:docMk/>
            <pc:sldMk cId="619211182" sldId="296"/>
            <ac:picMk id="7" creationId="{0C6B05E5-80AD-1E8D-A223-89135365E5FC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5.254" v="127"/>
        <pc:sldMkLst>
          <pc:docMk/>
          <pc:sldMk cId="2487770590" sldId="296"/>
        </pc:sldMkLst>
        <pc:spChg chg="add del">
          <ac:chgData name="Felipe Freitas" userId="754b0854625114a1" providerId="LiveId" clId="{D3337E6F-9E70-4B65-B42F-8091C9D37240}" dt="2023-10-23T00:58:35.254" v="127"/>
          <ac:spMkLst>
            <pc:docMk/>
            <pc:sldMk cId="2487770590" sldId="296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515430272" sldId="297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515430272" sldId="297"/>
            <ac:spMk id="12" creationId="{3B47FC9C-2ED3-4100-A4EF-E8CDFEE106C9}"/>
          </ac:spMkLst>
        </pc:sp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2004806392" sldId="297"/>
        </pc:sldMkLst>
        <pc:spChg chg="mod ord">
          <ac:chgData name="Felipe Freitas" userId="754b0854625114a1" providerId="LiveId" clId="{D3337E6F-9E70-4B65-B42F-8091C9D37240}" dt="2023-10-23T01:04:35.226" v="219" actId="26606"/>
          <ac:spMkLst>
            <pc:docMk/>
            <pc:sldMk cId="2004806392" sldId="297"/>
            <ac:spMk id="2" creationId="{65C11385-BCBC-4B11-63AB-7393A2B5B858}"/>
          </ac:spMkLst>
        </pc:spChg>
        <pc:spChg chg="del">
          <ac:chgData name="Felipe Freitas" userId="754b0854625114a1" providerId="LiveId" clId="{D3337E6F-9E70-4B65-B42F-8091C9D37240}" dt="2023-10-23T01:04:33.918" v="218"/>
          <ac:spMkLst>
            <pc:docMk/>
            <pc:sldMk cId="2004806392" sldId="297"/>
            <ac:spMk id="4" creationId="{D1D06267-0291-9C84-2411-B92CFCEA23E1}"/>
          </ac:spMkLst>
        </pc:spChg>
        <pc:spChg chg="add">
          <ac:chgData name="Felipe Freitas" userId="754b0854625114a1" providerId="LiveId" clId="{D3337E6F-9E70-4B65-B42F-8091C9D37240}" dt="2023-10-23T01:04:35.226" v="219" actId="26606"/>
          <ac:spMkLst>
            <pc:docMk/>
            <pc:sldMk cId="2004806392" sldId="297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4:35.226" v="219" actId="26606"/>
          <ac:picMkLst>
            <pc:docMk/>
            <pc:sldMk cId="2004806392" sldId="297"/>
            <ac:picMk id="5" creationId="{CF12710D-7BD4-BDC6-AE22-9A10D3F28B13}"/>
          </ac:picMkLst>
        </pc:picChg>
        <pc:picChg chg="add mod">
          <ac:chgData name="Felipe Freitas" userId="754b0854625114a1" providerId="LiveId" clId="{D3337E6F-9E70-4B65-B42F-8091C9D37240}" dt="2023-10-23T01:04:35.226" v="219" actId="26606"/>
          <ac:picMkLst>
            <pc:docMk/>
            <pc:sldMk cId="2004806392" sldId="297"/>
            <ac:picMk id="7" creationId="{D414B466-8D21-4D35-3081-A36F712B4861}"/>
          </ac:picMkLst>
        </pc:pic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663718904" sldId="298"/>
        </pc:sldMkLst>
        <pc:spChg chg="mod">
          <ac:chgData name="Felipe Freitas" userId="754b0854625114a1" providerId="LiveId" clId="{D3337E6F-9E70-4B65-B42F-8091C9D37240}" dt="2023-10-23T01:09:19.109" v="262" actId="26606"/>
          <ac:spMkLst>
            <pc:docMk/>
            <pc:sldMk cId="663718904" sldId="298"/>
            <ac:spMk id="2" creationId="{25507AD8-5769-1871-C2E3-8F2F5709A2E1}"/>
          </ac:spMkLst>
        </pc:spChg>
        <pc:spChg chg="del">
          <ac:chgData name="Felipe Freitas" userId="754b0854625114a1" providerId="LiveId" clId="{D3337E6F-9E70-4B65-B42F-8091C9D37240}" dt="2023-10-23T01:04:41.998" v="220"/>
          <ac:spMkLst>
            <pc:docMk/>
            <pc:sldMk cId="663718904" sldId="298"/>
            <ac:spMk id="4" creationId="{F2FFCBE5-0B62-38E2-DDD8-427558A77C0F}"/>
          </ac:spMkLst>
        </pc:spChg>
        <pc:picChg chg="add mod">
          <ac:chgData name="Felipe Freitas" userId="754b0854625114a1" providerId="LiveId" clId="{D3337E6F-9E70-4B65-B42F-8091C9D37240}" dt="2023-10-23T01:09:19.109" v="262" actId="26606"/>
          <ac:picMkLst>
            <pc:docMk/>
            <pc:sldMk cId="663718904" sldId="298"/>
            <ac:picMk id="5" creationId="{1896D14A-F4DF-5FFB-38B5-6CE01B9D139C}"/>
          </ac:picMkLst>
        </pc:picChg>
        <pc:picChg chg="add mod">
          <ac:chgData name="Felipe Freitas" userId="754b0854625114a1" providerId="LiveId" clId="{D3337E6F-9E70-4B65-B42F-8091C9D37240}" dt="2023-10-23T01:09:19.109" v="262" actId="26606"/>
          <ac:picMkLst>
            <pc:docMk/>
            <pc:sldMk cId="663718904" sldId="298"/>
            <ac:picMk id="7" creationId="{EECE2A8D-9D36-8885-4E1D-BD01C7471BD9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2740501489" sldId="298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2740501489" sldId="298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376659677" sldId="299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376659677" sldId="299"/>
            <ac:spMk id="12" creationId="{3B47FC9C-2ED3-4100-A4EF-E8CDFEE106C9}"/>
          </ac:spMkLst>
        </pc:sp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1045596276" sldId="299"/>
        </pc:sldMkLst>
        <pc:spChg chg="ord">
          <ac:chgData name="Felipe Freitas" userId="754b0854625114a1" providerId="LiveId" clId="{D3337E6F-9E70-4B65-B42F-8091C9D37240}" dt="2023-10-23T01:04:50.892" v="222" actId="26606"/>
          <ac:spMkLst>
            <pc:docMk/>
            <pc:sldMk cId="1045596276" sldId="299"/>
            <ac:spMk id="2" creationId="{AB174FCF-100E-A371-E790-152B385F4A03}"/>
          </ac:spMkLst>
        </pc:spChg>
        <pc:spChg chg="del">
          <ac:chgData name="Felipe Freitas" userId="754b0854625114a1" providerId="LiveId" clId="{D3337E6F-9E70-4B65-B42F-8091C9D37240}" dt="2023-10-23T01:04:49.744" v="221"/>
          <ac:spMkLst>
            <pc:docMk/>
            <pc:sldMk cId="1045596276" sldId="299"/>
            <ac:spMk id="4" creationId="{E9BC88A5-DB02-0E71-74CC-952FDBCF96CE}"/>
          </ac:spMkLst>
        </pc:spChg>
        <pc:spChg chg="add">
          <ac:chgData name="Felipe Freitas" userId="754b0854625114a1" providerId="LiveId" clId="{D3337E6F-9E70-4B65-B42F-8091C9D37240}" dt="2023-10-23T01:04:50.892" v="222" actId="26606"/>
          <ac:spMkLst>
            <pc:docMk/>
            <pc:sldMk cId="1045596276" sldId="299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4:50.892" v="222" actId="26606"/>
          <ac:picMkLst>
            <pc:docMk/>
            <pc:sldMk cId="1045596276" sldId="299"/>
            <ac:picMk id="5" creationId="{B34E6548-173E-B27D-18E0-535F109F2334}"/>
          </ac:picMkLst>
        </pc:picChg>
        <pc:picChg chg="add mod">
          <ac:chgData name="Felipe Freitas" userId="754b0854625114a1" providerId="LiveId" clId="{D3337E6F-9E70-4B65-B42F-8091C9D37240}" dt="2023-10-23T01:04:50.892" v="222" actId="26606"/>
          <ac:picMkLst>
            <pc:docMk/>
            <pc:sldMk cId="1045596276" sldId="299"/>
            <ac:picMk id="7" creationId="{1BEEC3ED-9614-8A83-E927-FD70066C4783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1654808291" sldId="300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1654808291" sldId="300"/>
            <ac:spMk id="12" creationId="{3B47FC9C-2ED3-4100-A4EF-E8CDFEE106C9}"/>
          </ac:spMkLst>
        </pc:sp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3523566229" sldId="300"/>
        </pc:sldMkLst>
        <pc:spChg chg="ord">
          <ac:chgData name="Felipe Freitas" userId="754b0854625114a1" providerId="LiveId" clId="{D3337E6F-9E70-4B65-B42F-8091C9D37240}" dt="2023-10-23T01:04:58.776" v="224" actId="26606"/>
          <ac:spMkLst>
            <pc:docMk/>
            <pc:sldMk cId="3523566229" sldId="300"/>
            <ac:spMk id="2" creationId="{EACB5293-0FDD-271A-3B75-C1B547BCB875}"/>
          </ac:spMkLst>
        </pc:spChg>
        <pc:spChg chg="del">
          <ac:chgData name="Felipe Freitas" userId="754b0854625114a1" providerId="LiveId" clId="{D3337E6F-9E70-4B65-B42F-8091C9D37240}" dt="2023-10-23T01:04:56.847" v="223"/>
          <ac:spMkLst>
            <pc:docMk/>
            <pc:sldMk cId="3523566229" sldId="300"/>
            <ac:spMk id="4" creationId="{B110AADB-E0CF-EB3B-08E2-B1463C75B2B0}"/>
          </ac:spMkLst>
        </pc:spChg>
        <pc:spChg chg="add">
          <ac:chgData name="Felipe Freitas" userId="754b0854625114a1" providerId="LiveId" clId="{D3337E6F-9E70-4B65-B42F-8091C9D37240}" dt="2023-10-23T01:04:58.776" v="224" actId="26606"/>
          <ac:spMkLst>
            <pc:docMk/>
            <pc:sldMk cId="3523566229" sldId="300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4:58.776" v="224" actId="26606"/>
          <ac:picMkLst>
            <pc:docMk/>
            <pc:sldMk cId="3523566229" sldId="300"/>
            <ac:picMk id="5" creationId="{73353916-A77B-E910-CB01-030DEA94F86F}"/>
          </ac:picMkLst>
        </pc:picChg>
        <pc:picChg chg="add mod">
          <ac:chgData name="Felipe Freitas" userId="754b0854625114a1" providerId="LiveId" clId="{D3337E6F-9E70-4B65-B42F-8091C9D37240}" dt="2023-10-23T01:04:58.776" v="224" actId="26606"/>
          <ac:picMkLst>
            <pc:docMk/>
            <pc:sldMk cId="3523566229" sldId="300"/>
            <ac:picMk id="7" creationId="{F887DC14-31C0-0D6F-EEB4-460770E03944}"/>
          </ac:picMkLst>
        </pc:pic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292060917" sldId="301"/>
        </pc:sldMkLst>
        <pc:spChg chg="ord">
          <ac:chgData name="Felipe Freitas" userId="754b0854625114a1" providerId="LiveId" clId="{D3337E6F-9E70-4B65-B42F-8091C9D37240}" dt="2023-10-23T01:05:05.246" v="226" actId="26606"/>
          <ac:spMkLst>
            <pc:docMk/>
            <pc:sldMk cId="292060917" sldId="301"/>
            <ac:spMk id="2" creationId="{DFE2B4DC-A5C0-C8D3-C66E-836E85A60E93}"/>
          </ac:spMkLst>
        </pc:spChg>
        <pc:spChg chg="del">
          <ac:chgData name="Felipe Freitas" userId="754b0854625114a1" providerId="LiveId" clId="{D3337E6F-9E70-4B65-B42F-8091C9D37240}" dt="2023-10-23T01:05:03.496" v="225"/>
          <ac:spMkLst>
            <pc:docMk/>
            <pc:sldMk cId="292060917" sldId="301"/>
            <ac:spMk id="4" creationId="{61792894-74E5-8B06-486D-08EA82925D0F}"/>
          </ac:spMkLst>
        </pc:spChg>
        <pc:spChg chg="add">
          <ac:chgData name="Felipe Freitas" userId="754b0854625114a1" providerId="LiveId" clId="{D3337E6F-9E70-4B65-B42F-8091C9D37240}" dt="2023-10-23T01:05:05.246" v="226" actId="26606"/>
          <ac:spMkLst>
            <pc:docMk/>
            <pc:sldMk cId="292060917" sldId="301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5:05.246" v="226" actId="26606"/>
          <ac:picMkLst>
            <pc:docMk/>
            <pc:sldMk cId="292060917" sldId="301"/>
            <ac:picMk id="5" creationId="{27790F52-1967-8A55-F261-FFED98D93D56}"/>
          </ac:picMkLst>
        </pc:picChg>
        <pc:picChg chg="add mod">
          <ac:chgData name="Felipe Freitas" userId="754b0854625114a1" providerId="LiveId" clId="{D3337E6F-9E70-4B65-B42F-8091C9D37240}" dt="2023-10-23T01:05:05.246" v="226" actId="26606"/>
          <ac:picMkLst>
            <pc:docMk/>
            <pc:sldMk cId="292060917" sldId="301"/>
            <ac:picMk id="7" creationId="{7811CC95-3BE0-E1F0-9F4F-FD0FBE807E63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2629243660" sldId="301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2629243660" sldId="301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108765473" sldId="302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108765473" sldId="302"/>
            <ac:spMk id="12" creationId="{3B47FC9C-2ED3-4100-A4EF-E8CDFEE106C9}"/>
          </ac:spMkLst>
        </pc:sp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2193577529" sldId="302"/>
        </pc:sldMkLst>
        <pc:spChg chg="ord">
          <ac:chgData name="Felipe Freitas" userId="754b0854625114a1" providerId="LiveId" clId="{D3337E6F-9E70-4B65-B42F-8091C9D37240}" dt="2023-10-23T01:05:11.511" v="228" actId="26606"/>
          <ac:spMkLst>
            <pc:docMk/>
            <pc:sldMk cId="2193577529" sldId="302"/>
            <ac:spMk id="2" creationId="{787BD46A-090E-645E-A58E-942DE8293721}"/>
          </ac:spMkLst>
        </pc:spChg>
        <pc:spChg chg="del">
          <ac:chgData name="Felipe Freitas" userId="754b0854625114a1" providerId="LiveId" clId="{D3337E6F-9E70-4B65-B42F-8091C9D37240}" dt="2023-10-23T01:05:10.110" v="227"/>
          <ac:spMkLst>
            <pc:docMk/>
            <pc:sldMk cId="2193577529" sldId="302"/>
            <ac:spMk id="4" creationId="{F75418F6-FEE1-6E31-5B4D-D6DEF3CBDAB3}"/>
          </ac:spMkLst>
        </pc:spChg>
        <pc:spChg chg="add">
          <ac:chgData name="Felipe Freitas" userId="754b0854625114a1" providerId="LiveId" clId="{D3337E6F-9E70-4B65-B42F-8091C9D37240}" dt="2023-10-23T01:05:11.511" v="228" actId="26606"/>
          <ac:spMkLst>
            <pc:docMk/>
            <pc:sldMk cId="2193577529" sldId="302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5:11.511" v="228" actId="26606"/>
          <ac:picMkLst>
            <pc:docMk/>
            <pc:sldMk cId="2193577529" sldId="302"/>
            <ac:picMk id="5" creationId="{4BEED8C1-445C-6CD8-23C1-80F80D414B3B}"/>
          </ac:picMkLst>
        </pc:picChg>
        <pc:picChg chg="add mod">
          <ac:chgData name="Felipe Freitas" userId="754b0854625114a1" providerId="LiveId" clId="{D3337E6F-9E70-4B65-B42F-8091C9D37240}" dt="2023-10-23T01:05:11.511" v="228" actId="26606"/>
          <ac:picMkLst>
            <pc:docMk/>
            <pc:sldMk cId="2193577529" sldId="302"/>
            <ac:picMk id="7" creationId="{7F18D8C7-1423-7A24-D584-412C977305EA}"/>
          </ac:picMkLst>
        </pc:picChg>
      </pc:sldChg>
      <pc:sldChg chg="addSp delSp add del setBg delDesignElem">
        <pc:chgData name="Felipe Freitas" userId="754b0854625114a1" providerId="LiveId" clId="{D3337E6F-9E70-4B65-B42F-8091C9D37240}" dt="2023-10-23T00:58:34.643" v="126"/>
        <pc:sldMkLst>
          <pc:docMk/>
          <pc:sldMk cId="3878603632" sldId="303"/>
        </pc:sldMkLst>
        <pc:spChg chg="add del">
          <ac:chgData name="Felipe Freitas" userId="754b0854625114a1" providerId="LiveId" clId="{D3337E6F-9E70-4B65-B42F-8091C9D37240}" dt="2023-10-23T00:58:34.643" v="126"/>
          <ac:spMkLst>
            <pc:docMk/>
            <pc:sldMk cId="3878603632" sldId="303"/>
            <ac:spMk id="12" creationId="{3B47FC9C-2ED3-4100-A4EF-E8CDFEE106C9}"/>
          </ac:spMkLst>
        </pc:spChg>
      </pc:sldChg>
      <pc:sldChg chg="addSp delSp modSp add del mod setBg">
        <pc:chgData name="Felipe Freitas" userId="754b0854625114a1" providerId="LiveId" clId="{D3337E6F-9E70-4B65-B42F-8091C9D37240}" dt="2023-10-23T01:11:11.669" v="264" actId="47"/>
        <pc:sldMkLst>
          <pc:docMk/>
          <pc:sldMk cId="4203671523" sldId="303"/>
        </pc:sldMkLst>
        <pc:spChg chg="mod ord">
          <ac:chgData name="Felipe Freitas" userId="754b0854625114a1" providerId="LiveId" clId="{D3337E6F-9E70-4B65-B42F-8091C9D37240}" dt="2023-10-23T01:05:20.382" v="230" actId="26606"/>
          <ac:spMkLst>
            <pc:docMk/>
            <pc:sldMk cId="4203671523" sldId="303"/>
            <ac:spMk id="2" creationId="{935EEDD6-8504-65CF-EEF6-E2DF9027F368}"/>
          </ac:spMkLst>
        </pc:spChg>
        <pc:spChg chg="del">
          <ac:chgData name="Felipe Freitas" userId="754b0854625114a1" providerId="LiveId" clId="{D3337E6F-9E70-4B65-B42F-8091C9D37240}" dt="2023-10-23T01:05:19.086" v="229"/>
          <ac:spMkLst>
            <pc:docMk/>
            <pc:sldMk cId="4203671523" sldId="303"/>
            <ac:spMk id="4" creationId="{4795549C-DDD1-82C6-26F6-FA4A78D21CB3}"/>
          </ac:spMkLst>
        </pc:spChg>
        <pc:spChg chg="add">
          <ac:chgData name="Felipe Freitas" userId="754b0854625114a1" providerId="LiveId" clId="{D3337E6F-9E70-4B65-B42F-8091C9D37240}" dt="2023-10-23T01:05:20.382" v="230" actId="26606"/>
          <ac:spMkLst>
            <pc:docMk/>
            <pc:sldMk cId="4203671523" sldId="303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05:20.382" v="230" actId="26606"/>
          <ac:picMkLst>
            <pc:docMk/>
            <pc:sldMk cId="4203671523" sldId="303"/>
            <ac:picMk id="5" creationId="{1FA5D598-830C-078B-6943-50D8D50BF2A9}"/>
          </ac:picMkLst>
        </pc:picChg>
        <pc:picChg chg="add mod">
          <ac:chgData name="Felipe Freitas" userId="754b0854625114a1" providerId="LiveId" clId="{D3337E6F-9E70-4B65-B42F-8091C9D37240}" dt="2023-10-23T01:05:20.382" v="230" actId="26606"/>
          <ac:picMkLst>
            <pc:docMk/>
            <pc:sldMk cId="4203671523" sldId="303"/>
            <ac:picMk id="7" creationId="{C8F401D5-EA1A-4F47-AF92-AC3F1357C00F}"/>
          </ac:picMkLst>
        </pc:picChg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1352647519" sldId="304"/>
        </pc:sldMkLst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1951063453" sldId="304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1951063453" sldId="304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44723647" sldId="305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44723647" sldId="305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1940997790" sldId="305"/>
        </pc:sldMkLst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3265935767" sldId="306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3265935767" sldId="306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3270671985" sldId="306"/>
        </pc:sldMkLst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1315124290" sldId="307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1315124290" sldId="307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1864369729" sldId="307"/>
        </pc:sldMkLst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957277778" sldId="308"/>
        </pc:sldMkLst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3020941122" sldId="308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3020941122" sldId="308"/>
            <ac:spMk id="12" creationId="{3B47FC9C-2ED3-4100-A4EF-E8CDFEE106C9}"/>
          </ac:spMkLst>
        </pc:spChg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1928442262" sldId="309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1928442262" sldId="309"/>
            <ac:spMk id="12" creationId="{3B47FC9C-2ED3-4100-A4EF-E8CDFEE106C9}"/>
          </ac:spMkLst>
        </pc:spChg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2029826457" sldId="309"/>
        </pc:sldMkLst>
      </pc:sldChg>
      <pc:sldChg chg="add del">
        <pc:chgData name="Felipe Freitas" userId="754b0854625114a1" providerId="LiveId" clId="{D3337E6F-9E70-4B65-B42F-8091C9D37240}" dt="2023-10-23T01:00:18.668" v="167" actId="47"/>
        <pc:sldMkLst>
          <pc:docMk/>
          <pc:sldMk cId="346391631" sldId="310"/>
        </pc:sldMkLst>
      </pc:sldChg>
      <pc:sldChg chg="addSp delSp add del setBg delDesignElem">
        <pc:chgData name="Felipe Freitas" userId="754b0854625114a1" providerId="LiveId" clId="{D3337E6F-9E70-4B65-B42F-8091C9D37240}" dt="2023-10-23T00:58:33.545" v="124"/>
        <pc:sldMkLst>
          <pc:docMk/>
          <pc:sldMk cId="1447997413" sldId="310"/>
        </pc:sldMkLst>
        <pc:spChg chg="add del">
          <ac:chgData name="Felipe Freitas" userId="754b0854625114a1" providerId="LiveId" clId="{D3337E6F-9E70-4B65-B42F-8091C9D37240}" dt="2023-10-23T00:58:33.545" v="124"/>
          <ac:spMkLst>
            <pc:docMk/>
            <pc:sldMk cId="1447997413" sldId="310"/>
            <ac:spMk id="12" creationId="{3B47FC9C-2ED3-4100-A4EF-E8CDFEE106C9}"/>
          </ac:spMkLst>
        </pc:spChg>
      </pc:sldChg>
      <pc:sldChg chg="addSp delSp modSp add mod setBg modClrScheme delDesignElem chgLayout">
        <pc:chgData name="Felipe Freitas" userId="754b0854625114a1" providerId="LiveId" clId="{D3337E6F-9E70-4B65-B42F-8091C9D37240}" dt="2023-10-23T01:46:51.207" v="595"/>
        <pc:sldMkLst>
          <pc:docMk/>
          <pc:sldMk cId="328495122" sldId="311"/>
        </pc:sldMkLst>
        <pc:spChg chg="mod ord">
          <ac:chgData name="Felipe Freitas" userId="754b0854625114a1" providerId="LiveId" clId="{D3337E6F-9E70-4B65-B42F-8091C9D37240}" dt="2023-10-23T01:42:33.879" v="517" actId="20577"/>
          <ac:spMkLst>
            <pc:docMk/>
            <pc:sldMk cId="328495122" sldId="311"/>
            <ac:spMk id="2" creationId="{65C11385-BCBC-4B11-63AB-7393A2B5B858}"/>
          </ac:spMkLst>
        </pc:spChg>
        <pc:spChg chg="del">
          <ac:chgData name="Felipe Freitas" userId="754b0854625114a1" providerId="LiveId" clId="{D3337E6F-9E70-4B65-B42F-8091C9D37240}" dt="2023-10-23T01:06:46.794" v="234"/>
          <ac:spMkLst>
            <pc:docMk/>
            <pc:sldMk cId="328495122" sldId="311"/>
            <ac:spMk id="4" creationId="{D1D06267-0291-9C84-2411-B92CFCEA23E1}"/>
          </ac:spMkLst>
        </pc:spChg>
        <pc:spChg chg="add del mod">
          <ac:chgData name="Felipe Freitas" userId="754b0854625114a1" providerId="LiveId" clId="{D3337E6F-9E70-4B65-B42F-8091C9D37240}" dt="2023-10-23T01:12:29.167" v="266"/>
          <ac:spMkLst>
            <pc:docMk/>
            <pc:sldMk cId="328495122" sldId="311"/>
            <ac:spMk id="9" creationId="{FF6E3F4D-21D0-EDF7-ADCF-8D741E89630D}"/>
          </ac:spMkLst>
        </pc:spChg>
        <pc:spChg chg="add del">
          <ac:chgData name="Felipe Freitas" userId="754b0854625114a1" providerId="LiveId" clId="{D3337E6F-9E70-4B65-B42F-8091C9D37240}" dt="2023-10-23T01:12:31.215" v="267" actId="26606"/>
          <ac:spMkLst>
            <pc:docMk/>
            <pc:sldMk cId="328495122" sldId="311"/>
            <ac:spMk id="12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13:51.024" v="283"/>
          <ac:spMkLst>
            <pc:docMk/>
            <pc:sldMk cId="328495122" sldId="311"/>
            <ac:spMk id="16" creationId="{228995AC-DF10-22DD-7012-DDEB77222740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28495122" sldId="311"/>
            <ac:spMk id="21" creationId="{47A983A6-E746-6534-E3F1-6837DF5BD018}"/>
          </ac:spMkLst>
        </pc:spChg>
        <pc:spChg chg="add mod">
          <ac:chgData name="Felipe Freitas" userId="754b0854625114a1" providerId="LiveId" clId="{D3337E6F-9E70-4B65-B42F-8091C9D37240}" dt="2023-10-23T01:46:51.207" v="595"/>
          <ac:spMkLst>
            <pc:docMk/>
            <pc:sldMk cId="328495122" sldId="311"/>
            <ac:spMk id="22" creationId="{3ED77D3F-7E25-182A-BE5D-E44808C5EA38}"/>
          </ac:spMkLst>
        </pc:spChg>
        <pc:spChg chg="add mod">
          <ac:chgData name="Felipe Freitas" userId="754b0854625114a1" providerId="LiveId" clId="{D3337E6F-9E70-4B65-B42F-8091C9D37240}" dt="2023-10-23T01:46:51.207" v="595"/>
          <ac:spMkLst>
            <pc:docMk/>
            <pc:sldMk cId="328495122" sldId="311"/>
            <ac:spMk id="23" creationId="{60943290-EBA1-2AFF-601A-C339DC9096D8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328495122" sldId="311"/>
            <ac:spMk id="25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12:24.309" v="265" actId="478"/>
          <ac:picMkLst>
            <pc:docMk/>
            <pc:sldMk cId="328495122" sldId="311"/>
            <ac:picMk id="5" creationId="{C10827C3-43FF-1D5C-4634-539E48BB8B5C}"/>
          </ac:picMkLst>
        </pc:picChg>
        <pc:picChg chg="add del mod">
          <ac:chgData name="Felipe Freitas" userId="754b0854625114a1" providerId="LiveId" clId="{D3337E6F-9E70-4B65-B42F-8091C9D37240}" dt="2023-10-23T01:12:24.309" v="265" actId="478"/>
          <ac:picMkLst>
            <pc:docMk/>
            <pc:sldMk cId="328495122" sldId="311"/>
            <ac:picMk id="7" creationId="{131C0AB6-276D-A9DB-6FCE-5F661921F669}"/>
          </ac:picMkLst>
        </pc:picChg>
        <pc:picChg chg="add del mod ord">
          <ac:chgData name="Felipe Freitas" userId="754b0854625114a1" providerId="LiveId" clId="{D3337E6F-9E70-4B65-B42F-8091C9D37240}" dt="2023-10-23T01:13:38.388" v="282" actId="478"/>
          <ac:picMkLst>
            <pc:docMk/>
            <pc:sldMk cId="328495122" sldId="311"/>
            <ac:picMk id="11" creationId="{351E8853-893F-C4BE-6AE7-2BB485F9DA51}"/>
          </ac:picMkLst>
        </pc:picChg>
        <pc:picChg chg="add del mod">
          <ac:chgData name="Felipe Freitas" userId="754b0854625114a1" providerId="LiveId" clId="{D3337E6F-9E70-4B65-B42F-8091C9D37240}" dt="2023-10-23T01:13:38.388" v="282" actId="478"/>
          <ac:picMkLst>
            <pc:docMk/>
            <pc:sldMk cId="328495122" sldId="311"/>
            <ac:picMk id="14" creationId="{EA4CB31C-9077-F4E2-69FC-8F38241791D8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328495122" sldId="311"/>
            <ac:picMk id="18" creationId="{191A1C16-F508-5BD4-CD58-723C94A1E31B}"/>
          </ac:picMkLst>
        </pc:picChg>
        <pc:picChg chg="add mod">
          <ac:chgData name="Felipe Freitas" userId="754b0854625114a1" providerId="LiveId" clId="{D3337E6F-9E70-4B65-B42F-8091C9D37240}" dt="2023-10-23T01:13:53.437" v="284" actId="26606"/>
          <ac:picMkLst>
            <pc:docMk/>
            <pc:sldMk cId="328495122" sldId="311"/>
            <ac:picMk id="20" creationId="{079EE610-06CE-13E0-FC3F-7CB5ECC9B2BA}"/>
          </ac:picMkLst>
        </pc:picChg>
      </pc:sldChg>
      <pc:sldChg chg="addSp delSp modSp add del mod setBg modClrScheme delDesignElem chgLayout">
        <pc:chgData name="Felipe Freitas" userId="754b0854625114a1" providerId="LiveId" clId="{D3337E6F-9E70-4B65-B42F-8091C9D37240}" dt="2023-10-23T01:32:44.070" v="404" actId="47"/>
        <pc:sldMkLst>
          <pc:docMk/>
          <pc:sldMk cId="4192118212" sldId="312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4192118212" sldId="312"/>
            <ac:spMk id="2" creationId="{25507AD8-5769-1871-C2E3-8F2F5709A2E1}"/>
          </ac:spMkLst>
        </pc:spChg>
        <pc:spChg chg="del">
          <ac:chgData name="Felipe Freitas" userId="754b0854625114a1" providerId="LiveId" clId="{D3337E6F-9E70-4B65-B42F-8091C9D37240}" dt="2023-10-23T01:06:55.032" v="236"/>
          <ac:spMkLst>
            <pc:docMk/>
            <pc:sldMk cId="4192118212" sldId="312"/>
            <ac:spMk id="4" creationId="{F2FFCBE5-0B62-38E2-DDD8-427558A77C0F}"/>
          </ac:spMkLst>
        </pc:spChg>
        <pc:spChg chg="add del mod">
          <ac:chgData name="Felipe Freitas" userId="754b0854625114a1" providerId="LiveId" clId="{D3337E6F-9E70-4B65-B42F-8091C9D37240}" dt="2023-10-23T01:13:22.832" v="278"/>
          <ac:spMkLst>
            <pc:docMk/>
            <pc:sldMk cId="4192118212" sldId="312"/>
            <ac:spMk id="9" creationId="{17D02059-5235-5F6F-D45A-177C54E6E937}"/>
          </ac:spMkLst>
        </pc:spChg>
        <pc:spChg chg="add del">
          <ac:chgData name="Felipe Freitas" userId="754b0854625114a1" providerId="LiveId" clId="{D3337E6F-9E70-4B65-B42F-8091C9D37240}" dt="2023-10-23T01:13:24.892" v="279" actId="26606"/>
          <ac:spMkLst>
            <pc:docMk/>
            <pc:sldMk cId="4192118212" sldId="312"/>
            <ac:spMk id="12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192118212" sldId="312"/>
            <ac:spMk id="19" creationId="{EB38D2F7-E003-C431-4B73-B7EDB6E7B697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192118212" sldId="312"/>
            <ac:spMk id="23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12:46.439" v="268" actId="478"/>
          <ac:picMkLst>
            <pc:docMk/>
            <pc:sldMk cId="4192118212" sldId="312"/>
            <ac:picMk id="5" creationId="{6D125163-9EFA-C8E9-AE48-C2C8E5A9DC46}"/>
          </ac:picMkLst>
        </pc:picChg>
        <pc:picChg chg="add del mod">
          <ac:chgData name="Felipe Freitas" userId="754b0854625114a1" providerId="LiveId" clId="{D3337E6F-9E70-4B65-B42F-8091C9D37240}" dt="2023-10-23T01:12:46.439" v="268" actId="478"/>
          <ac:picMkLst>
            <pc:docMk/>
            <pc:sldMk cId="4192118212" sldId="312"/>
            <ac:picMk id="7" creationId="{F149E1E4-94E6-83A5-BD04-D739797CE9B3}"/>
          </ac:picMkLst>
        </pc:picChg>
        <pc:picChg chg="add del mod ord">
          <ac:chgData name="Felipe Freitas" userId="754b0854625114a1" providerId="LiveId" clId="{D3337E6F-9E70-4B65-B42F-8091C9D37240}" dt="2023-10-23T01:13:18.603" v="277"/>
          <ac:picMkLst>
            <pc:docMk/>
            <pc:sldMk cId="4192118212" sldId="312"/>
            <ac:picMk id="11" creationId="{1028352B-0821-6160-F1E8-BA98DDD82ECA}"/>
          </ac:picMkLst>
        </pc:picChg>
        <pc:picChg chg="add del mod">
          <ac:chgData name="Felipe Freitas" userId="754b0854625114a1" providerId="LiveId" clId="{D3337E6F-9E70-4B65-B42F-8091C9D37240}" dt="2023-10-23T01:13:18.603" v="277"/>
          <ac:picMkLst>
            <pc:docMk/>
            <pc:sldMk cId="4192118212" sldId="312"/>
            <ac:picMk id="14" creationId="{E00A7C1F-44E0-D66E-D7E4-D48D5ECD44CE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192118212" sldId="312"/>
            <ac:picMk id="16" creationId="{EBBF0581-1AB1-F86F-9776-FFBE0912E03F}"/>
          </ac:picMkLst>
        </pc:picChg>
        <pc:picChg chg="add mod">
          <ac:chgData name="Felipe Freitas" userId="754b0854625114a1" providerId="LiveId" clId="{D3337E6F-9E70-4B65-B42F-8091C9D37240}" dt="2023-10-23T01:13:24.892" v="279" actId="26606"/>
          <ac:picMkLst>
            <pc:docMk/>
            <pc:sldMk cId="4192118212" sldId="312"/>
            <ac:picMk id="18" creationId="{935105BB-BF27-DD30-174B-49A5C9295F30}"/>
          </ac:picMkLst>
        </pc:picChg>
      </pc:sldChg>
      <pc:sldChg chg="addSp delSp modSp add del mod setBg modClrScheme delDesignElem chgLayout">
        <pc:chgData name="Felipe Freitas" userId="754b0854625114a1" providerId="LiveId" clId="{D3337E6F-9E70-4B65-B42F-8091C9D37240}" dt="2023-10-23T01:32:46.468" v="405" actId="47"/>
        <pc:sldMkLst>
          <pc:docMk/>
          <pc:sldMk cId="152488700" sldId="313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152488700" sldId="313"/>
            <ac:spMk id="2" creationId="{AB174FCF-100E-A371-E790-152B385F4A03}"/>
          </ac:spMkLst>
        </pc:spChg>
        <pc:spChg chg="del">
          <ac:chgData name="Felipe Freitas" userId="754b0854625114a1" providerId="LiveId" clId="{D3337E6F-9E70-4B65-B42F-8091C9D37240}" dt="2023-10-23T01:07:08.479" v="238"/>
          <ac:spMkLst>
            <pc:docMk/>
            <pc:sldMk cId="152488700" sldId="313"/>
            <ac:spMk id="4" creationId="{E9BC88A5-DB02-0E71-74CC-952FDBCF96CE}"/>
          </ac:spMkLst>
        </pc:spChg>
        <pc:spChg chg="add del mod">
          <ac:chgData name="Felipe Freitas" userId="754b0854625114a1" providerId="LiveId" clId="{D3337E6F-9E70-4B65-B42F-8091C9D37240}" dt="2023-10-23T01:09:02.857" v="260"/>
          <ac:spMkLst>
            <pc:docMk/>
            <pc:sldMk cId="152488700" sldId="313"/>
            <ac:spMk id="9" creationId="{C22691BB-8335-F7B1-7A08-F5D01C5078D0}"/>
          </ac:spMkLst>
        </pc:spChg>
        <pc:spChg chg="add del">
          <ac:chgData name="Felipe Freitas" userId="754b0854625114a1" providerId="LiveId" clId="{D3337E6F-9E70-4B65-B42F-8091C9D37240}" dt="2023-10-23T01:09:04.432" v="261" actId="26606"/>
          <ac:spMkLst>
            <pc:docMk/>
            <pc:sldMk cId="152488700" sldId="313"/>
            <ac:spMk id="12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13:30.603" v="280"/>
          <ac:spMkLst>
            <pc:docMk/>
            <pc:sldMk cId="152488700" sldId="313"/>
            <ac:spMk id="14" creationId="{CF805E5C-9B8B-5731-85FB-8640178C33A7}"/>
          </ac:spMkLst>
        </pc:spChg>
        <pc:spChg chg="add del">
          <ac:chgData name="Felipe Freitas" userId="754b0854625114a1" providerId="LiveId" clId="{D3337E6F-9E70-4B65-B42F-8091C9D37240}" dt="2023-10-23T01:13:31.748" v="281" actId="26606"/>
          <ac:spMkLst>
            <pc:docMk/>
            <pc:sldMk cId="152488700" sldId="313"/>
            <ac:spMk id="17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52488700" sldId="313"/>
            <ac:spMk id="20" creationId="{06D0B329-B1F9-5BBA-8676-450DC0993199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52488700" sldId="313"/>
            <ac:spMk id="24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09:00.379" v="259" actId="478"/>
          <ac:picMkLst>
            <pc:docMk/>
            <pc:sldMk cId="152488700" sldId="313"/>
            <ac:picMk id="5" creationId="{66E254EA-2F29-AD33-5F51-9465205EB6D2}"/>
          </ac:picMkLst>
        </pc:picChg>
        <pc:picChg chg="add del mod">
          <ac:chgData name="Felipe Freitas" userId="754b0854625114a1" providerId="LiveId" clId="{D3337E6F-9E70-4B65-B42F-8091C9D37240}" dt="2023-10-23T01:12:49.414" v="269" actId="478"/>
          <ac:picMkLst>
            <pc:docMk/>
            <pc:sldMk cId="152488700" sldId="313"/>
            <ac:picMk id="7" creationId="{3C7A1CA4-253C-24ED-20CA-4115FEFB05DF}"/>
          </ac:picMkLst>
        </pc:picChg>
        <pc:picChg chg="add del mod">
          <ac:chgData name="Felipe Freitas" userId="754b0854625114a1" providerId="LiveId" clId="{D3337E6F-9E70-4B65-B42F-8091C9D37240}" dt="2023-10-23T01:12:49.414" v="269" actId="478"/>
          <ac:picMkLst>
            <pc:docMk/>
            <pc:sldMk cId="152488700" sldId="313"/>
            <ac:picMk id="11" creationId="{5F155DB7-F733-AB67-1D94-6FB73910AEA1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152488700" sldId="313"/>
            <ac:picMk id="16" creationId="{7594E86B-44C5-75A4-FA11-BE165A5586A5}"/>
          </ac:picMkLst>
        </pc:picChg>
        <pc:picChg chg="add mod">
          <ac:chgData name="Felipe Freitas" userId="754b0854625114a1" providerId="LiveId" clId="{D3337E6F-9E70-4B65-B42F-8091C9D37240}" dt="2023-10-23T01:13:31.748" v="281" actId="26606"/>
          <ac:picMkLst>
            <pc:docMk/>
            <pc:sldMk cId="152488700" sldId="313"/>
            <ac:picMk id="19" creationId="{A6D1736D-68FF-FF69-C5A2-0B9C0161A9D2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53.024" v="596"/>
        <pc:sldMkLst>
          <pc:docMk/>
          <pc:sldMk cId="4212152824" sldId="314"/>
        </pc:sldMkLst>
        <pc:spChg chg="mod ord">
          <ac:chgData name="Felipe Freitas" userId="754b0854625114a1" providerId="LiveId" clId="{D3337E6F-9E70-4B65-B42F-8091C9D37240}" dt="2023-10-23T01:42:28.692" v="516" actId="20577"/>
          <ac:spMkLst>
            <pc:docMk/>
            <pc:sldMk cId="4212152824" sldId="314"/>
            <ac:spMk id="2" creationId="{EACB5293-0FDD-271A-3B75-C1B547BCB875}"/>
          </ac:spMkLst>
        </pc:spChg>
        <pc:spChg chg="del">
          <ac:chgData name="Felipe Freitas" userId="754b0854625114a1" providerId="LiveId" clId="{D3337E6F-9E70-4B65-B42F-8091C9D37240}" dt="2023-10-23T01:07:14.882" v="240"/>
          <ac:spMkLst>
            <pc:docMk/>
            <pc:sldMk cId="4212152824" sldId="314"/>
            <ac:spMk id="4" creationId="{B110AADB-E0CF-EB3B-08E2-B1463C75B2B0}"/>
          </ac:spMkLst>
        </pc:spChg>
        <pc:spChg chg="add del mod">
          <ac:chgData name="Felipe Freitas" userId="754b0854625114a1" providerId="LiveId" clId="{D3337E6F-9E70-4B65-B42F-8091C9D37240}" dt="2023-10-23T01:08:53.218" v="257"/>
          <ac:spMkLst>
            <pc:docMk/>
            <pc:sldMk cId="4212152824" sldId="314"/>
            <ac:spMk id="9" creationId="{A8C40457-2C99-1B4B-10CF-A1ECA9CE2365}"/>
          </ac:spMkLst>
        </pc:spChg>
        <pc:spChg chg="add del">
          <ac:chgData name="Felipe Freitas" userId="754b0854625114a1" providerId="LiveId" clId="{D3337E6F-9E70-4B65-B42F-8091C9D37240}" dt="2023-10-23T01:08:54.320" v="258" actId="26606"/>
          <ac:spMkLst>
            <pc:docMk/>
            <pc:sldMk cId="4212152824" sldId="314"/>
            <ac:spMk id="12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14:01.758" v="285"/>
          <ac:spMkLst>
            <pc:docMk/>
            <pc:sldMk cId="4212152824" sldId="314"/>
            <ac:spMk id="14" creationId="{C9087C9F-B29B-9600-D191-8C047CE60395}"/>
          </ac:spMkLst>
        </pc:spChg>
        <pc:spChg chg="add del">
          <ac:chgData name="Felipe Freitas" userId="754b0854625114a1" providerId="LiveId" clId="{D3337E6F-9E70-4B65-B42F-8091C9D37240}" dt="2023-10-23T01:14:02.925" v="286" actId="26606"/>
          <ac:spMkLst>
            <pc:docMk/>
            <pc:sldMk cId="4212152824" sldId="314"/>
            <ac:spMk id="17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212152824" sldId="314"/>
            <ac:spMk id="20" creationId="{2EAB19D4-392B-8CC3-13B1-D00A4ED80B1B}"/>
          </ac:spMkLst>
        </pc:spChg>
        <pc:spChg chg="add mod">
          <ac:chgData name="Felipe Freitas" userId="754b0854625114a1" providerId="LiveId" clId="{D3337E6F-9E70-4B65-B42F-8091C9D37240}" dt="2023-10-23T01:46:53.024" v="596"/>
          <ac:spMkLst>
            <pc:docMk/>
            <pc:sldMk cId="4212152824" sldId="314"/>
            <ac:spMk id="21" creationId="{5FD41517-0483-D496-6696-1109F48774B8}"/>
          </ac:spMkLst>
        </pc:spChg>
        <pc:spChg chg="add mod">
          <ac:chgData name="Felipe Freitas" userId="754b0854625114a1" providerId="LiveId" clId="{D3337E6F-9E70-4B65-B42F-8091C9D37240}" dt="2023-10-23T01:46:53.024" v="596"/>
          <ac:spMkLst>
            <pc:docMk/>
            <pc:sldMk cId="4212152824" sldId="314"/>
            <ac:spMk id="22" creationId="{1ED01720-04EB-7F7E-1701-B66EA80EC019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212152824" sldId="314"/>
            <ac:spMk id="24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08:51.102" v="256" actId="478"/>
          <ac:picMkLst>
            <pc:docMk/>
            <pc:sldMk cId="4212152824" sldId="314"/>
            <ac:picMk id="5" creationId="{6A69BCD2-E3D6-78D3-DA77-8556DCEB9B43}"/>
          </ac:picMkLst>
        </pc:picChg>
        <pc:picChg chg="add del mod">
          <ac:chgData name="Felipe Freitas" userId="754b0854625114a1" providerId="LiveId" clId="{D3337E6F-9E70-4B65-B42F-8091C9D37240}" dt="2023-10-23T01:12:53.459" v="270" actId="478"/>
          <ac:picMkLst>
            <pc:docMk/>
            <pc:sldMk cId="4212152824" sldId="314"/>
            <ac:picMk id="7" creationId="{4ECBF980-49A3-A695-B88F-4F504D0B3920}"/>
          </ac:picMkLst>
        </pc:picChg>
        <pc:picChg chg="add del mod">
          <ac:chgData name="Felipe Freitas" userId="754b0854625114a1" providerId="LiveId" clId="{D3337E6F-9E70-4B65-B42F-8091C9D37240}" dt="2023-10-23T01:12:53.459" v="270" actId="478"/>
          <ac:picMkLst>
            <pc:docMk/>
            <pc:sldMk cId="4212152824" sldId="314"/>
            <ac:picMk id="11" creationId="{98EC6437-A4AB-2E35-34A2-C86BDEBF8CD1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212152824" sldId="314"/>
            <ac:picMk id="16" creationId="{664EEF2B-913E-00AF-CB55-2D85B0084536}"/>
          </ac:picMkLst>
        </pc:picChg>
        <pc:picChg chg="add mod">
          <ac:chgData name="Felipe Freitas" userId="754b0854625114a1" providerId="LiveId" clId="{D3337E6F-9E70-4B65-B42F-8091C9D37240}" dt="2023-10-23T01:14:02.925" v="286" actId="26606"/>
          <ac:picMkLst>
            <pc:docMk/>
            <pc:sldMk cId="4212152824" sldId="314"/>
            <ac:picMk id="19" creationId="{B39D5E25-E303-914C-616B-78D53A03572A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54.038" v="597"/>
        <pc:sldMkLst>
          <pc:docMk/>
          <pc:sldMk cId="1308216174" sldId="315"/>
        </pc:sldMkLst>
        <pc:spChg chg="mod ord">
          <ac:chgData name="Felipe Freitas" userId="754b0854625114a1" providerId="LiveId" clId="{D3337E6F-9E70-4B65-B42F-8091C9D37240}" dt="2023-10-23T01:42:22.854" v="515" actId="20577"/>
          <ac:spMkLst>
            <pc:docMk/>
            <pc:sldMk cId="1308216174" sldId="315"/>
            <ac:spMk id="2" creationId="{DFE2B4DC-A5C0-C8D3-C66E-836E85A60E93}"/>
          </ac:spMkLst>
        </pc:spChg>
        <pc:spChg chg="del">
          <ac:chgData name="Felipe Freitas" userId="754b0854625114a1" providerId="LiveId" clId="{D3337E6F-9E70-4B65-B42F-8091C9D37240}" dt="2023-10-23T01:07:21.731" v="242"/>
          <ac:spMkLst>
            <pc:docMk/>
            <pc:sldMk cId="1308216174" sldId="315"/>
            <ac:spMk id="4" creationId="{61792894-74E5-8B06-486D-08EA82925D0F}"/>
          </ac:spMkLst>
        </pc:spChg>
        <pc:spChg chg="add del mod">
          <ac:chgData name="Felipe Freitas" userId="754b0854625114a1" providerId="LiveId" clId="{D3337E6F-9E70-4B65-B42F-8091C9D37240}" dt="2023-10-23T01:08:31.374" v="254"/>
          <ac:spMkLst>
            <pc:docMk/>
            <pc:sldMk cId="1308216174" sldId="315"/>
            <ac:spMk id="11" creationId="{703BC4D3-76D2-94A7-F409-275D41371905}"/>
          </ac:spMkLst>
        </pc:spChg>
        <pc:spChg chg="add del">
          <ac:chgData name="Felipe Freitas" userId="754b0854625114a1" providerId="LiveId" clId="{D3337E6F-9E70-4B65-B42F-8091C9D37240}" dt="2023-10-23T01:08:32.778" v="255" actId="26606"/>
          <ac:spMkLst>
            <pc:docMk/>
            <pc:sldMk cId="1308216174" sldId="315"/>
            <ac:spMk id="12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14:07.517" v="287"/>
          <ac:spMkLst>
            <pc:docMk/>
            <pc:sldMk cId="1308216174" sldId="315"/>
            <ac:spMk id="16" creationId="{D8CA5BA5-06A0-E3D6-9205-9150074F94F3}"/>
          </ac:spMkLst>
        </pc:spChg>
        <pc:spChg chg="add del">
          <ac:chgData name="Felipe Freitas" userId="754b0854625114a1" providerId="LiveId" clId="{D3337E6F-9E70-4B65-B42F-8091C9D37240}" dt="2023-10-23T01:14:08.750" v="288" actId="26606"/>
          <ac:spMkLst>
            <pc:docMk/>
            <pc:sldMk cId="1308216174" sldId="315"/>
            <ac:spMk id="19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308216174" sldId="315"/>
            <ac:spMk id="22" creationId="{B995602A-C961-C2DD-121A-B053CBF50FF0}"/>
          </ac:spMkLst>
        </pc:spChg>
        <pc:spChg chg="add mod">
          <ac:chgData name="Felipe Freitas" userId="754b0854625114a1" providerId="LiveId" clId="{D3337E6F-9E70-4B65-B42F-8091C9D37240}" dt="2023-10-23T01:46:54.038" v="597"/>
          <ac:spMkLst>
            <pc:docMk/>
            <pc:sldMk cId="1308216174" sldId="315"/>
            <ac:spMk id="23" creationId="{1ACB69C3-FF08-7980-ACFE-83E50B227DBF}"/>
          </ac:spMkLst>
        </pc:spChg>
        <pc:spChg chg="add mod">
          <ac:chgData name="Felipe Freitas" userId="754b0854625114a1" providerId="LiveId" clId="{D3337E6F-9E70-4B65-B42F-8091C9D37240}" dt="2023-10-23T01:46:54.038" v="597"/>
          <ac:spMkLst>
            <pc:docMk/>
            <pc:sldMk cId="1308216174" sldId="315"/>
            <ac:spMk id="24" creationId="{A7564DAB-B037-83FC-A687-3B8AB85E1C91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308216174" sldId="315"/>
            <ac:spMk id="26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08:29.703" v="253" actId="478"/>
          <ac:picMkLst>
            <pc:docMk/>
            <pc:sldMk cId="1308216174" sldId="315"/>
            <ac:picMk id="5" creationId="{6A0C30FB-2876-147C-C88E-A2DEB0BA0726}"/>
          </ac:picMkLst>
        </pc:picChg>
        <pc:picChg chg="add del mod">
          <ac:chgData name="Felipe Freitas" userId="754b0854625114a1" providerId="LiveId" clId="{D3337E6F-9E70-4B65-B42F-8091C9D37240}" dt="2023-10-23T01:12:56.877" v="271" actId="478"/>
          <ac:picMkLst>
            <pc:docMk/>
            <pc:sldMk cId="1308216174" sldId="315"/>
            <ac:picMk id="7" creationId="{D95C91A8-D803-86C2-E314-344FC5F8C2A8}"/>
          </ac:picMkLst>
        </pc:picChg>
        <pc:picChg chg="add del mod">
          <ac:chgData name="Felipe Freitas" userId="754b0854625114a1" providerId="LiveId" clId="{D3337E6F-9E70-4B65-B42F-8091C9D37240}" dt="2023-10-23T01:08:14.080" v="252"/>
          <ac:picMkLst>
            <pc:docMk/>
            <pc:sldMk cId="1308216174" sldId="315"/>
            <ac:picMk id="9" creationId="{4C2CC04E-B35A-51EA-7635-08E5DDFABFE2}"/>
          </ac:picMkLst>
        </pc:picChg>
        <pc:picChg chg="add del mod">
          <ac:chgData name="Felipe Freitas" userId="754b0854625114a1" providerId="LiveId" clId="{D3337E6F-9E70-4B65-B42F-8091C9D37240}" dt="2023-10-23T01:12:56.877" v="271" actId="478"/>
          <ac:picMkLst>
            <pc:docMk/>
            <pc:sldMk cId="1308216174" sldId="315"/>
            <ac:picMk id="14" creationId="{0763C689-6D3D-F9DE-7ECA-A3119565C893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1308216174" sldId="315"/>
            <ac:picMk id="18" creationId="{5BD31CF8-B873-136D-E3B8-DF5307D6366C}"/>
          </ac:picMkLst>
        </pc:picChg>
        <pc:picChg chg="add mod">
          <ac:chgData name="Felipe Freitas" userId="754b0854625114a1" providerId="LiveId" clId="{D3337E6F-9E70-4B65-B42F-8091C9D37240}" dt="2023-10-23T01:14:08.750" v="288" actId="26606"/>
          <ac:picMkLst>
            <pc:docMk/>
            <pc:sldMk cId="1308216174" sldId="315"/>
            <ac:picMk id="21" creationId="{65821F56-FAC8-D4B3-19D7-1A1DC2CD89AB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59.409" v="600"/>
        <pc:sldMkLst>
          <pc:docMk/>
          <pc:sldMk cId="424616134" sldId="316"/>
        </pc:sldMkLst>
        <pc:spChg chg="mod ord">
          <ac:chgData name="Felipe Freitas" userId="754b0854625114a1" providerId="LiveId" clId="{D3337E6F-9E70-4B65-B42F-8091C9D37240}" dt="2023-10-23T01:42:18.137" v="514" actId="20577"/>
          <ac:spMkLst>
            <pc:docMk/>
            <pc:sldMk cId="424616134" sldId="316"/>
            <ac:spMk id="2" creationId="{787BD46A-090E-645E-A58E-942DE8293721}"/>
          </ac:spMkLst>
        </pc:spChg>
        <pc:spChg chg="del">
          <ac:chgData name="Felipe Freitas" userId="754b0854625114a1" providerId="LiveId" clId="{D3337E6F-9E70-4B65-B42F-8091C9D37240}" dt="2023-10-23T01:07:29.827" v="244"/>
          <ac:spMkLst>
            <pc:docMk/>
            <pc:sldMk cId="424616134" sldId="316"/>
            <ac:spMk id="4" creationId="{F75418F6-FEE1-6E31-5B4D-D6DEF3CBDAB3}"/>
          </ac:spMkLst>
        </pc:spChg>
        <pc:spChg chg="add del mod">
          <ac:chgData name="Felipe Freitas" userId="754b0854625114a1" providerId="LiveId" clId="{D3337E6F-9E70-4B65-B42F-8091C9D37240}" dt="2023-10-23T01:14:16.729" v="289"/>
          <ac:spMkLst>
            <pc:docMk/>
            <pc:sldMk cId="424616134" sldId="316"/>
            <ac:spMk id="9" creationId="{03B2EE7D-A25E-9D70-0122-12F10B9A5C89}"/>
          </ac:spMkLst>
        </pc:spChg>
        <pc:spChg chg="add del">
          <ac:chgData name="Felipe Freitas" userId="754b0854625114a1" providerId="LiveId" clId="{D3337E6F-9E70-4B65-B42F-8091C9D37240}" dt="2023-10-23T01:14:18.352" v="290" actId="26606"/>
          <ac:spMkLst>
            <pc:docMk/>
            <pc:sldMk cId="424616134" sldId="316"/>
            <ac:spMk id="12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24616134" sldId="316"/>
            <ac:spMk id="15" creationId="{97406DD5-5BE7-4A39-3F19-22F7EA1C1D30}"/>
          </ac:spMkLst>
        </pc:spChg>
        <pc:spChg chg="add mod">
          <ac:chgData name="Felipe Freitas" userId="754b0854625114a1" providerId="LiveId" clId="{D3337E6F-9E70-4B65-B42F-8091C9D37240}" dt="2023-10-23T01:46:54.581" v="598"/>
          <ac:spMkLst>
            <pc:docMk/>
            <pc:sldMk cId="424616134" sldId="316"/>
            <ac:spMk id="16" creationId="{B01EBD14-1FD1-7600-4941-1EC8FCE98DD9}"/>
          </ac:spMkLst>
        </pc:spChg>
        <pc:spChg chg="add mod">
          <ac:chgData name="Felipe Freitas" userId="754b0854625114a1" providerId="LiveId" clId="{D3337E6F-9E70-4B65-B42F-8091C9D37240}" dt="2023-10-23T01:46:54.581" v="598"/>
          <ac:spMkLst>
            <pc:docMk/>
            <pc:sldMk cId="424616134" sldId="316"/>
            <ac:spMk id="17" creationId="{97142270-DEC7-A053-BFFE-394B37BC98F5}"/>
          </ac:spMkLst>
        </pc:spChg>
        <pc:spChg chg="add del mod">
          <ac:chgData name="Felipe Freitas" userId="754b0854625114a1" providerId="LiveId" clId="{D3337E6F-9E70-4B65-B42F-8091C9D37240}" dt="2023-10-23T01:46:59.409" v="600"/>
          <ac:spMkLst>
            <pc:docMk/>
            <pc:sldMk cId="424616134" sldId="316"/>
            <ac:spMk id="18" creationId="{E04466EC-6E12-7059-E6AC-E6B33B6B9C2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24616134" sldId="316"/>
            <ac:spMk id="19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46:59.409" v="600"/>
          <ac:spMkLst>
            <pc:docMk/>
            <pc:sldMk cId="424616134" sldId="316"/>
            <ac:spMk id="20" creationId="{0092E40E-164F-A11F-3B61-14433E6FE0DF}"/>
          </ac:spMkLst>
        </pc:spChg>
        <pc:picChg chg="add del mod ord">
          <ac:chgData name="Felipe Freitas" userId="754b0854625114a1" providerId="LiveId" clId="{D3337E6F-9E70-4B65-B42F-8091C9D37240}" dt="2023-10-23T01:12:59.816" v="272" actId="478"/>
          <ac:picMkLst>
            <pc:docMk/>
            <pc:sldMk cId="424616134" sldId="316"/>
            <ac:picMk id="5" creationId="{FF8D6371-B498-1E5E-BC93-94D76C6E6D9A}"/>
          </ac:picMkLst>
        </pc:picChg>
        <pc:picChg chg="add del mod">
          <ac:chgData name="Felipe Freitas" userId="754b0854625114a1" providerId="LiveId" clId="{D3337E6F-9E70-4B65-B42F-8091C9D37240}" dt="2023-10-23T01:12:59.816" v="272" actId="478"/>
          <ac:picMkLst>
            <pc:docMk/>
            <pc:sldMk cId="424616134" sldId="316"/>
            <ac:picMk id="7" creationId="{94B23183-5F3F-88F3-1435-1E2AAF438DA3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24616134" sldId="316"/>
            <ac:picMk id="11" creationId="{7F76824A-29EC-0F2E-8DCD-C4B1589BBF4D}"/>
          </ac:picMkLst>
        </pc:picChg>
        <pc:picChg chg="add mod">
          <ac:chgData name="Felipe Freitas" userId="754b0854625114a1" providerId="LiveId" clId="{D3337E6F-9E70-4B65-B42F-8091C9D37240}" dt="2023-10-23T01:14:18.352" v="290" actId="26606"/>
          <ac:picMkLst>
            <pc:docMk/>
            <pc:sldMk cId="424616134" sldId="316"/>
            <ac:picMk id="14" creationId="{A2C237B4-34C3-45B7-229D-8EB1A37A91AF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7:00.469" v="601"/>
        <pc:sldMkLst>
          <pc:docMk/>
          <pc:sldMk cId="2923604090" sldId="317"/>
        </pc:sldMkLst>
        <pc:spChg chg="mod ord">
          <ac:chgData name="Felipe Freitas" userId="754b0854625114a1" providerId="LiveId" clId="{D3337E6F-9E70-4B65-B42F-8091C9D37240}" dt="2023-10-23T01:42:10.145" v="513" actId="27636"/>
          <ac:spMkLst>
            <pc:docMk/>
            <pc:sldMk cId="2923604090" sldId="317"/>
            <ac:spMk id="2" creationId="{935EEDD6-8504-65CF-EEF6-E2DF9027F368}"/>
          </ac:spMkLst>
        </pc:spChg>
        <pc:spChg chg="del">
          <ac:chgData name="Felipe Freitas" userId="754b0854625114a1" providerId="LiveId" clId="{D3337E6F-9E70-4B65-B42F-8091C9D37240}" dt="2023-10-23T01:07:37.558" v="246"/>
          <ac:spMkLst>
            <pc:docMk/>
            <pc:sldMk cId="2923604090" sldId="317"/>
            <ac:spMk id="4" creationId="{4795549C-DDD1-82C6-26F6-FA4A78D21CB3}"/>
          </ac:spMkLst>
        </pc:spChg>
        <pc:spChg chg="add del mod">
          <ac:chgData name="Felipe Freitas" userId="754b0854625114a1" providerId="LiveId" clId="{D3337E6F-9E70-4B65-B42F-8091C9D37240}" dt="2023-10-23T01:07:50.923" v="249"/>
          <ac:spMkLst>
            <pc:docMk/>
            <pc:sldMk cId="2923604090" sldId="317"/>
            <ac:spMk id="9" creationId="{FE2E01AC-D024-FD70-4D16-E094BD40938D}"/>
          </ac:spMkLst>
        </pc:spChg>
        <pc:spChg chg="add del">
          <ac:chgData name="Felipe Freitas" userId="754b0854625114a1" providerId="LiveId" clId="{D3337E6F-9E70-4B65-B42F-8091C9D37240}" dt="2023-10-23T01:07:53.379" v="250" actId="26606"/>
          <ac:spMkLst>
            <pc:docMk/>
            <pc:sldMk cId="2923604090" sldId="317"/>
            <ac:spMk id="12" creationId="{3B47FC9C-2ED3-4100-A4EF-E8CDFEE106C9}"/>
          </ac:spMkLst>
        </pc:spChg>
        <pc:spChg chg="add del mod">
          <ac:chgData name="Felipe Freitas" userId="754b0854625114a1" providerId="LiveId" clId="{D3337E6F-9E70-4B65-B42F-8091C9D37240}" dt="2023-10-23T01:14:25.858" v="291"/>
          <ac:spMkLst>
            <pc:docMk/>
            <pc:sldMk cId="2923604090" sldId="317"/>
            <ac:spMk id="14" creationId="{3E8D21DB-9961-3341-FFC2-6C2CCB281408}"/>
          </ac:spMkLst>
        </pc:spChg>
        <pc:spChg chg="add del">
          <ac:chgData name="Felipe Freitas" userId="754b0854625114a1" providerId="LiveId" clId="{D3337E6F-9E70-4B65-B42F-8091C9D37240}" dt="2023-10-23T01:14:27.312" v="292" actId="26606"/>
          <ac:spMkLst>
            <pc:docMk/>
            <pc:sldMk cId="2923604090" sldId="317"/>
            <ac:spMk id="17" creationId="{3B47FC9C-2ED3-4100-A4EF-E8CDFEE106C9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2923604090" sldId="317"/>
            <ac:spMk id="20" creationId="{B84AEBB3-D175-8023-A9C2-66930B8E6E64}"/>
          </ac:spMkLst>
        </pc:spChg>
        <pc:spChg chg="add mod">
          <ac:chgData name="Felipe Freitas" userId="754b0854625114a1" providerId="LiveId" clId="{D3337E6F-9E70-4B65-B42F-8091C9D37240}" dt="2023-10-23T01:47:00.469" v="601"/>
          <ac:spMkLst>
            <pc:docMk/>
            <pc:sldMk cId="2923604090" sldId="317"/>
            <ac:spMk id="21" creationId="{16FEC65C-F3C2-F1C6-C245-57F40D49352C}"/>
          </ac:spMkLst>
        </pc:spChg>
        <pc:spChg chg="add mod">
          <ac:chgData name="Felipe Freitas" userId="754b0854625114a1" providerId="LiveId" clId="{D3337E6F-9E70-4B65-B42F-8091C9D37240}" dt="2023-10-23T01:47:00.469" v="601"/>
          <ac:spMkLst>
            <pc:docMk/>
            <pc:sldMk cId="2923604090" sldId="317"/>
            <ac:spMk id="22" creationId="{2C9BD1F7-E2CD-B443-AAF3-BAA2AD3D5B37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2923604090" sldId="317"/>
            <ac:spMk id="24" creationId="{3B47FC9C-2ED3-4100-A4EF-E8CDFEE106C9}"/>
          </ac:spMkLst>
        </pc:spChg>
        <pc:picChg chg="add del mod ord">
          <ac:chgData name="Felipe Freitas" userId="754b0854625114a1" providerId="LiveId" clId="{D3337E6F-9E70-4B65-B42F-8091C9D37240}" dt="2023-10-23T01:07:48.383" v="248" actId="478"/>
          <ac:picMkLst>
            <pc:docMk/>
            <pc:sldMk cId="2923604090" sldId="317"/>
            <ac:picMk id="5" creationId="{6591611B-6EE1-DC13-92B4-9C128F813BEC}"/>
          </ac:picMkLst>
        </pc:picChg>
        <pc:picChg chg="add del mod">
          <ac:chgData name="Felipe Freitas" userId="754b0854625114a1" providerId="LiveId" clId="{D3337E6F-9E70-4B65-B42F-8091C9D37240}" dt="2023-10-23T01:13:05.534" v="273" actId="478"/>
          <ac:picMkLst>
            <pc:docMk/>
            <pc:sldMk cId="2923604090" sldId="317"/>
            <ac:picMk id="7" creationId="{DEBE3DCB-78C5-F3D0-5BBA-8EFA95FDA882}"/>
          </ac:picMkLst>
        </pc:picChg>
        <pc:picChg chg="add del mod">
          <ac:chgData name="Felipe Freitas" userId="754b0854625114a1" providerId="LiveId" clId="{D3337E6F-9E70-4B65-B42F-8091C9D37240}" dt="2023-10-23T01:13:05.534" v="273" actId="478"/>
          <ac:picMkLst>
            <pc:docMk/>
            <pc:sldMk cId="2923604090" sldId="317"/>
            <ac:picMk id="11" creationId="{C750B7B5-3D57-40D2-D7A0-069D7F9705EB}"/>
          </ac:picMkLst>
        </pc:pic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2923604090" sldId="317"/>
            <ac:picMk id="16" creationId="{99379313-BAA0-0DFA-3E95-C3FA0DD732E3}"/>
          </ac:picMkLst>
        </pc:picChg>
        <pc:picChg chg="add mod">
          <ac:chgData name="Felipe Freitas" userId="754b0854625114a1" providerId="LiveId" clId="{D3337E6F-9E70-4B65-B42F-8091C9D37240}" dt="2023-10-23T01:14:27.312" v="292" actId="26606"/>
          <ac:picMkLst>
            <pc:docMk/>
            <pc:sldMk cId="2923604090" sldId="317"/>
            <ac:picMk id="19" creationId="{A5F2F6F3-F750-CEEF-22B5-594DE657B0FE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38.110" v="585"/>
        <pc:sldMkLst>
          <pc:docMk/>
          <pc:sldMk cId="3608825359" sldId="318"/>
        </pc:sldMkLst>
        <pc:spChg chg="mod ord">
          <ac:chgData name="Felipe Freitas" userId="754b0854625114a1" providerId="LiveId" clId="{D3337E6F-9E70-4B65-B42F-8091C9D37240}" dt="2023-10-23T01:43:14.501" v="524" actId="20577"/>
          <ac:spMkLst>
            <pc:docMk/>
            <pc:sldMk cId="3608825359" sldId="318"/>
            <ac:spMk id="2" creationId="{65C11385-BCBC-4B11-63AB-7393A2B5B858}"/>
          </ac:spMkLst>
        </pc:spChg>
        <pc:spChg chg="del">
          <ac:chgData name="Felipe Freitas" userId="754b0854625114a1" providerId="LiveId" clId="{D3337E6F-9E70-4B65-B42F-8091C9D37240}" dt="2023-10-23T01:01:56.590" v="182"/>
          <ac:spMkLst>
            <pc:docMk/>
            <pc:sldMk cId="3608825359" sldId="318"/>
            <ac:spMk id="4" creationId="{D1D06267-0291-9C84-2411-B92CFCEA23E1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608825359" sldId="318"/>
            <ac:spMk id="10" creationId="{DF842737-9822-439A-DC5B-AA9655ED696E}"/>
          </ac:spMkLst>
        </pc:spChg>
        <pc:spChg chg="add mod">
          <ac:chgData name="Felipe Freitas" userId="754b0854625114a1" providerId="LiveId" clId="{D3337E6F-9E70-4B65-B42F-8091C9D37240}" dt="2023-10-23T01:46:38.110" v="585"/>
          <ac:spMkLst>
            <pc:docMk/>
            <pc:sldMk cId="3608825359" sldId="318"/>
            <ac:spMk id="11" creationId="{D6408F18-DE11-669E-4711-52AAE8790157}"/>
          </ac:spMkLst>
        </pc:spChg>
        <pc:spChg chg="add del">
          <ac:chgData name="Felipe Freitas" userId="754b0854625114a1" providerId="LiveId" clId="{D3337E6F-9E70-4B65-B42F-8091C9D37240}" dt="2023-10-23T01:23:58.619" v="300" actId="26606"/>
          <ac:spMkLst>
            <pc:docMk/>
            <pc:sldMk cId="3608825359" sldId="318"/>
            <ac:spMk id="12" creationId="{3B47FC9C-2ED3-4100-A4EF-E8CDFEE106C9}"/>
          </ac:spMkLst>
        </pc:spChg>
        <pc:spChg chg="add mod">
          <ac:chgData name="Felipe Freitas" userId="754b0854625114a1" providerId="LiveId" clId="{D3337E6F-9E70-4B65-B42F-8091C9D37240}" dt="2023-10-23T01:46:38.110" v="585"/>
          <ac:spMkLst>
            <pc:docMk/>
            <pc:sldMk cId="3608825359" sldId="318"/>
            <ac:spMk id="13" creationId="{64383022-473A-5DC3-502F-8E391BB6B11B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3608825359" sldId="318"/>
            <ac:spMk id="17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3608825359" sldId="318"/>
            <ac:picMk id="5" creationId="{9CEFC240-68F3-98DE-4CC5-4AC4870BF24E}"/>
          </ac:picMkLst>
        </pc:picChg>
        <pc:picChg chg="add del mod">
          <ac:chgData name="Felipe Freitas" userId="754b0854625114a1" providerId="LiveId" clId="{D3337E6F-9E70-4B65-B42F-8091C9D37240}" dt="2023-10-23T01:23:54.559" v="298" actId="478"/>
          <ac:picMkLst>
            <pc:docMk/>
            <pc:sldMk cId="3608825359" sldId="318"/>
            <ac:picMk id="7" creationId="{C653C0C6-F3F3-B039-4427-167422471931}"/>
          </ac:picMkLst>
        </pc:picChg>
        <pc:picChg chg="add mod ord">
          <ac:chgData name="Felipe Freitas" userId="754b0854625114a1" providerId="LiveId" clId="{D3337E6F-9E70-4B65-B42F-8091C9D37240}" dt="2023-10-23T01:23:58.619" v="300" actId="26606"/>
          <ac:picMkLst>
            <pc:docMk/>
            <pc:sldMk cId="3608825359" sldId="318"/>
            <ac:picMk id="9" creationId="{231BE591-252F-6FBC-A1D4-0DA89A5CE00F}"/>
          </ac:picMkLst>
        </pc:picChg>
      </pc:sldChg>
      <pc:sldChg chg="addSp delSp modSp add del mod setBg modClrScheme delDesignElem chgLayout">
        <pc:chgData name="Felipe Freitas" userId="754b0854625114a1" providerId="LiveId" clId="{D3337E6F-9E70-4B65-B42F-8091C9D37240}" dt="2023-10-23T01:32:33.503" v="400" actId="47"/>
        <pc:sldMkLst>
          <pc:docMk/>
          <pc:sldMk cId="4090791825" sldId="319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4090791825" sldId="319"/>
            <ac:spMk id="2" creationId="{25507AD8-5769-1871-C2E3-8F2F5709A2E1}"/>
          </ac:spMkLst>
        </pc:spChg>
        <pc:spChg chg="del">
          <ac:chgData name="Felipe Freitas" userId="754b0854625114a1" providerId="LiveId" clId="{D3337E6F-9E70-4B65-B42F-8091C9D37240}" dt="2023-10-23T01:02:02.366" v="184"/>
          <ac:spMkLst>
            <pc:docMk/>
            <pc:sldMk cId="4090791825" sldId="319"/>
            <ac:spMk id="4" creationId="{F2FFCBE5-0B62-38E2-DDD8-427558A77C0F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4090791825" sldId="319"/>
            <ac:spMk id="8" creationId="{D0749950-30BE-0898-B822-C6B4103FFA5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4090791825" sldId="319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4090791825" sldId="319"/>
            <ac:picMk id="5" creationId="{DF9BF27E-26D6-1E3E-90A0-59432B5F6C5A}"/>
          </ac:picMkLst>
        </pc:picChg>
        <pc:picChg chg="add mod">
          <ac:chgData name="Felipe Freitas" userId="754b0854625114a1" providerId="LiveId" clId="{D3337E6F-9E70-4B65-B42F-8091C9D37240}" dt="2023-10-23T01:02:03.410" v="185" actId="26606"/>
          <ac:picMkLst>
            <pc:docMk/>
            <pc:sldMk cId="4090791825" sldId="319"/>
            <ac:picMk id="7" creationId="{138D02FA-D1DB-14D7-24DA-2D1B9F9614D4}"/>
          </ac:picMkLst>
        </pc:picChg>
      </pc:sldChg>
      <pc:sldChg chg="addSp delSp modSp add del mod setBg modClrScheme delDesignElem chgLayout">
        <pc:chgData name="Felipe Freitas" userId="754b0854625114a1" providerId="LiveId" clId="{D3337E6F-9E70-4B65-B42F-8091C9D37240}" dt="2023-10-23T01:32:35.494" v="401" actId="47"/>
        <pc:sldMkLst>
          <pc:docMk/>
          <pc:sldMk cId="562826640" sldId="320"/>
        </pc:sldMkLst>
        <pc:spChg chg="mod ord">
          <ac:chgData name="Felipe Freitas" userId="754b0854625114a1" providerId="LiveId" clId="{D3337E6F-9E70-4B65-B42F-8091C9D37240}" dt="2023-10-23T01:31:39.075" v="395" actId="700"/>
          <ac:spMkLst>
            <pc:docMk/>
            <pc:sldMk cId="562826640" sldId="320"/>
            <ac:spMk id="2" creationId="{AB174FCF-100E-A371-E790-152B385F4A03}"/>
          </ac:spMkLst>
        </pc:spChg>
        <pc:spChg chg="del">
          <ac:chgData name="Felipe Freitas" userId="754b0854625114a1" providerId="LiveId" clId="{D3337E6F-9E70-4B65-B42F-8091C9D37240}" dt="2023-10-23T01:02:08.435" v="186"/>
          <ac:spMkLst>
            <pc:docMk/>
            <pc:sldMk cId="562826640" sldId="320"/>
            <ac:spMk id="4" creationId="{E9BC88A5-DB02-0E71-74CC-952FDBCF96CE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562826640" sldId="320"/>
            <ac:spMk id="8" creationId="{3D4C7C0F-7FF3-152C-8C90-7FFF164BE84E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562826640" sldId="320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562826640" sldId="320"/>
            <ac:picMk id="5" creationId="{ACD685E0-C490-C2DB-25D3-6347EF6E15D3}"/>
          </ac:picMkLst>
        </pc:picChg>
        <pc:picChg chg="add mod">
          <ac:chgData name="Felipe Freitas" userId="754b0854625114a1" providerId="LiveId" clId="{D3337E6F-9E70-4B65-B42F-8091C9D37240}" dt="2023-10-23T01:02:10.081" v="187" actId="26606"/>
          <ac:picMkLst>
            <pc:docMk/>
            <pc:sldMk cId="562826640" sldId="320"/>
            <ac:picMk id="7" creationId="{8E37345B-7F39-D8ED-E59C-E2E352712DE6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39.596" v="586"/>
        <pc:sldMkLst>
          <pc:docMk/>
          <pc:sldMk cId="2516272587" sldId="321"/>
        </pc:sldMkLst>
        <pc:spChg chg="mod ord">
          <ac:chgData name="Felipe Freitas" userId="754b0854625114a1" providerId="LiveId" clId="{D3337E6F-9E70-4B65-B42F-8091C9D37240}" dt="2023-10-23T01:43:11.735" v="523" actId="20577"/>
          <ac:spMkLst>
            <pc:docMk/>
            <pc:sldMk cId="2516272587" sldId="321"/>
            <ac:spMk id="2" creationId="{EACB5293-0FDD-271A-3B75-C1B547BCB875}"/>
          </ac:spMkLst>
        </pc:spChg>
        <pc:spChg chg="del">
          <ac:chgData name="Felipe Freitas" userId="754b0854625114a1" providerId="LiveId" clId="{D3337E6F-9E70-4B65-B42F-8091C9D37240}" dt="2023-10-23T01:02:14.700" v="188"/>
          <ac:spMkLst>
            <pc:docMk/>
            <pc:sldMk cId="2516272587" sldId="321"/>
            <ac:spMk id="4" creationId="{B110AADB-E0CF-EB3B-08E2-B1463C75B2B0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2516272587" sldId="321"/>
            <ac:spMk id="8" creationId="{059372CD-3360-562B-4B13-FE13E3F71B9A}"/>
          </ac:spMkLst>
        </pc:spChg>
        <pc:spChg chg="add mod">
          <ac:chgData name="Felipe Freitas" userId="754b0854625114a1" providerId="LiveId" clId="{D3337E6F-9E70-4B65-B42F-8091C9D37240}" dt="2023-10-23T01:46:39.596" v="586"/>
          <ac:spMkLst>
            <pc:docMk/>
            <pc:sldMk cId="2516272587" sldId="321"/>
            <ac:spMk id="9" creationId="{B46D8CC3-F75C-CD0C-BF9F-D862BC0D1B53}"/>
          </ac:spMkLst>
        </pc:spChg>
        <pc:spChg chg="add mod">
          <ac:chgData name="Felipe Freitas" userId="754b0854625114a1" providerId="LiveId" clId="{D3337E6F-9E70-4B65-B42F-8091C9D37240}" dt="2023-10-23T01:46:39.596" v="586"/>
          <ac:spMkLst>
            <pc:docMk/>
            <pc:sldMk cId="2516272587" sldId="321"/>
            <ac:spMk id="10" creationId="{7ADD905F-C6B8-4FBA-D751-AC1CC645F521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2516272587" sldId="321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2516272587" sldId="321"/>
            <ac:picMk id="5" creationId="{9C161910-4195-AAC9-9FA3-28F74C8B8187}"/>
          </ac:picMkLst>
        </pc:picChg>
        <pc:picChg chg="add mod">
          <ac:chgData name="Felipe Freitas" userId="754b0854625114a1" providerId="LiveId" clId="{D3337E6F-9E70-4B65-B42F-8091C9D37240}" dt="2023-10-23T01:02:16.323" v="189" actId="26606"/>
          <ac:picMkLst>
            <pc:docMk/>
            <pc:sldMk cId="2516272587" sldId="321"/>
            <ac:picMk id="7" creationId="{17A4B3F2-480C-40B1-10D8-649C5AA12F2F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41.144" v="587"/>
        <pc:sldMkLst>
          <pc:docMk/>
          <pc:sldMk cId="1311682758" sldId="322"/>
        </pc:sldMkLst>
        <pc:spChg chg="mod ord">
          <ac:chgData name="Felipe Freitas" userId="754b0854625114a1" providerId="LiveId" clId="{D3337E6F-9E70-4B65-B42F-8091C9D37240}" dt="2023-10-23T01:43:07.658" v="522" actId="20577"/>
          <ac:spMkLst>
            <pc:docMk/>
            <pc:sldMk cId="1311682758" sldId="322"/>
            <ac:spMk id="2" creationId="{DFE2B4DC-A5C0-C8D3-C66E-836E85A60E93}"/>
          </ac:spMkLst>
        </pc:spChg>
        <pc:spChg chg="del">
          <ac:chgData name="Felipe Freitas" userId="754b0854625114a1" providerId="LiveId" clId="{D3337E6F-9E70-4B65-B42F-8091C9D37240}" dt="2023-10-23T01:02:25.183" v="190"/>
          <ac:spMkLst>
            <pc:docMk/>
            <pc:sldMk cId="1311682758" sldId="322"/>
            <ac:spMk id="4" creationId="{61792894-74E5-8B06-486D-08EA82925D0F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1311682758" sldId="322"/>
            <ac:spMk id="8" creationId="{9FF11D4D-DBE4-5CA2-08E5-74F5396F639E}"/>
          </ac:spMkLst>
        </pc:spChg>
        <pc:spChg chg="add mod">
          <ac:chgData name="Felipe Freitas" userId="754b0854625114a1" providerId="LiveId" clId="{D3337E6F-9E70-4B65-B42F-8091C9D37240}" dt="2023-10-23T01:46:41.144" v="587"/>
          <ac:spMkLst>
            <pc:docMk/>
            <pc:sldMk cId="1311682758" sldId="322"/>
            <ac:spMk id="9" creationId="{4C2CA245-8116-6D9C-149F-3F0A9D68ADCD}"/>
          </ac:spMkLst>
        </pc:spChg>
        <pc:spChg chg="add mod">
          <ac:chgData name="Felipe Freitas" userId="754b0854625114a1" providerId="LiveId" clId="{D3337E6F-9E70-4B65-B42F-8091C9D37240}" dt="2023-10-23T01:46:41.144" v="587"/>
          <ac:spMkLst>
            <pc:docMk/>
            <pc:sldMk cId="1311682758" sldId="322"/>
            <ac:spMk id="10" creationId="{0A4F5994-57AA-EA9E-85E4-AE8D4E596D19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1311682758" sldId="322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1311682758" sldId="322"/>
            <ac:picMk id="5" creationId="{5286D888-7E77-CDD1-E942-2F31D6A05044}"/>
          </ac:picMkLst>
        </pc:picChg>
        <pc:picChg chg="add mod">
          <ac:chgData name="Felipe Freitas" userId="754b0854625114a1" providerId="LiveId" clId="{D3337E6F-9E70-4B65-B42F-8091C9D37240}" dt="2023-10-23T01:02:26.869" v="191" actId="26606"/>
          <ac:picMkLst>
            <pc:docMk/>
            <pc:sldMk cId="1311682758" sldId="322"/>
            <ac:picMk id="7" creationId="{6AB313BE-426F-0E9E-4C2B-88D637491E27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42.400" v="588"/>
        <pc:sldMkLst>
          <pc:docMk/>
          <pc:sldMk cId="2426543671" sldId="323"/>
        </pc:sldMkLst>
        <pc:spChg chg="mod ord">
          <ac:chgData name="Felipe Freitas" userId="754b0854625114a1" providerId="LiveId" clId="{D3337E6F-9E70-4B65-B42F-8091C9D37240}" dt="2023-10-23T01:43:03.331" v="521" actId="20577"/>
          <ac:spMkLst>
            <pc:docMk/>
            <pc:sldMk cId="2426543671" sldId="323"/>
            <ac:spMk id="2" creationId="{787BD46A-090E-645E-A58E-942DE8293721}"/>
          </ac:spMkLst>
        </pc:spChg>
        <pc:spChg chg="del">
          <ac:chgData name="Felipe Freitas" userId="754b0854625114a1" providerId="LiveId" clId="{D3337E6F-9E70-4B65-B42F-8091C9D37240}" dt="2023-10-23T01:02:33.715" v="192"/>
          <ac:spMkLst>
            <pc:docMk/>
            <pc:sldMk cId="2426543671" sldId="323"/>
            <ac:spMk id="4" creationId="{F75418F6-FEE1-6E31-5B4D-D6DEF3CBDAB3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2426543671" sldId="323"/>
            <ac:spMk id="8" creationId="{D170804F-276E-3893-C316-A1DDD03EBD74}"/>
          </ac:spMkLst>
        </pc:spChg>
        <pc:spChg chg="add mod">
          <ac:chgData name="Felipe Freitas" userId="754b0854625114a1" providerId="LiveId" clId="{D3337E6F-9E70-4B65-B42F-8091C9D37240}" dt="2023-10-23T01:46:42.400" v="588"/>
          <ac:spMkLst>
            <pc:docMk/>
            <pc:sldMk cId="2426543671" sldId="323"/>
            <ac:spMk id="9" creationId="{3A2FF595-E626-CC5A-41FF-D3C9D96D7C3F}"/>
          </ac:spMkLst>
        </pc:spChg>
        <pc:spChg chg="add mod">
          <ac:chgData name="Felipe Freitas" userId="754b0854625114a1" providerId="LiveId" clId="{D3337E6F-9E70-4B65-B42F-8091C9D37240}" dt="2023-10-23T01:46:42.400" v="588"/>
          <ac:spMkLst>
            <pc:docMk/>
            <pc:sldMk cId="2426543671" sldId="323"/>
            <ac:spMk id="10" creationId="{CF8374A5-C6D1-66AA-436F-7CC85B2F7534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2426543671" sldId="323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2426543671" sldId="323"/>
            <ac:picMk id="5" creationId="{DDA6C196-3B0C-F840-B245-1BCE389A47DF}"/>
          </ac:picMkLst>
        </pc:picChg>
        <pc:picChg chg="add mod">
          <ac:chgData name="Felipe Freitas" userId="754b0854625114a1" providerId="LiveId" clId="{D3337E6F-9E70-4B65-B42F-8091C9D37240}" dt="2023-10-23T01:02:35.025" v="193" actId="26606"/>
          <ac:picMkLst>
            <pc:docMk/>
            <pc:sldMk cId="2426543671" sldId="323"/>
            <ac:picMk id="7" creationId="{0B4475B7-FF63-1244-C331-4F08B9BBB1E8}"/>
          </ac:picMkLst>
        </pc:picChg>
      </pc:sldChg>
      <pc:sldChg chg="addSp delSp modSp add mod setBg modClrScheme delDesignElem chgLayout">
        <pc:chgData name="Felipe Freitas" userId="754b0854625114a1" providerId="LiveId" clId="{D3337E6F-9E70-4B65-B42F-8091C9D37240}" dt="2023-10-23T01:46:43.792" v="589"/>
        <pc:sldMkLst>
          <pc:docMk/>
          <pc:sldMk cId="3643502309" sldId="324"/>
        </pc:sldMkLst>
        <pc:spChg chg="mod ord">
          <ac:chgData name="Felipe Freitas" userId="754b0854625114a1" providerId="LiveId" clId="{D3337E6F-9E70-4B65-B42F-8091C9D37240}" dt="2023-10-23T01:40:45.114" v="489" actId="27636"/>
          <ac:spMkLst>
            <pc:docMk/>
            <pc:sldMk cId="3643502309" sldId="324"/>
            <ac:spMk id="2" creationId="{935EEDD6-8504-65CF-EEF6-E2DF9027F368}"/>
          </ac:spMkLst>
        </pc:spChg>
        <pc:spChg chg="del">
          <ac:chgData name="Felipe Freitas" userId="754b0854625114a1" providerId="LiveId" clId="{D3337E6F-9E70-4B65-B42F-8091C9D37240}" dt="2023-10-23T01:02:39.472" v="194"/>
          <ac:spMkLst>
            <pc:docMk/>
            <pc:sldMk cId="3643502309" sldId="324"/>
            <ac:spMk id="4" creationId="{4795549C-DDD1-82C6-26F6-FA4A78D21CB3}"/>
          </ac:spMkLst>
        </pc:spChg>
        <pc:spChg chg="add del mod ord">
          <ac:chgData name="Felipe Freitas" userId="754b0854625114a1" providerId="LiveId" clId="{D3337E6F-9E70-4B65-B42F-8091C9D37240}" dt="2023-10-23T01:31:39.075" v="395" actId="700"/>
          <ac:spMkLst>
            <pc:docMk/>
            <pc:sldMk cId="3643502309" sldId="324"/>
            <ac:spMk id="8" creationId="{81A2D4E1-9D4F-5041-B743-58D055FBDF28}"/>
          </ac:spMkLst>
        </pc:spChg>
        <pc:spChg chg="add mod">
          <ac:chgData name="Felipe Freitas" userId="754b0854625114a1" providerId="LiveId" clId="{D3337E6F-9E70-4B65-B42F-8091C9D37240}" dt="2023-10-23T01:46:43.792" v="589"/>
          <ac:spMkLst>
            <pc:docMk/>
            <pc:sldMk cId="3643502309" sldId="324"/>
            <ac:spMk id="9" creationId="{908D2493-D516-F792-594E-4D6C27FC82F0}"/>
          </ac:spMkLst>
        </pc:spChg>
        <pc:spChg chg="add mod">
          <ac:chgData name="Felipe Freitas" userId="754b0854625114a1" providerId="LiveId" clId="{D3337E6F-9E70-4B65-B42F-8091C9D37240}" dt="2023-10-23T01:46:43.792" v="589"/>
          <ac:spMkLst>
            <pc:docMk/>
            <pc:sldMk cId="3643502309" sldId="324"/>
            <ac:spMk id="10" creationId="{847ABCEA-1279-9C5D-FAAE-2A0A3C50599C}"/>
          </ac:spMkLst>
        </pc:spChg>
        <pc:spChg chg="add del">
          <ac:chgData name="Felipe Freitas" userId="754b0854625114a1" providerId="LiveId" clId="{D3337E6F-9E70-4B65-B42F-8091C9D37240}" dt="2023-10-23T01:31:39.075" v="395" actId="700"/>
          <ac:spMkLst>
            <pc:docMk/>
            <pc:sldMk cId="3643502309" sldId="324"/>
            <ac:spMk id="12" creationId="{3B47FC9C-2ED3-4100-A4EF-E8CDFEE106C9}"/>
          </ac:spMkLst>
        </pc:spChg>
        <pc:picChg chg="add mod ord">
          <ac:chgData name="Felipe Freitas" userId="754b0854625114a1" providerId="LiveId" clId="{D3337E6F-9E70-4B65-B42F-8091C9D37240}" dt="2023-10-23T01:31:39.075" v="395" actId="700"/>
          <ac:picMkLst>
            <pc:docMk/>
            <pc:sldMk cId="3643502309" sldId="324"/>
            <ac:picMk id="5" creationId="{96FD235F-A8E3-FF5A-EA51-450B8399FF27}"/>
          </ac:picMkLst>
        </pc:picChg>
        <pc:picChg chg="add mod">
          <ac:chgData name="Felipe Freitas" userId="754b0854625114a1" providerId="LiveId" clId="{D3337E6F-9E70-4B65-B42F-8091C9D37240}" dt="2023-10-23T01:02:41.344" v="195" actId="26606"/>
          <ac:picMkLst>
            <pc:docMk/>
            <pc:sldMk cId="3643502309" sldId="324"/>
            <ac:picMk id="7" creationId="{0CC544C3-7531-0CD4-A2CC-013AFAFD974F}"/>
          </ac:picMkLst>
        </pc:picChg>
      </pc:sldChg>
      <pc:sldMasterChg chg="modSp modSldLayout">
        <pc:chgData name="Felipe Freitas" userId="754b0854625114a1" providerId="LiveId" clId="{D3337E6F-9E70-4B65-B42F-8091C9D37240}" dt="2023-10-23T01:30:47.145" v="392" actId="2711"/>
        <pc:sldMasterMkLst>
          <pc:docMk/>
          <pc:sldMasterMk cId="1521101646" sldId="2147483648"/>
        </pc:sldMasterMkLst>
        <pc:spChg chg="mod">
          <ac:chgData name="Felipe Freitas" userId="754b0854625114a1" providerId="LiveId" clId="{D3337E6F-9E70-4B65-B42F-8091C9D37240}" dt="2023-10-23T01:30:19.635" v="381" actId="2711"/>
          <ac:spMkLst>
            <pc:docMk/>
            <pc:sldMasterMk cId="1521101646" sldId="2147483648"/>
            <ac:spMk id="2" creationId="{85448D72-9C3A-662B-4BFC-EC19B3A69C5E}"/>
          </ac:spMkLst>
        </pc:spChg>
        <pc:sldLayoutChg chg="modSp">
          <pc:chgData name="Felipe Freitas" userId="754b0854625114a1" providerId="LiveId" clId="{D3337E6F-9E70-4B65-B42F-8091C9D37240}" dt="2023-10-23T01:30:47.145" v="392" actId="2711"/>
          <pc:sldLayoutMkLst>
            <pc:docMk/>
            <pc:sldMasterMk cId="1521101646" sldId="2147483648"/>
            <pc:sldLayoutMk cId="1434513189" sldId="2147483649"/>
          </pc:sldLayoutMkLst>
          <pc:spChg chg="mod">
            <ac:chgData name="Felipe Freitas" userId="754b0854625114a1" providerId="LiveId" clId="{D3337E6F-9E70-4B65-B42F-8091C9D37240}" dt="2023-10-23T01:30:32.843" v="389" actId="404"/>
            <ac:spMkLst>
              <pc:docMk/>
              <pc:sldMasterMk cId="1521101646" sldId="2147483648"/>
              <pc:sldLayoutMk cId="1434513189" sldId="2147483649"/>
              <ac:spMk id="2" creationId="{44F99753-8349-5DE2-93C7-78E49FFFED6D}"/>
            </ac:spMkLst>
          </pc:spChg>
          <pc:spChg chg="mod">
            <ac:chgData name="Felipe Freitas" userId="754b0854625114a1" providerId="LiveId" clId="{D3337E6F-9E70-4B65-B42F-8091C9D37240}" dt="2023-10-23T01:30:47.145" v="392" actId="2711"/>
            <ac:spMkLst>
              <pc:docMk/>
              <pc:sldMasterMk cId="1521101646" sldId="2147483648"/>
              <pc:sldLayoutMk cId="1434513189" sldId="2147483649"/>
              <ac:spMk id="3" creationId="{59F3058A-0C86-0BD4-E683-5969DDD79560}"/>
            </ac:spMkLst>
          </pc:spChg>
        </pc:sldLayoutChg>
        <pc:sldLayoutChg chg="modSp">
          <pc:chgData name="Felipe Freitas" userId="754b0854625114a1" providerId="LiveId" clId="{D3337E6F-9E70-4B65-B42F-8091C9D37240}" dt="2023-10-23T01:30:41.427" v="391" actId="2711"/>
          <pc:sldLayoutMkLst>
            <pc:docMk/>
            <pc:sldMasterMk cId="1521101646" sldId="2147483648"/>
            <pc:sldLayoutMk cId="1497817306" sldId="2147483650"/>
          </pc:sldLayoutMkLst>
          <pc:spChg chg="mod">
            <ac:chgData name="Felipe Freitas" userId="754b0854625114a1" providerId="LiveId" clId="{D3337E6F-9E70-4B65-B42F-8091C9D37240}" dt="2023-10-23T01:30:41.427" v="391" actId="2711"/>
            <ac:spMkLst>
              <pc:docMk/>
              <pc:sldMasterMk cId="1521101646" sldId="2147483648"/>
              <pc:sldLayoutMk cId="1497817306" sldId="2147483650"/>
              <ac:spMk id="3" creationId="{C740A171-5737-EAE2-6147-BBF33971B9FC}"/>
            </ac:spMkLst>
          </pc:spChg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F99753-8349-5DE2-93C7-78E49FFFE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>
            <a:normAutofit/>
          </a:bodyPr>
          <a:lstStyle>
            <a:lvl1pPr algn="ctr"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9F3058A-0C86-0BD4-E683-5969DDD7956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F3922F-9DC8-AA11-901E-1936D7A98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7FF4C8-905C-63C3-9FFB-E06DFEB80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AA53CE-16B3-A978-ADFB-012A61277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513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C54154-52EB-C9F1-2A9A-17A8D54592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AB574C-0233-9278-AA65-E7CF668444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0502F5-CA3B-4C95-55FA-07696280F1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133D99-1061-7E54-426B-5353B9CE0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292E7C-1C81-A3DF-CAEA-99AB9D80FE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460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50995B-3D8F-5EAC-C081-A5BF347D923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5395F7-8DC2-4690-32A6-ADA185D3C7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F67A9-D19A-002A-A04D-67A0BDF5C8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AF2AAB-DB78-D7B5-1C5D-D79183CD76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7D4513-9325-ED71-5416-59FBFAD00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718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039BC6-8FAC-6482-4A51-568B01BCCB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40A171-5737-EAE2-6147-BBF33971B9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>
            <a:lvl1pPr>
              <a:defRPr sz="2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  <a:lvl2pPr>
              <a:defRPr sz="2000">
                <a:latin typeface="Times New Roman" panose="02020603050405020304" pitchFamily="18" charset="0"/>
                <a:cs typeface="Times New Roman" panose="02020603050405020304" pitchFamily="18" charset="0"/>
              </a:defRPr>
            </a:lvl2pPr>
            <a:lvl3pPr>
              <a:defRPr sz="1800">
                <a:latin typeface="Times New Roman" panose="02020603050405020304" pitchFamily="18" charset="0"/>
                <a:cs typeface="Times New Roman" panose="02020603050405020304" pitchFamily="18" charset="0"/>
              </a:defRPr>
            </a:lvl3pPr>
            <a:lvl4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4pPr>
            <a:lvl5pPr>
              <a:defRPr sz="1600">
                <a:latin typeface="Times New Roman" panose="02020603050405020304" pitchFamily="18" charset="0"/>
                <a:cs typeface="Times New Roman" panose="02020603050405020304" pitchFamily="18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5F2660-3A02-699F-2F7C-F9DF2F2F2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5E522-6F0E-A428-1D04-D3E3720D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72A93-CD73-26EB-873E-C98DBB245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817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45932-0EF9-439D-5DB6-77F29978EF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8E0323-938B-8827-7BF4-A05A4682F5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DC9D4A-2129-5AFF-1F5D-C20C0188F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408C6C-6A80-AF93-E899-74C92E54B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B7AF1-3ED6-2C9A-CC65-C05C99484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520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5D66A1-2EA3-1D61-F1E2-26273E57FA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4C1D7E-8F00-1C86-CB0D-FF2E8D638DA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E4A3392-CC45-B671-A914-43E61B9CFA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B4DCD7-3F18-C4C5-3B77-7C51F5649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51D300-1DC2-F9DD-948A-58D790B2B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F55677-5444-2BB9-F0EC-E6D3F24CA0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8712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0BF664-CBB6-AE1A-1B26-920479832D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EA06066-2572-900E-9E9C-D529BC0B34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FF493E-A988-2C11-EFC0-4C1F86C143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683F993-360C-376E-E70E-79797F9E39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864FAE-D8AA-373A-02C1-314984C23A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E05EC3-36DF-29C4-A32F-472B85A07D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D66665D-E4FC-A2FE-F09A-593389CDB5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8392F88-4433-C9B8-2009-DE7F5F48A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369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F77C4-E54F-3884-F28A-1EB7B2E015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6DA265A-D4CF-127B-8E1F-F174F13A9F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D4016B-8032-73E9-FC12-6AABD75B3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481DCFD-ABC0-D1C0-04EA-9A4030073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298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BC26E34-2D51-B332-F690-27AAEFF47D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354D7A-0048-88F1-77ED-031AADB2BD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15E9694-9F27-25EF-3659-22493B5AC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952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E9A52A-60E1-35DA-F2F0-4DAF772CAF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4407B9-C688-F9C6-F040-6C60AE1AB4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E6898A-F14F-573A-534E-6B061D34DB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76F303-F548-E452-1CAC-9DB0CFEE8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013583-C48C-7DB0-157C-F27B9E543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6320DE-0518-FFAE-2E25-854152CF8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796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58E3B6-C094-38A3-3509-619467682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E03AD2-49E2-D380-5359-E399535907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178EF4-690D-8CA8-4B41-6764C725F3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EEC340-4BAB-2277-C00A-B84BDF0AA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745E4F-EB3A-AB72-AA68-6587785A59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6C9161-B7ED-A541-EE09-DD9CE9214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053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5448D72-9C3A-662B-4BFC-EC19B3A69C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EEF71F-B96D-3596-F40B-85970BA242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6400DD-3416-8A36-35FC-94CC6F2CD66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024A3-FFF7-47CA-BCEA-4F6329BB27F9}" type="datetimeFigureOut">
              <a:rPr lang="en-US" smtClean="0"/>
              <a:t>10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E531FA-1AE6-1017-D4B4-7387FB8819E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CE86FA-93EC-AA4A-86A0-F32354A9C1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6EEEE1-DC4B-4D4D-A33F-8B9CEA72AF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101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2800" kern="1200">
          <a:solidFill>
            <a:schemeClr val="tx1"/>
          </a:solidFill>
          <a:latin typeface="Times New Roman" panose="02020603050405020304" pitchFamily="18" charset="0"/>
          <a:ea typeface="+mj-ea"/>
          <a:cs typeface="Times New Roman" panose="02020603050405020304" pitchFamily="18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png"/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lines&#10;&#10;Description automatically generated with medium confidence">
            <a:extLst>
              <a:ext uri="{FF2B5EF4-FFF2-40B4-BE49-F238E27FC236}">
                <a16:creationId xmlns:a16="http://schemas.microsoft.com/office/drawing/2014/main" id="{958CC049-441E-17B5-59CB-BD8F00EE2EE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525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3B0B0CDA-D7A6-DDE1-702D-8BADCA33FD4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65C11385-BCBC-4B11-63AB-7393A2B5B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  <a:latin typeface="Times New Roman" panose="02020603050405020304" pitchFamily="18" charset="0"/>
                <a:ea typeface="+mj-ea"/>
                <a:cs typeface="+mj-cs"/>
              </a:rPr>
              <a:t>Scenario S2;</a:t>
            </a:r>
            <a:r>
              <a:rPr lang="en-US" sz="2000" dirty="0">
                <a:latin typeface="Times New Roman" panose="02020603050405020304" pitchFamily="18" charset="0"/>
              </a:rPr>
              <a:t> </a:t>
            </a:r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EA (cm²): Ultrasound-based loin eye area measured between the 10</a:t>
            </a:r>
            <a:r>
              <a:rPr lang="en-US" sz="2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nd 11</a:t>
            </a:r>
            <a:r>
              <a:rPr lang="en-US" sz="2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ribs; </a:t>
            </a:r>
            <a:endParaRPr lang="en-US" sz="2000" kern="1200" dirty="0">
              <a:solidFill>
                <a:schemeClr val="tx1"/>
              </a:solidFill>
              <a:latin typeface="Times New Roman" panose="02020603050405020304" pitchFamily="18" charset="0"/>
              <a:ea typeface="+mj-ea"/>
              <a:cs typeface="+mj-cs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B71B73-BBF3-137E-9EB6-2A786B44DB66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24324FC-3452-0A4D-5770-73A56725084D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642560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a number of dots&#10;&#10;Description automatically generated with medium confidence">
            <a:extLst>
              <a:ext uri="{FF2B5EF4-FFF2-40B4-BE49-F238E27FC236}">
                <a16:creationId xmlns:a16="http://schemas.microsoft.com/office/drawing/2014/main" id="{0CC544C3-7531-0CD4-A2CC-013AFAFD97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96FD235F-A8E3-FF5A-EA51-450B8399FF2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35EEDD6-8504-65CF-EEF6-E2DF9027F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4; CCY (%): Cold carcass yield as a percentage of the slaughter weigh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8D2493-D516-F792-594E-4D6C27FC82F0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47ABCEA-1279-9C5D-FAAE-2A0A3C50599C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35023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a number of dots&#10;&#10;Description automatically generated">
            <a:extLst>
              <a:ext uri="{FF2B5EF4-FFF2-40B4-BE49-F238E27FC236}">
                <a16:creationId xmlns:a16="http://schemas.microsoft.com/office/drawing/2014/main" id="{9CA50217-D92B-6726-1952-9C0E00A2DE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7" y="1992313"/>
            <a:ext cx="8237989" cy="2671127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985C261A-0AB1-73DC-48FF-62EA50CC6A3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03" r="31215"/>
          <a:stretch/>
        </p:blipFill>
        <p:spPr>
          <a:xfrm>
            <a:off x="8729632" y="2289676"/>
            <a:ext cx="2565683" cy="2112391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65C11385-BCBC-4B11-63AB-7393A2B5B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6; </a:t>
            </a:r>
            <a:r>
              <a:rPr lang="en-US" sz="2000" dirty="0">
                <a:effectLst/>
                <a:ea typeface="Calibri" panose="020F0502020204030204" pitchFamily="34" charset="0"/>
              </a:rPr>
              <a:t>LEA (cm²): Ultrasound-based loin eye area measured between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and 11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s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FCC19AC-B27D-66E0-2E26-AABC6C9806AA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A285B3-6525-7B22-FF0D-95668284E513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212879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a number of dots&#10;&#10;Description automatically generated with medium confidence">
            <a:extLst>
              <a:ext uri="{FF2B5EF4-FFF2-40B4-BE49-F238E27FC236}">
                <a16:creationId xmlns:a16="http://schemas.microsoft.com/office/drawing/2014/main" id="{8C480A2B-FE97-988F-0706-C9DBB4E558F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992313"/>
            <a:ext cx="7827317" cy="2537969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5275395B-7D5A-B9C4-508C-BCF8C4610E1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826" r="32643"/>
          <a:stretch/>
        </p:blipFill>
        <p:spPr>
          <a:xfrm>
            <a:off x="8196072" y="1992313"/>
            <a:ext cx="2788920" cy="2537969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ACB5293-0FDD-271A-3B75-C1B547BCB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6 BFT; (cm): backfat thickness measured by ultrasound at the 10</a:t>
            </a:r>
            <a:r>
              <a:rPr lang="en-US" sz="20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h</a:t>
            </a:r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rib;</a:t>
            </a:r>
            <a:endParaRPr lang="en-US" sz="2000" kern="1200" dirty="0">
              <a:solidFill>
                <a:schemeClr val="tx1"/>
              </a:solidFill>
              <a:latin typeface="+mj-lt"/>
              <a:ea typeface="+mj-ea"/>
              <a:cs typeface="+mj-cs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5218E40-E50B-4856-1D43-132283D50569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F19936-01B1-44A6-EA53-CD6B6B7D6144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394357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">
            <a:extLst>
              <a:ext uri="{FF2B5EF4-FFF2-40B4-BE49-F238E27FC236}">
                <a16:creationId xmlns:a16="http://schemas.microsoft.com/office/drawing/2014/main" id="{CEDD1250-F632-FC16-109A-0A3D619B15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992313"/>
            <a:ext cx="7307359" cy="23693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9E8861E2-C280-0E98-AF20-B923DBB882B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635" r="32059"/>
          <a:stretch/>
        </p:blipFill>
        <p:spPr>
          <a:xfrm>
            <a:off x="7845551" y="1992313"/>
            <a:ext cx="2755401" cy="246081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E2B4DC-A5C0-C8D3-C66E-836E85A60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6 </a:t>
            </a:r>
            <a:r>
              <a:rPr lang="en-US" sz="2000" dirty="0">
                <a:effectLst/>
                <a:ea typeface="Calibri" panose="020F0502020204030204" pitchFamily="34" charset="0"/>
              </a:rPr>
              <a:t>; IMF (%): Intramuscular fat content in percentage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43246A-CB66-3A43-14D8-FF74E902F99C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068424-97F5-7762-3A18-7CE9CE5FEBD9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277033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a number of dots&#10;&#10;Description automatically generated">
            <a:extLst>
              <a:ext uri="{FF2B5EF4-FFF2-40B4-BE49-F238E27FC236}">
                <a16:creationId xmlns:a16="http://schemas.microsoft.com/office/drawing/2014/main" id="{0AD93B8D-C414-35B9-12CD-D3429B35E46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037" y="1992313"/>
            <a:ext cx="7363761" cy="2387663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8F3583DB-2E6C-E074-813D-365273411E0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73" r="29526"/>
          <a:stretch/>
        </p:blipFill>
        <p:spPr>
          <a:xfrm>
            <a:off x="7863840" y="1992313"/>
            <a:ext cx="2943722" cy="2479103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87BD46A-090E-645E-A58E-942DE8293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6; </a:t>
            </a:r>
            <a:r>
              <a:rPr lang="en-US" sz="2000" dirty="0">
                <a:effectLst/>
                <a:ea typeface="Calibri" panose="020F0502020204030204" pitchFamily="34" charset="0"/>
              </a:rPr>
              <a:t>SW (kg): Slaughter weight in kg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C2E8255-01E2-5ABB-31DF-1EBA322F3BD9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7AF3D13-9CA3-6786-D7B7-449973527099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6076032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0C6B05E5-80AD-1E8D-A223-89135365E5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525" y="1992313"/>
            <a:ext cx="7899577" cy="2561399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B4DC64A7-E641-82EE-7C46-28044DBD4E7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474" r="30032"/>
          <a:stretch/>
        </p:blipFill>
        <p:spPr>
          <a:xfrm>
            <a:off x="8236243" y="1992313"/>
            <a:ext cx="3420960" cy="2808633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35EEDD6-8504-65CF-EEF6-E2DF9027F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6; CCY (%): Cold carcass yield as a percentage of the slaughter weigh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2437F47-B92B-3811-7623-BD820ADA4868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B800954-2AEF-3286-71FA-352DFA2439C0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1921118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5" name="Rectangle 24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8" name="Content Placeholder 17" descr="A graph of numbers and dots&#10;&#10;Description automatically generated">
            <a:extLst>
              <a:ext uri="{FF2B5EF4-FFF2-40B4-BE49-F238E27FC236}">
                <a16:creationId xmlns:a16="http://schemas.microsoft.com/office/drawing/2014/main" id="{191A1C16-F508-5BD4-CD58-723C94A1E31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</p:spPr>
      </p:pic>
      <p:pic>
        <p:nvPicPr>
          <p:cNvPr id="20" name="Picture 19" descr="A graph of a graph&#10;&#10;Description automatically generated">
            <a:extLst>
              <a:ext uri="{FF2B5EF4-FFF2-40B4-BE49-F238E27FC236}">
                <a16:creationId xmlns:a16="http://schemas.microsoft.com/office/drawing/2014/main" id="{079EE610-06CE-13E0-FC3F-7CB5ECC9B2B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65C11385-BCBC-4B11-63AB-7393A2B5B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8; </a:t>
            </a:r>
            <a:r>
              <a:rPr lang="en-US" sz="2000" dirty="0">
                <a:effectLst/>
                <a:ea typeface="Calibri" panose="020F0502020204030204" pitchFamily="34" charset="0"/>
              </a:rPr>
              <a:t>LEA (cm²): Ultrasound-based loin eye area measured between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and 11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s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ED77D3F-7E25-182A-BE5D-E44808C5EA38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0943290-EBA1-2AFF-601A-C339DC9096D8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849512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6" name="Content Placeholder 15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664EEF2B-913E-00AF-CB55-2D85B008453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</p:spPr>
      </p:pic>
      <p:pic>
        <p:nvPicPr>
          <p:cNvPr id="19" name="Picture 18" descr="A graph of a graph&#10;&#10;Description automatically generated">
            <a:extLst>
              <a:ext uri="{FF2B5EF4-FFF2-40B4-BE49-F238E27FC236}">
                <a16:creationId xmlns:a16="http://schemas.microsoft.com/office/drawing/2014/main" id="{B39D5E25-E303-914C-616B-78D53A0357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ACB5293-0FDD-271A-3B75-C1B547BCB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8; </a:t>
            </a:r>
            <a:r>
              <a:rPr lang="en-US" sz="2000" dirty="0">
                <a:effectLst/>
                <a:ea typeface="Calibri" panose="020F0502020204030204" pitchFamily="34" charset="0"/>
              </a:rPr>
              <a:t>BFT (cm): backfat thickness measured by ultrasound at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;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FD41517-0483-D496-6696-1109F48774B8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ED01720-04EB-7F7E-1701-B66EA80EC019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1215282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6" name="Rectangle 25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8" name="Content Placeholder 17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5BD31CF8-B873-136D-E3B8-DF5307D6366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</p:spPr>
      </p:pic>
      <p:pic>
        <p:nvPicPr>
          <p:cNvPr id="21" name="Picture 20" descr="A graph of a graph&#10;&#10;Description automatically generated">
            <a:extLst>
              <a:ext uri="{FF2B5EF4-FFF2-40B4-BE49-F238E27FC236}">
                <a16:creationId xmlns:a16="http://schemas.microsoft.com/office/drawing/2014/main" id="{65821F56-FAC8-D4B3-19D7-1A1DC2CD89A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E2B4DC-A5C0-C8D3-C66E-836E85A60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8</a:t>
            </a:r>
            <a:r>
              <a:rPr lang="en-US" sz="2000" dirty="0">
                <a:effectLst/>
                <a:ea typeface="Calibri" panose="020F0502020204030204" pitchFamily="34" charset="0"/>
              </a:rPr>
              <a:t>; IMF (%): Intramuscular fat content in percentage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ACB69C3-FF08-7980-ACFE-83E50B227DBF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564DAB-B037-83FC-A687-3B8AB85E1C91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821617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9" name="Rectangle 18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1" name="Content Placeholder 10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7F76824A-29EC-0F2E-8DCD-C4B1589BBF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</p:spPr>
      </p:pic>
      <p:pic>
        <p:nvPicPr>
          <p:cNvPr id="14" name="Picture 13" descr="A graph of a graph&#10;&#10;Description automatically generated">
            <a:extLst>
              <a:ext uri="{FF2B5EF4-FFF2-40B4-BE49-F238E27FC236}">
                <a16:creationId xmlns:a16="http://schemas.microsoft.com/office/drawing/2014/main" id="{A2C237B4-34C3-45B7-229D-8EB1A37A91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87BD46A-090E-645E-A58E-942DE8293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8; </a:t>
            </a:r>
            <a:r>
              <a:rPr lang="en-US" sz="2000" dirty="0">
                <a:effectLst/>
                <a:ea typeface="Calibri" panose="020F0502020204030204" pitchFamily="34" charset="0"/>
              </a:rPr>
              <a:t>SW (kg): Slaughter weight in kg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01EBD14-1FD1-7600-4941-1EC8FCE98DD9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142270-DEC7-A053-BFFE-394B37BC98F5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616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083F5890-FD73-204C-3619-02585B64DD7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A1BC0CCA-0635-DBDB-251D-8540FC9D60A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ACB5293-0FDD-271A-3B75-C1B547BCB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2; </a:t>
            </a:r>
            <a:r>
              <a:rPr lang="en-US" sz="2000" dirty="0">
                <a:effectLst/>
                <a:ea typeface="Calibri" panose="020F0502020204030204" pitchFamily="34" charset="0"/>
              </a:rPr>
              <a:t>BFT (cm): backfat thickness measured by ultrasound at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;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099B8F9-CD77-36C6-8DB0-756FDAB307AA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CED5301-E72F-F8E8-4211-D2F7805E98A0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247393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24" name="Rectangle 23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9" name="Picture 18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A5F2F6F3-F750-CEEF-22B5-594DE657B0F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16" name="Content Placeholder 15" descr="A graph of a graph&#10;&#10;Description automatically generated">
            <a:extLst>
              <a:ext uri="{FF2B5EF4-FFF2-40B4-BE49-F238E27FC236}">
                <a16:creationId xmlns:a16="http://schemas.microsoft.com/office/drawing/2014/main" id="{99379313-BAA0-0DFA-3E95-C3FA0DD732E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35EEDD6-8504-65CF-EEF6-E2DF9027F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8; CCY (%): Cold carcass yield as a percentage of the slaughter weigh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6FEC65C-F3C2-F1C6-C245-57F40D49352C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C9BD1F7-E2CD-B443-AAF3-BAA2AD3D5B37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236040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B04DA4EE-B158-DA3F-76ED-BDB05D1BECE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CD9FE44F-9C59-6B57-C56D-114565BF816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E2B4DC-A5C0-C8D3-C66E-836E85A60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2</a:t>
            </a:r>
            <a:r>
              <a:rPr lang="en-US" sz="2000" dirty="0">
                <a:effectLst/>
                <a:ea typeface="Calibri" panose="020F0502020204030204" pitchFamily="34" charset="0"/>
              </a:rPr>
              <a:t>; IMF (%): Intramuscular fat content in percentage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8F6AAD9-72C7-7E5B-40FE-FDC52BCACC93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D2B5B7A-9D27-BA07-EF7E-80E37FCE9734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427801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7" name="Rectangle 16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" name="Picture 8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DBB31EE8-246D-632B-5C13-F9711EA90D7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line&#10;&#10;Description automatically generated">
            <a:extLst>
              <a:ext uri="{FF2B5EF4-FFF2-40B4-BE49-F238E27FC236}">
                <a16:creationId xmlns:a16="http://schemas.microsoft.com/office/drawing/2014/main" id="{5E217D7C-BADA-C449-B2C1-D46B1B21BF6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87BD46A-090E-645E-A58E-942DE8293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2; SW (kg): Slaughter weight in k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A2B262-09A1-1FBD-4934-DBEB11D49B25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70D0C7A-A6B0-234B-DEC0-95D7F9E58221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26158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different types of numbers&#10;&#10;Description automatically generated with medium confidence">
            <a:extLst>
              <a:ext uri="{FF2B5EF4-FFF2-40B4-BE49-F238E27FC236}">
                <a16:creationId xmlns:a16="http://schemas.microsoft.com/office/drawing/2014/main" id="{FDDABF21-13D4-C94D-16C1-ED85486A94F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0F7AE48C-A006-FE6D-53E5-4C45710BEBF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935EEDD6-8504-65CF-EEF6-E2DF9027F3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2; CCY (%): Cold carcass yield as a percentage of the slaughter weigh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7A6BAB-F389-168A-1C35-2CA5543D2858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57D7B69-2F42-DAC1-B3A2-F6B0074AA796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93124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7" name="Rectangle 16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9" name="Picture 8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231BE591-252F-6FBC-A1D4-0DA89A5CE0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9CEFC240-68F3-98DE-4CC5-4AC4870BF2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65C11385-BCBC-4B11-63AB-7393A2B5B8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94717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4; </a:t>
            </a:r>
            <a:r>
              <a:rPr lang="en-US" sz="2000" dirty="0">
                <a:effectLst/>
                <a:ea typeface="Calibri" panose="020F0502020204030204" pitchFamily="34" charset="0"/>
              </a:rPr>
              <a:t>LEA (cm²): Ultrasound-based loin eye area measured between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and 11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s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408F18-DE11-669E-4711-52AAE8790157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4383022-473A-5DC3-502F-8E391BB6B11B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088253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">
            <a:extLst>
              <a:ext uri="{FF2B5EF4-FFF2-40B4-BE49-F238E27FC236}">
                <a16:creationId xmlns:a16="http://schemas.microsoft.com/office/drawing/2014/main" id="{17A4B3F2-480C-40B1-10D8-649C5AA12F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9C161910-4195-AAC9-9FA3-28F74C8B818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EACB5293-0FDD-271A-3B75-C1B547BCB8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4; </a:t>
            </a:r>
            <a:r>
              <a:rPr lang="en-US" sz="2000" dirty="0">
                <a:effectLst/>
                <a:ea typeface="Calibri" panose="020F0502020204030204" pitchFamily="34" charset="0"/>
              </a:rPr>
              <a:t>BFT (cm): backfat thickness measured by ultrasound at the 10</a:t>
            </a:r>
            <a:r>
              <a:rPr lang="en-US" sz="2000" baseline="30000" dirty="0">
                <a:effectLst/>
                <a:ea typeface="Calibri" panose="020F0502020204030204" pitchFamily="34" charset="0"/>
              </a:rPr>
              <a:t>th</a:t>
            </a:r>
            <a:r>
              <a:rPr lang="en-US" sz="2000" dirty="0">
                <a:effectLst/>
                <a:ea typeface="Calibri" panose="020F0502020204030204" pitchFamily="34" charset="0"/>
              </a:rPr>
              <a:t> rib;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46D8CC3-F75C-CD0C-BF9F-D862BC0D1B53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DD905F-C6B8-4FBA-D751-AC1CC645F521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62725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dots&#10;&#10;Description automatically generated with medium confidence">
            <a:extLst>
              <a:ext uri="{FF2B5EF4-FFF2-40B4-BE49-F238E27FC236}">
                <a16:creationId xmlns:a16="http://schemas.microsoft.com/office/drawing/2014/main" id="{6AB313BE-426F-0E9E-4C2B-88D637491E2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5286D888-7E77-CDD1-E942-2F31D6A0504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DFE2B4DC-A5C0-C8D3-C66E-836E85A60E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4</a:t>
            </a:r>
            <a:r>
              <a:rPr lang="en-US" sz="2000" dirty="0">
                <a:effectLst/>
                <a:ea typeface="Calibri" panose="020F0502020204030204" pitchFamily="34" charset="0"/>
              </a:rPr>
              <a:t>; IMF (%): Intramuscular fat content in percentage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2CA245-8116-6D9C-149F-3F0A9D68ADCD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A4F5994-57AA-EA9E-85E4-AE8D4E596D19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116827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2" name="Rectangle 11">
            <a:extLst>
              <a:ext uri="{FF2B5EF4-FFF2-40B4-BE49-F238E27FC236}">
                <a16:creationId xmlns:a16="http://schemas.microsoft.com/office/drawing/2014/main" id="{3B47FC9C-2ED3-4100-A4EF-E8CDFEE106C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7" name="Picture 6" descr="A graph of numbers and lines&#10;&#10;Description automatically generated with medium confidence">
            <a:extLst>
              <a:ext uri="{FF2B5EF4-FFF2-40B4-BE49-F238E27FC236}">
                <a16:creationId xmlns:a16="http://schemas.microsoft.com/office/drawing/2014/main" id="{0B4475B7-FF63-1244-C331-4F08B9BBB1E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938" y="1535113"/>
            <a:ext cx="8159750" cy="2670175"/>
          </a:xfrm>
          <a:prstGeom prst="rect">
            <a:avLst/>
          </a:prstGeom>
        </p:spPr>
      </p:pic>
      <p:pic>
        <p:nvPicPr>
          <p:cNvPr id="5" name="Content Placeholder 4" descr="A graph of a graph&#10;&#10;Description automatically generated">
            <a:extLst>
              <a:ext uri="{FF2B5EF4-FFF2-40B4-BE49-F238E27FC236}">
                <a16:creationId xmlns:a16="http://schemas.microsoft.com/office/drawing/2014/main" id="{DDA6C196-3B0C-F840-B245-1BCE389A47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77300" y="1535113"/>
            <a:ext cx="2670175" cy="2670175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87BD46A-090E-645E-A58E-942DE82937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5358141"/>
            <a:ext cx="10515600" cy="942664"/>
          </a:xfrm>
        </p:spPr>
        <p:txBody>
          <a:bodyPr vert="horz" lIns="91440" tIns="45720" rIns="91440" bIns="45720" rtlCol="0" anchor="ctr">
            <a:normAutofit/>
          </a:bodyPr>
          <a:lstStyle/>
          <a:p>
            <a:pPr algn="ctr"/>
            <a:r>
              <a:rPr lang="en-US" sz="2000" kern="1200" dirty="0">
                <a:solidFill>
                  <a:schemeClr val="tx1"/>
                </a:solidFill>
              </a:rPr>
              <a:t>Scenario S4; </a:t>
            </a:r>
            <a:r>
              <a:rPr lang="en-US" sz="2000" dirty="0">
                <a:effectLst/>
                <a:ea typeface="Calibri" panose="020F0502020204030204" pitchFamily="34" charset="0"/>
              </a:rPr>
              <a:t>SW (kg): Slaughter weight in kg; </a:t>
            </a:r>
            <a:endParaRPr lang="en-US" sz="2000" kern="1200" dirty="0">
              <a:solidFill>
                <a:schemeClr val="tx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2FF595-E626-CC5A-41FF-D3C9D96D7C3F}"/>
              </a:ext>
            </a:extLst>
          </p:cNvPr>
          <p:cNvSpPr txBox="1"/>
          <p:nvPr/>
        </p:nvSpPr>
        <p:spPr>
          <a:xfrm>
            <a:off x="731520" y="608586"/>
            <a:ext cx="16512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hattan plo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8374A5-C6D1-66AA-436F-7CC85B2F7534}"/>
              </a:ext>
            </a:extLst>
          </p:cNvPr>
          <p:cNvSpPr txBox="1"/>
          <p:nvPr/>
        </p:nvSpPr>
        <p:spPr>
          <a:xfrm>
            <a:off x="9590532" y="55599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QQ-</a:t>
            </a:r>
            <a:r>
              <a:rPr lang="pt-BR" dirty="0" err="1"/>
              <a:t>plo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6543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0</Words>
  <Application>Microsoft Office PowerPoint</Application>
  <PresentationFormat>Widescreen</PresentationFormat>
  <Paragraphs>60</Paragraphs>
  <Slides>2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5" baseType="lpstr">
      <vt:lpstr>Arial</vt:lpstr>
      <vt:lpstr>Calibri</vt:lpstr>
      <vt:lpstr>Calibri Light</vt:lpstr>
      <vt:lpstr>Times New Roman</vt:lpstr>
      <vt:lpstr>Office Theme</vt:lpstr>
      <vt:lpstr>Scenario S2; LEA (cm²): Ultrasound-based loin eye area measured between the 10th and 11th ribs; </vt:lpstr>
      <vt:lpstr>Scenario S2; BFT (cm): backfat thickness measured by ultrasound at the 10th rib;</vt:lpstr>
      <vt:lpstr>Scenario S2; IMF (%): Intramuscular fat content in percentage</vt:lpstr>
      <vt:lpstr>Scenario S2; SW (kg): Slaughter weight in kg</vt:lpstr>
      <vt:lpstr>Scenario S2; CCY (%): Cold carcass yield as a percentage of the slaughter weight</vt:lpstr>
      <vt:lpstr>Scenario S4; LEA (cm²): Ultrasound-based loin eye area measured between the 10th and 11th ribs; </vt:lpstr>
      <vt:lpstr>Scenario S4; BFT (cm): backfat thickness measured by ultrasound at the 10th rib;</vt:lpstr>
      <vt:lpstr>Scenario S4; IMF (%): Intramuscular fat content in percentage</vt:lpstr>
      <vt:lpstr>Scenario S4; SW (kg): Slaughter weight in kg; </vt:lpstr>
      <vt:lpstr>Scenario S4; CCY (%): Cold carcass yield as a percentage of the slaughter weight</vt:lpstr>
      <vt:lpstr>Scenario S6; LEA (cm²): Ultrasound-based loin eye area measured between the 10th and 11th ribs; </vt:lpstr>
      <vt:lpstr>S6 BFT; (cm): backfat thickness measured by ultrasound at the 10th rib;</vt:lpstr>
      <vt:lpstr>Scenario S6 ; IMF (%): Intramuscular fat content in percentage</vt:lpstr>
      <vt:lpstr>Scenario S6; SW (kg): Slaughter weight in kg; </vt:lpstr>
      <vt:lpstr>Scenario S6; CCY (%): Cold carcass yield as a percentage of the slaughter weight</vt:lpstr>
      <vt:lpstr>Scenario S8; LEA (cm²): Ultrasound-based loin eye area measured between the 10th and 11th ribs; </vt:lpstr>
      <vt:lpstr>Scenario S8; BFT (cm): backfat thickness measured by ultrasound at the 10th rib;</vt:lpstr>
      <vt:lpstr>Scenario S8; IMF (%): Intramuscular fat content in percentage</vt:lpstr>
      <vt:lpstr>Scenario S8; SW (kg): Slaughter weight in kg; </vt:lpstr>
      <vt:lpstr>Scenario S8; CCY (%): Cold carcass yield as a percentage of the slaughter weigh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cenario S2; LEA (cm²): Ultrasound-based loin eye area measured between the 10th and 11th ribs; </dc:title>
  <dc:creator>Author</dc:creator>
  <cp:lastModifiedBy>Author</cp:lastModifiedBy>
  <cp:revision>1</cp:revision>
  <dcterms:created xsi:type="dcterms:W3CDTF">2023-10-23T00:53:18Z</dcterms:created>
  <dcterms:modified xsi:type="dcterms:W3CDTF">2023-10-23T01:49:30Z</dcterms:modified>
</cp:coreProperties>
</file>